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19.png" ContentType="image/png"/>
  <Override PartName="/ppt/media/image1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3.png" ContentType="image/png"/>
  <Override PartName="/ppt/media/image4.jpeg" ContentType="image/jpeg"/>
  <Override PartName="/ppt/media/image2.png" ContentType="image/png"/>
  <Override PartName="/ppt/media/image5.png" ContentType="image/png"/>
  <Override PartName="/ppt/media/image10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FBD0C40-2977-4DA6-9EA1-1C403D0831D4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5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606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Fig. S3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omparison of glycolysis and citrate cycle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.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(A) Comparison of glycolysis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; (1) hexokinase; (2) glucosephosphate isomerase; (3) phosphofructokinase; (4) aldolase; (5) triose phosphofructokinase; (6) glyceraldehyde phosphate dehydrogenase; (7) phosphoglycerate kinase; (8) phosphoglyceromutase; (9) enolase; (10) pyruvate kinase; (11) non-enzymatic reaction; (12) lactate dehydrogenase; (13) pyruvate decarboxylase; (14) alcohol dehydrogenase. (B) Comparison of the citrate cycle between </a:t>
            </a: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and WT; (pre), pyruvate dehydrogenase complex; (1) citrate synthase; (2) aconitase; (3) aconitase; (4) isocitrate dehydrogenase; (5) α-ketoglutarate dehydrogenase; (6) succinyl CoA synthase; (7)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succinate</a:t>
            </a: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dehydrogenase; (8) funarase; (9) malate dehydrogenase. Gene expression was scaled using Z-scores of FPKM for mean valued of three biological replicates in heatmap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7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57954E1-CF3D-4D39-98F1-5A63D47F1BEA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9ADDFD-724B-4E93-BB2C-65E0AF55E5A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CFA408-D0E6-4AB1-91AE-7B557D1FB9F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D3850B-C3C5-421B-ABA3-473F4FBBF6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79D595-EB69-401B-A11C-2470737659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3BC4CC-84D8-4471-BC40-504ECBB6DF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7D2E7F-D378-4ADA-8EDB-7E39ECA4288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99D42D-4639-4F4C-B5D8-83A2A4C355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B54219-00E0-41BF-96E7-6D090DEA9A6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C3286E-6D0B-4BEE-955B-F226758474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D0D566-18BA-483F-9AC3-5A3FA5EE62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0B8BEB-F7B2-482D-B4BB-ABF55DACC0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EE94CE-3710-4F16-8EDC-B317C277F2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D0BB5A0-4FB6-4A68-B8E6-205C9D9173F8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slideLayout" Target="../slideLayouts/slideLayout1.xml"/><Relationship Id="rId2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13" descr="F:\油料所工作\052414.tif"/>
          <p:cNvPicPr/>
          <p:nvPr/>
        </p:nvPicPr>
        <p:blipFill>
          <a:blip r:embed="rId1"/>
          <a:stretch/>
        </p:blipFill>
        <p:spPr>
          <a:xfrm>
            <a:off x="3160800" y="474840"/>
            <a:ext cx="809640" cy="107928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3" descr="F:\油料所工作\05242.tif"/>
          <p:cNvPicPr/>
          <p:nvPr/>
        </p:nvPicPr>
        <p:blipFill>
          <a:blip r:embed="rId2"/>
          <a:stretch/>
        </p:blipFill>
        <p:spPr>
          <a:xfrm>
            <a:off x="4821120" y="428760"/>
            <a:ext cx="809640" cy="161640"/>
          </a:xfrm>
          <a:prstGeom prst="rect">
            <a:avLst/>
          </a:prstGeom>
          <a:ln w="0">
            <a:noFill/>
          </a:ln>
        </p:spPr>
      </p:pic>
      <p:sp>
        <p:nvSpPr>
          <p:cNvPr id="50" name="TextBox 50"/>
          <p:cNvSpPr/>
          <p:nvPr/>
        </p:nvSpPr>
        <p:spPr>
          <a:xfrm>
            <a:off x="3630600" y="104760"/>
            <a:ext cx="428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组合 51"/>
          <p:cNvGrpSpPr/>
          <p:nvPr/>
        </p:nvGrpSpPr>
        <p:grpSpPr>
          <a:xfrm>
            <a:off x="2523960" y="-6480"/>
            <a:ext cx="723960" cy="678600"/>
            <a:chOff x="2523960" y="-6480"/>
            <a:chExt cx="723960" cy="678600"/>
          </a:xfrm>
        </p:grpSpPr>
        <p:sp>
          <p:nvSpPr>
            <p:cNvPr id="52" name="直接连接符 6"/>
            <p:cNvSpPr/>
            <p:nvPr/>
          </p:nvSpPr>
          <p:spPr>
            <a:xfrm>
              <a:off x="2754000" y="166680"/>
              <a:ext cx="1350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直接连接符 7"/>
            <p:cNvSpPr/>
            <p:nvPr/>
          </p:nvSpPr>
          <p:spPr>
            <a:xfrm flipV="1">
              <a:off x="2660400" y="166680"/>
              <a:ext cx="9360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直接连接符 12"/>
            <p:cNvSpPr/>
            <p:nvPr/>
          </p:nvSpPr>
          <p:spPr>
            <a:xfrm>
              <a:off x="2974320" y="190440"/>
              <a:ext cx="120600" cy="14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直接连接符 14"/>
            <p:cNvSpPr/>
            <p:nvPr/>
          </p:nvSpPr>
          <p:spPr>
            <a:xfrm>
              <a:off x="2662920" y="307800"/>
              <a:ext cx="120600" cy="1461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直接连接符 15"/>
            <p:cNvSpPr/>
            <p:nvPr/>
          </p:nvSpPr>
          <p:spPr>
            <a:xfrm>
              <a:off x="2763720" y="452520"/>
              <a:ext cx="23004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等腰三角形 17"/>
            <p:cNvSpPr/>
            <p:nvPr/>
          </p:nvSpPr>
          <p:spPr>
            <a:xfrm flipH="1" rot="19537200">
              <a:off x="2706480" y="297000"/>
              <a:ext cx="7920" cy="1713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等腰三角形 18"/>
            <p:cNvSpPr/>
            <p:nvPr/>
          </p:nvSpPr>
          <p:spPr>
            <a:xfrm flipH="1" rot="1732200">
              <a:off x="3024360" y="298800"/>
              <a:ext cx="7920" cy="1591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直接连接符 19"/>
            <p:cNvSpPr/>
            <p:nvPr/>
          </p:nvSpPr>
          <p:spPr>
            <a:xfrm flipV="1">
              <a:off x="3024000" y="230040"/>
              <a:ext cx="9360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直接连接符 20"/>
            <p:cNvSpPr/>
            <p:nvPr/>
          </p:nvSpPr>
          <p:spPr>
            <a:xfrm>
              <a:off x="3037680" y="279360"/>
              <a:ext cx="96840" cy="109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23"/>
            <p:cNvSpPr/>
            <p:nvPr/>
          </p:nvSpPr>
          <p:spPr>
            <a:xfrm>
              <a:off x="2848320" y="88560"/>
              <a:ext cx="136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直接连接符 25"/>
            <p:cNvSpPr/>
            <p:nvPr/>
          </p:nvSpPr>
          <p:spPr>
            <a:xfrm flipH="1">
              <a:off x="2759040" y="385920"/>
              <a:ext cx="144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直接连接符 27"/>
            <p:cNvSpPr/>
            <p:nvPr/>
          </p:nvSpPr>
          <p:spPr>
            <a:xfrm flipH="1">
              <a:off x="2968560" y="393840"/>
              <a:ext cx="144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直接连接符 28"/>
            <p:cNvSpPr/>
            <p:nvPr/>
          </p:nvSpPr>
          <p:spPr>
            <a:xfrm flipH="1">
              <a:off x="2650680" y="237960"/>
              <a:ext cx="144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直接连接符 29"/>
            <p:cNvSpPr/>
            <p:nvPr/>
          </p:nvSpPr>
          <p:spPr>
            <a:xfrm flipH="1">
              <a:off x="2752560" y="118800"/>
              <a:ext cx="144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TextBox 30"/>
            <p:cNvSpPr/>
            <p:nvPr/>
          </p:nvSpPr>
          <p:spPr>
            <a:xfrm>
              <a:off x="2663280" y="-6480"/>
              <a:ext cx="443520" cy="19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TextBox 31"/>
            <p:cNvSpPr/>
            <p:nvPr/>
          </p:nvSpPr>
          <p:spPr>
            <a:xfrm>
              <a:off x="3050640" y="142200"/>
              <a:ext cx="197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Box 34"/>
            <p:cNvSpPr/>
            <p:nvPr/>
          </p:nvSpPr>
          <p:spPr>
            <a:xfrm>
              <a:off x="2523960" y="118440"/>
              <a:ext cx="197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Box 35"/>
            <p:cNvSpPr/>
            <p:nvPr/>
          </p:nvSpPr>
          <p:spPr>
            <a:xfrm>
              <a:off x="2663280" y="486720"/>
              <a:ext cx="197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Box 36"/>
            <p:cNvSpPr/>
            <p:nvPr/>
          </p:nvSpPr>
          <p:spPr>
            <a:xfrm>
              <a:off x="2872080" y="273240"/>
              <a:ext cx="1972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TextBox 37"/>
            <p:cNvSpPr/>
            <p:nvPr/>
          </p:nvSpPr>
          <p:spPr>
            <a:xfrm>
              <a:off x="2526120" y="338400"/>
              <a:ext cx="565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TextBox 38"/>
            <p:cNvSpPr/>
            <p:nvPr/>
          </p:nvSpPr>
          <p:spPr>
            <a:xfrm>
              <a:off x="2651400" y="267120"/>
              <a:ext cx="565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" name="TextBox 39"/>
          <p:cNvSpPr/>
          <p:nvPr/>
        </p:nvSpPr>
        <p:spPr>
          <a:xfrm>
            <a:off x="2849400" y="500040"/>
            <a:ext cx="563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H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弧形 47"/>
          <p:cNvSpPr/>
          <p:nvPr/>
        </p:nvSpPr>
        <p:spPr>
          <a:xfrm flipV="1">
            <a:off x="3279600" y="130680"/>
            <a:ext cx="535320" cy="212760"/>
          </a:xfrm>
          <a:custGeom>
            <a:avLst/>
            <a:gdLst/>
            <a:ahLst/>
            <a:rect l="l" t="t" r="r" b="b"/>
            <a:pathLst>
              <a:path stroke="0" w="534988" h="212725">
                <a:moveTo>
                  <a:pt x="1598" y="94755"/>
                </a:moveTo>
                <a:cubicBezTo>
                  <a:pt x="16584" y="40478"/>
                  <a:pt x="132498" y="-470"/>
                  <a:pt x="269815" y="4"/>
                </a:cubicBezTo>
                <a:cubicBezTo>
                  <a:pt x="416637" y="510"/>
                  <a:pt x="534989" y="47980"/>
                  <a:pt x="534989" y="106363"/>
                </a:cubicBezTo>
                <a:lnTo>
                  <a:pt x="267494" y="106363"/>
                </a:lnTo>
                <a:lnTo>
                  <a:pt x="1598" y="94755"/>
                </a:lnTo>
                <a:close/>
              </a:path>
              <a:path fill="none" w="534988" h="212725">
                <a:moveTo>
                  <a:pt x="1598" y="94755"/>
                </a:moveTo>
                <a:cubicBezTo>
                  <a:pt x="16584" y="40478"/>
                  <a:pt x="132498" y="-470"/>
                  <a:pt x="269815" y="4"/>
                </a:cubicBezTo>
                <a:cubicBezTo>
                  <a:pt x="416637" y="510"/>
                  <a:pt x="534989" y="47980"/>
                  <a:pt x="534989" y="10636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弧形 48"/>
          <p:cNvSpPr/>
          <p:nvPr/>
        </p:nvSpPr>
        <p:spPr>
          <a:xfrm>
            <a:off x="3281400" y="349200"/>
            <a:ext cx="539640" cy="152280"/>
          </a:xfrm>
          <a:custGeom>
            <a:avLst/>
            <a:gdLst/>
            <a:ahLst/>
            <a:rect l="l" t="t" r="r" b="b"/>
            <a:pathLst>
              <a:path stroke="0" w="539750" h="152400">
                <a:moveTo>
                  <a:pt x="3169" y="64557"/>
                </a:moveTo>
                <a:cubicBezTo>
                  <a:pt x="23606" y="27234"/>
                  <a:pt x="137784" y="-231"/>
                  <a:pt x="271538" y="1"/>
                </a:cubicBezTo>
                <a:cubicBezTo>
                  <a:pt x="419934" y="259"/>
                  <a:pt x="539751" y="34299"/>
                  <a:pt x="539751" y="76200"/>
                </a:cubicBezTo>
                <a:lnTo>
                  <a:pt x="269875" y="76200"/>
                </a:lnTo>
                <a:lnTo>
                  <a:pt x="3169" y="64557"/>
                </a:lnTo>
                <a:close/>
              </a:path>
              <a:path fill="none" w="539750" h="152400">
                <a:moveTo>
                  <a:pt x="3169" y="64557"/>
                </a:moveTo>
                <a:cubicBezTo>
                  <a:pt x="23606" y="27234"/>
                  <a:pt x="137784" y="-231"/>
                  <a:pt x="271538" y="1"/>
                </a:cubicBezTo>
                <a:cubicBezTo>
                  <a:pt x="419934" y="259"/>
                  <a:pt x="539751" y="34299"/>
                  <a:pt x="539751" y="7620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49"/>
          <p:cNvSpPr/>
          <p:nvPr/>
        </p:nvSpPr>
        <p:spPr>
          <a:xfrm>
            <a:off x="3130560" y="98280"/>
            <a:ext cx="428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7" name="组合 52"/>
          <p:cNvGrpSpPr/>
          <p:nvPr/>
        </p:nvGrpSpPr>
        <p:grpSpPr>
          <a:xfrm>
            <a:off x="3832200" y="61920"/>
            <a:ext cx="720720" cy="679680"/>
            <a:chOff x="3832200" y="61920"/>
            <a:chExt cx="720720" cy="679680"/>
          </a:xfrm>
        </p:grpSpPr>
        <p:sp>
          <p:nvSpPr>
            <p:cNvPr id="78" name="直接连接符 53"/>
            <p:cNvSpPr/>
            <p:nvPr/>
          </p:nvSpPr>
          <p:spPr>
            <a:xfrm>
              <a:off x="4059000" y="236520"/>
              <a:ext cx="1350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直接连接符 54"/>
            <p:cNvSpPr/>
            <p:nvPr/>
          </p:nvSpPr>
          <p:spPr>
            <a:xfrm flipV="1">
              <a:off x="3966480" y="234360"/>
              <a:ext cx="9180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直接连接符 55"/>
            <p:cNvSpPr/>
            <p:nvPr/>
          </p:nvSpPr>
          <p:spPr>
            <a:xfrm>
              <a:off x="4279320" y="260280"/>
              <a:ext cx="120600" cy="14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直接连接符 56"/>
            <p:cNvSpPr/>
            <p:nvPr/>
          </p:nvSpPr>
          <p:spPr>
            <a:xfrm>
              <a:off x="3970080" y="376200"/>
              <a:ext cx="118800" cy="14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直接连接符 57"/>
            <p:cNvSpPr/>
            <p:nvPr/>
          </p:nvSpPr>
          <p:spPr>
            <a:xfrm>
              <a:off x="4068720" y="522360"/>
              <a:ext cx="23004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等腰三角形 58"/>
            <p:cNvSpPr/>
            <p:nvPr/>
          </p:nvSpPr>
          <p:spPr>
            <a:xfrm flipH="1" rot="19537200">
              <a:off x="4011480" y="365400"/>
              <a:ext cx="7920" cy="1713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等腰三角形 59"/>
            <p:cNvSpPr/>
            <p:nvPr/>
          </p:nvSpPr>
          <p:spPr>
            <a:xfrm flipH="1" rot="1732200">
              <a:off x="4329360" y="368640"/>
              <a:ext cx="7920" cy="1591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直接连接符 60"/>
            <p:cNvSpPr/>
            <p:nvPr/>
          </p:nvSpPr>
          <p:spPr>
            <a:xfrm flipV="1">
              <a:off x="4330080" y="298440"/>
              <a:ext cx="9180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直接连接符 61"/>
            <p:cNvSpPr/>
            <p:nvPr/>
          </p:nvSpPr>
          <p:spPr>
            <a:xfrm>
              <a:off x="4345200" y="334800"/>
              <a:ext cx="95040" cy="108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62"/>
            <p:cNvSpPr/>
            <p:nvPr/>
          </p:nvSpPr>
          <p:spPr>
            <a:xfrm>
              <a:off x="4154040" y="157320"/>
              <a:ext cx="136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直接连接符 63"/>
            <p:cNvSpPr/>
            <p:nvPr/>
          </p:nvSpPr>
          <p:spPr>
            <a:xfrm flipH="1">
              <a:off x="4064040" y="455760"/>
              <a:ext cx="144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直接连接符 64"/>
            <p:cNvSpPr/>
            <p:nvPr/>
          </p:nvSpPr>
          <p:spPr>
            <a:xfrm>
              <a:off x="4275000" y="461880"/>
              <a:ext cx="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直接连接符 65"/>
            <p:cNvSpPr/>
            <p:nvPr/>
          </p:nvSpPr>
          <p:spPr>
            <a:xfrm flipH="1">
              <a:off x="3957480" y="306360"/>
              <a:ext cx="144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直接连接符 66"/>
            <p:cNvSpPr/>
            <p:nvPr/>
          </p:nvSpPr>
          <p:spPr>
            <a:xfrm>
              <a:off x="4059000" y="187200"/>
              <a:ext cx="0" cy="135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67"/>
            <p:cNvSpPr/>
            <p:nvPr/>
          </p:nvSpPr>
          <p:spPr>
            <a:xfrm>
              <a:off x="3969000" y="61920"/>
              <a:ext cx="494640" cy="19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 </a:t>
              </a:r>
              <a:r>
                <a:rPr b="1" lang="en-US" sz="6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68"/>
            <p:cNvSpPr/>
            <p:nvPr/>
          </p:nvSpPr>
          <p:spPr>
            <a:xfrm>
              <a:off x="4356000" y="210960"/>
              <a:ext cx="196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Box 69"/>
            <p:cNvSpPr/>
            <p:nvPr/>
          </p:nvSpPr>
          <p:spPr>
            <a:xfrm>
              <a:off x="3867840" y="187200"/>
              <a:ext cx="196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70"/>
            <p:cNvSpPr/>
            <p:nvPr/>
          </p:nvSpPr>
          <p:spPr>
            <a:xfrm>
              <a:off x="3969000" y="556200"/>
              <a:ext cx="196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71"/>
            <p:cNvSpPr/>
            <p:nvPr/>
          </p:nvSpPr>
          <p:spPr>
            <a:xfrm>
              <a:off x="4177800" y="342360"/>
              <a:ext cx="196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72"/>
            <p:cNvSpPr/>
            <p:nvPr/>
          </p:nvSpPr>
          <p:spPr>
            <a:xfrm>
              <a:off x="3832200" y="407880"/>
              <a:ext cx="565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73"/>
            <p:cNvSpPr/>
            <p:nvPr/>
          </p:nvSpPr>
          <p:spPr>
            <a:xfrm>
              <a:off x="3957120" y="336240"/>
              <a:ext cx="565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9" name="弧形 76"/>
          <p:cNvSpPr/>
          <p:nvPr/>
        </p:nvSpPr>
        <p:spPr>
          <a:xfrm>
            <a:off x="4070520" y="534960"/>
            <a:ext cx="819000" cy="428760"/>
          </a:xfrm>
          <a:custGeom>
            <a:avLst/>
            <a:gdLst/>
            <a:ahLst/>
            <a:rect l="l" t="t" r="r" b="b"/>
            <a:pathLst>
              <a:path stroke="0" w="819150" h="428625">
                <a:moveTo>
                  <a:pt x="409575" y="0"/>
                </a:moveTo>
                <a:cubicBezTo>
                  <a:pt x="635777" y="0"/>
                  <a:pt x="819150" y="95951"/>
                  <a:pt x="819150" y="214313"/>
                </a:cubicBezTo>
                <a:lnTo>
                  <a:pt x="409575" y="214313"/>
                </a:lnTo>
                <a:lnTo>
                  <a:pt x="409575" y="0"/>
                </a:lnTo>
                <a:close/>
              </a:path>
              <a:path fill="none" w="819150" h="428625">
                <a:moveTo>
                  <a:pt x="409575" y="0"/>
                </a:moveTo>
                <a:cubicBezTo>
                  <a:pt x="635777" y="0"/>
                  <a:pt x="819150" y="95951"/>
                  <a:pt x="819150" y="21431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110"/>
          <p:cNvSpPr/>
          <p:nvPr/>
        </p:nvSpPr>
        <p:spPr>
          <a:xfrm>
            <a:off x="4149720" y="571680"/>
            <a:ext cx="3729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H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1" name="组合 232"/>
          <p:cNvGrpSpPr/>
          <p:nvPr/>
        </p:nvGrpSpPr>
        <p:grpSpPr>
          <a:xfrm>
            <a:off x="4546440" y="752400"/>
            <a:ext cx="971640" cy="599400"/>
            <a:chOff x="4546440" y="752400"/>
            <a:chExt cx="971640" cy="599400"/>
          </a:xfrm>
        </p:grpSpPr>
        <p:grpSp>
          <p:nvGrpSpPr>
            <p:cNvPr id="102" name="组合 120"/>
            <p:cNvGrpSpPr/>
            <p:nvPr/>
          </p:nvGrpSpPr>
          <p:grpSpPr>
            <a:xfrm>
              <a:off x="4546440" y="752400"/>
              <a:ext cx="971640" cy="599400"/>
              <a:chOff x="4546440" y="752400"/>
              <a:chExt cx="971640" cy="599400"/>
            </a:xfrm>
          </p:grpSpPr>
          <p:sp>
            <p:nvSpPr>
              <p:cNvPr id="103" name="TextBox 96"/>
              <p:cNvSpPr/>
              <p:nvPr/>
            </p:nvSpPr>
            <p:spPr>
              <a:xfrm>
                <a:off x="5000760" y="948240"/>
                <a:ext cx="26784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4" name="TextBox 93"/>
              <p:cNvSpPr/>
              <p:nvPr/>
            </p:nvSpPr>
            <p:spPr>
              <a:xfrm>
                <a:off x="5207040" y="809640"/>
                <a:ext cx="31104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直接连接符 79"/>
              <p:cNvSpPr/>
              <p:nvPr/>
            </p:nvSpPr>
            <p:spPr>
              <a:xfrm flipV="1">
                <a:off x="4811400" y="833040"/>
                <a:ext cx="153720" cy="1458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" name="TextBox 92"/>
              <p:cNvSpPr/>
              <p:nvPr/>
            </p:nvSpPr>
            <p:spPr>
              <a:xfrm>
                <a:off x="4546440" y="798840"/>
                <a:ext cx="428760" cy="19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</a:t>
                </a:r>
                <a:r>
                  <a:rPr b="1" lang="en-US" sz="600" spc="-1" strike="noStrike">
                    <a:solidFill>
                      <a:srgbClr val="c00000"/>
                    </a:solidFill>
                    <a:latin typeface="Times New Roman"/>
                    <a:ea typeface="Times New Roman"/>
                  </a:rPr>
                  <a:t>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" name="直接连接符 80"/>
              <p:cNvSpPr/>
              <p:nvPr/>
            </p:nvSpPr>
            <p:spPr>
              <a:xfrm>
                <a:off x="5054400" y="836280"/>
                <a:ext cx="198360" cy="180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直接连接符 81"/>
              <p:cNvSpPr/>
              <p:nvPr/>
            </p:nvSpPr>
            <p:spPr>
              <a:xfrm>
                <a:off x="4821120" y="982440"/>
                <a:ext cx="118800" cy="147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" name="直接连接符 82"/>
              <p:cNvSpPr/>
              <p:nvPr/>
            </p:nvSpPr>
            <p:spPr>
              <a:xfrm>
                <a:off x="4921200" y="1127160"/>
                <a:ext cx="228600" cy="144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" name="等腰三角形 83"/>
              <p:cNvSpPr/>
              <p:nvPr/>
            </p:nvSpPr>
            <p:spPr>
              <a:xfrm flipH="1" rot="19537200">
                <a:off x="4862520" y="971640"/>
                <a:ext cx="7920" cy="17136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等腰三角形 84"/>
              <p:cNvSpPr/>
              <p:nvPr/>
            </p:nvSpPr>
            <p:spPr>
              <a:xfrm flipH="1" rot="1732200">
                <a:off x="5178600" y="978120"/>
                <a:ext cx="7920" cy="159120"/>
              </a:xfrm>
              <a:prstGeom prst="triangle">
                <a:avLst>
                  <a:gd name="adj" fmla="val 50000"/>
                </a:avLst>
              </a:prstGeom>
              <a:solidFill>
                <a:srgbClr val="000000"/>
              </a:solidFill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6480" bIns="648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" name="直接连接符 85"/>
              <p:cNvSpPr/>
              <p:nvPr/>
            </p:nvSpPr>
            <p:spPr>
              <a:xfrm flipV="1">
                <a:off x="5182560" y="909360"/>
                <a:ext cx="91800" cy="131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" name="直接连接符 86"/>
              <p:cNvSpPr/>
              <p:nvPr/>
            </p:nvSpPr>
            <p:spPr>
              <a:xfrm>
                <a:off x="5184720" y="954000"/>
                <a:ext cx="107640" cy="99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TextBox 87"/>
              <p:cNvSpPr/>
              <p:nvPr/>
            </p:nvSpPr>
            <p:spPr>
              <a:xfrm>
                <a:off x="4915800" y="752400"/>
                <a:ext cx="136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" name="直接连接符 88"/>
              <p:cNvSpPr/>
              <p:nvPr/>
            </p:nvSpPr>
            <p:spPr>
              <a:xfrm flipH="1">
                <a:off x="4914720" y="1062000"/>
                <a:ext cx="1440" cy="1332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" name="直接连接符 89"/>
              <p:cNvSpPr/>
              <p:nvPr/>
            </p:nvSpPr>
            <p:spPr>
              <a:xfrm>
                <a:off x="5126040" y="1068480"/>
                <a:ext cx="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直接连接符 90"/>
              <p:cNvSpPr/>
              <p:nvPr/>
            </p:nvSpPr>
            <p:spPr>
              <a:xfrm flipH="1">
                <a:off x="4808160" y="912600"/>
                <a:ext cx="1440" cy="135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" name="TextBox 95"/>
              <p:cNvSpPr/>
              <p:nvPr/>
            </p:nvSpPr>
            <p:spPr>
              <a:xfrm>
                <a:off x="4820400" y="1161360"/>
                <a:ext cx="3585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Box 97"/>
              <p:cNvSpPr/>
              <p:nvPr/>
            </p:nvSpPr>
            <p:spPr>
              <a:xfrm>
                <a:off x="4704840" y="1013760"/>
                <a:ext cx="2916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" name="TextBox 98"/>
              <p:cNvSpPr/>
              <p:nvPr/>
            </p:nvSpPr>
            <p:spPr>
              <a:xfrm>
                <a:off x="4818240" y="942480"/>
                <a:ext cx="2203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" name="TextBox 113"/>
              <p:cNvSpPr/>
              <p:nvPr/>
            </p:nvSpPr>
            <p:spPr>
              <a:xfrm>
                <a:off x="5032800" y="1166400"/>
                <a:ext cx="2203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2" name="TextBox 114"/>
            <p:cNvSpPr/>
            <p:nvPr/>
          </p:nvSpPr>
          <p:spPr>
            <a:xfrm>
              <a:off x="5230080" y="987840"/>
              <a:ext cx="2203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3" name="弧形 115"/>
          <p:cNvSpPr/>
          <p:nvPr/>
        </p:nvSpPr>
        <p:spPr>
          <a:xfrm>
            <a:off x="4775040" y="1500120"/>
            <a:ext cx="720720" cy="814320"/>
          </a:xfrm>
          <a:custGeom>
            <a:avLst/>
            <a:gdLst/>
            <a:ahLst/>
            <a:rect l="l" t="t" r="r" b="b"/>
            <a:pathLst>
              <a:path stroke="0" w="720725" h="814387">
                <a:moveTo>
                  <a:pt x="360362" y="0"/>
                </a:moveTo>
                <a:cubicBezTo>
                  <a:pt x="559385" y="0"/>
                  <a:pt x="720725" y="182307"/>
                  <a:pt x="720725" y="407194"/>
                </a:cubicBezTo>
                <a:lnTo>
                  <a:pt x="360363" y="407194"/>
                </a:lnTo>
                <a:cubicBezTo>
                  <a:pt x="360363" y="271463"/>
                  <a:pt x="360362" y="135731"/>
                  <a:pt x="360362" y="0"/>
                </a:cubicBezTo>
                <a:close/>
              </a:path>
              <a:path fill="none" w="720725" h="814387">
                <a:moveTo>
                  <a:pt x="360362" y="0"/>
                </a:moveTo>
                <a:cubicBezTo>
                  <a:pt x="559385" y="0"/>
                  <a:pt x="720725" y="182307"/>
                  <a:pt x="720725" y="407194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弧形 116"/>
          <p:cNvSpPr/>
          <p:nvPr/>
        </p:nvSpPr>
        <p:spPr>
          <a:xfrm flipV="1" rot="2759400">
            <a:off x="5356080" y="1298520"/>
            <a:ext cx="397800" cy="401760"/>
          </a:xfrm>
          <a:custGeom>
            <a:avLst/>
            <a:gdLst/>
            <a:ahLst/>
            <a:rect l="l" t="t" r="r" b="b"/>
            <a:pathLst>
              <a:path stroke="0" w="398462" h="401637">
                <a:moveTo>
                  <a:pt x="86" y="206707"/>
                </a:moveTo>
                <a:cubicBezTo>
                  <a:pt x="-2014" y="134554"/>
                  <a:pt x="34465" y="66817"/>
                  <a:pt x="95636" y="29283"/>
                </a:cubicBezTo>
                <a:cubicBezTo>
                  <a:pt x="157456" y="-8650"/>
                  <a:pt x="234823" y="-9807"/>
                  <a:pt x="297733" y="26260"/>
                </a:cubicBezTo>
                <a:cubicBezTo>
                  <a:pt x="360003" y="61960"/>
                  <a:pt x="398463" y="128610"/>
                  <a:pt x="398463" y="200818"/>
                </a:cubicBezTo>
                <a:lnTo>
                  <a:pt x="199231" y="200819"/>
                </a:lnTo>
                <a:lnTo>
                  <a:pt x="86" y="206707"/>
                </a:lnTo>
                <a:close/>
              </a:path>
              <a:path fill="none" w="398462" h="401637">
                <a:moveTo>
                  <a:pt x="86" y="206707"/>
                </a:moveTo>
                <a:cubicBezTo>
                  <a:pt x="-2014" y="134554"/>
                  <a:pt x="34465" y="66817"/>
                  <a:pt x="95636" y="29283"/>
                </a:cubicBezTo>
                <a:cubicBezTo>
                  <a:pt x="157456" y="-8650"/>
                  <a:pt x="234823" y="-9807"/>
                  <a:pt x="297733" y="26260"/>
                </a:cubicBezTo>
                <a:cubicBezTo>
                  <a:pt x="360003" y="61960"/>
                  <a:pt x="398463" y="128610"/>
                  <a:pt x="398463" y="200818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117"/>
          <p:cNvSpPr/>
          <p:nvPr/>
        </p:nvSpPr>
        <p:spPr>
          <a:xfrm>
            <a:off x="5392800" y="1192320"/>
            <a:ext cx="428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T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118"/>
          <p:cNvSpPr/>
          <p:nvPr/>
        </p:nvSpPr>
        <p:spPr>
          <a:xfrm>
            <a:off x="5689440" y="1512720"/>
            <a:ext cx="428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119"/>
          <p:cNvSpPr/>
          <p:nvPr/>
        </p:nvSpPr>
        <p:spPr>
          <a:xfrm>
            <a:off x="5361120" y="1501920"/>
            <a:ext cx="428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g2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8" name="组合 231"/>
          <p:cNvGrpSpPr/>
          <p:nvPr/>
        </p:nvGrpSpPr>
        <p:grpSpPr>
          <a:xfrm>
            <a:off x="4964040" y="1924200"/>
            <a:ext cx="1214640" cy="685800"/>
            <a:chOff x="4964040" y="1924200"/>
            <a:chExt cx="1214640" cy="685800"/>
          </a:xfrm>
        </p:grpSpPr>
        <p:sp>
          <p:nvSpPr>
            <p:cNvPr id="129" name="TextBox 122"/>
            <p:cNvSpPr/>
            <p:nvPr/>
          </p:nvSpPr>
          <p:spPr>
            <a:xfrm>
              <a:off x="5480640" y="2120040"/>
              <a:ext cx="26784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直接连接符 124"/>
            <p:cNvSpPr/>
            <p:nvPr/>
          </p:nvSpPr>
          <p:spPr>
            <a:xfrm flipV="1">
              <a:off x="5290920" y="2004480"/>
              <a:ext cx="153720" cy="1458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Box 125"/>
            <p:cNvSpPr/>
            <p:nvPr/>
          </p:nvSpPr>
          <p:spPr>
            <a:xfrm>
              <a:off x="4964040" y="1970640"/>
              <a:ext cx="509400" cy="19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 </a:t>
              </a:r>
              <a:r>
                <a:rPr b="1" lang="en-US" sz="6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直接连接符 126"/>
            <p:cNvSpPr/>
            <p:nvPr/>
          </p:nvSpPr>
          <p:spPr>
            <a:xfrm>
              <a:off x="5533920" y="2008080"/>
              <a:ext cx="168120" cy="1522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直接连接符 127"/>
            <p:cNvSpPr/>
            <p:nvPr/>
          </p:nvSpPr>
          <p:spPr>
            <a:xfrm>
              <a:off x="5300640" y="2154240"/>
              <a:ext cx="118800" cy="147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直接连接符 128"/>
            <p:cNvSpPr/>
            <p:nvPr/>
          </p:nvSpPr>
          <p:spPr>
            <a:xfrm>
              <a:off x="5400720" y="2298600"/>
              <a:ext cx="228600" cy="144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等腰三角形 129"/>
            <p:cNvSpPr/>
            <p:nvPr/>
          </p:nvSpPr>
          <p:spPr>
            <a:xfrm flipH="1" rot="19537200">
              <a:off x="5344920" y="2142000"/>
              <a:ext cx="9360" cy="17136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等腰三角形 130"/>
            <p:cNvSpPr/>
            <p:nvPr/>
          </p:nvSpPr>
          <p:spPr>
            <a:xfrm flipH="1" rot="1732200">
              <a:off x="5658120" y="2149920"/>
              <a:ext cx="7920" cy="159120"/>
            </a:xfrm>
            <a:prstGeom prst="triangle">
              <a:avLst>
                <a:gd name="adj" fmla="val 50000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6480" bIns="64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直接连接符 131"/>
            <p:cNvSpPr/>
            <p:nvPr/>
          </p:nvSpPr>
          <p:spPr>
            <a:xfrm flipV="1">
              <a:off x="5662800" y="2081160"/>
              <a:ext cx="93600" cy="133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TextBox 133"/>
            <p:cNvSpPr/>
            <p:nvPr/>
          </p:nvSpPr>
          <p:spPr>
            <a:xfrm>
              <a:off x="5395680" y="1924200"/>
              <a:ext cx="136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直接连接符 134"/>
            <p:cNvSpPr/>
            <p:nvPr/>
          </p:nvSpPr>
          <p:spPr>
            <a:xfrm>
              <a:off x="5395680" y="2233800"/>
              <a:ext cx="0" cy="13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直接连接符 135"/>
            <p:cNvSpPr/>
            <p:nvPr/>
          </p:nvSpPr>
          <p:spPr>
            <a:xfrm flipH="1">
              <a:off x="5605560" y="2239920"/>
              <a:ext cx="1440" cy="13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直接连接符 136"/>
            <p:cNvSpPr/>
            <p:nvPr/>
          </p:nvSpPr>
          <p:spPr>
            <a:xfrm flipH="1">
              <a:off x="5288040" y="2084400"/>
              <a:ext cx="1440" cy="1346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Box 137"/>
            <p:cNvSpPr/>
            <p:nvPr/>
          </p:nvSpPr>
          <p:spPr>
            <a:xfrm>
              <a:off x="5299920" y="2333160"/>
              <a:ext cx="261720" cy="2768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Box 138"/>
            <p:cNvSpPr/>
            <p:nvPr/>
          </p:nvSpPr>
          <p:spPr>
            <a:xfrm>
              <a:off x="5184720" y="2185560"/>
              <a:ext cx="291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Box 139"/>
            <p:cNvSpPr/>
            <p:nvPr/>
          </p:nvSpPr>
          <p:spPr>
            <a:xfrm>
              <a:off x="5298120" y="2114280"/>
              <a:ext cx="2203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Box 140"/>
            <p:cNvSpPr/>
            <p:nvPr/>
          </p:nvSpPr>
          <p:spPr>
            <a:xfrm>
              <a:off x="5512320" y="2338200"/>
              <a:ext cx="2203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Box 123"/>
            <p:cNvSpPr/>
            <p:nvPr/>
          </p:nvSpPr>
          <p:spPr>
            <a:xfrm>
              <a:off x="5686920" y="1981440"/>
              <a:ext cx="491760" cy="19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 </a:t>
              </a:r>
              <a:r>
                <a:rPr b="1" lang="en-US" sz="6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7" name="组合 183"/>
          <p:cNvGrpSpPr/>
          <p:nvPr/>
        </p:nvGrpSpPr>
        <p:grpSpPr>
          <a:xfrm>
            <a:off x="4970520" y="3117960"/>
            <a:ext cx="533520" cy="472680"/>
            <a:chOff x="4970520" y="3117960"/>
            <a:chExt cx="533520" cy="472680"/>
          </a:xfrm>
        </p:grpSpPr>
        <p:sp>
          <p:nvSpPr>
            <p:cNvPr id="148" name="TextBox 178"/>
            <p:cNvSpPr/>
            <p:nvPr/>
          </p:nvSpPr>
          <p:spPr>
            <a:xfrm>
              <a:off x="5091120" y="3259080"/>
              <a:ext cx="412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9" name="组合 182"/>
            <p:cNvGrpSpPr/>
            <p:nvPr/>
          </p:nvGrpSpPr>
          <p:grpSpPr>
            <a:xfrm>
              <a:off x="4970520" y="3117960"/>
              <a:ext cx="494640" cy="472680"/>
              <a:chOff x="4970520" y="3117960"/>
              <a:chExt cx="494640" cy="472680"/>
            </a:xfrm>
          </p:grpSpPr>
          <p:sp>
            <p:nvSpPr>
              <p:cNvPr id="150" name="TextBox 175"/>
              <p:cNvSpPr/>
              <p:nvPr/>
            </p:nvSpPr>
            <p:spPr>
              <a:xfrm>
                <a:off x="4977360" y="3260520"/>
                <a:ext cx="1612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TextBox 176"/>
              <p:cNvSpPr/>
              <p:nvPr/>
            </p:nvSpPr>
            <p:spPr>
              <a:xfrm>
                <a:off x="5031360" y="3235680"/>
                <a:ext cx="161280" cy="231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9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=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TextBox 172"/>
              <p:cNvSpPr/>
              <p:nvPr/>
            </p:nvSpPr>
            <p:spPr>
              <a:xfrm>
                <a:off x="4973760" y="3117960"/>
                <a:ext cx="491400" cy="19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 </a:t>
                </a:r>
                <a:r>
                  <a:rPr b="1" lang="en-US" sz="600" spc="-1" strike="noStrike">
                    <a:solidFill>
                      <a:srgbClr val="c00000"/>
                    </a:solidFill>
                    <a:latin typeface="Times New Roman"/>
                    <a:ea typeface="Times New Roman"/>
                  </a:rPr>
                  <a:t>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直接连接符 174"/>
              <p:cNvSpPr/>
              <p:nvPr/>
            </p:nvSpPr>
            <p:spPr>
              <a:xfrm flipH="1">
                <a:off x="5065560" y="32432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" name="直接连接符 180"/>
              <p:cNvSpPr/>
              <p:nvPr/>
            </p:nvSpPr>
            <p:spPr>
              <a:xfrm flipH="1">
                <a:off x="5067360" y="337500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" name="TextBox 181"/>
              <p:cNvSpPr/>
              <p:nvPr/>
            </p:nvSpPr>
            <p:spPr>
              <a:xfrm>
                <a:off x="4970520" y="3392640"/>
                <a:ext cx="494280" cy="19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6" name="组合 182"/>
          <p:cNvGrpSpPr/>
          <p:nvPr/>
        </p:nvGrpSpPr>
        <p:grpSpPr>
          <a:xfrm>
            <a:off x="5556240" y="3106800"/>
            <a:ext cx="479520" cy="564120"/>
            <a:chOff x="5556240" y="3106800"/>
            <a:chExt cx="479520" cy="564120"/>
          </a:xfrm>
        </p:grpSpPr>
        <p:sp>
          <p:nvSpPr>
            <p:cNvPr id="157" name="TextBox 192"/>
            <p:cNvSpPr/>
            <p:nvPr/>
          </p:nvSpPr>
          <p:spPr>
            <a:xfrm>
              <a:off x="5556240" y="3381480"/>
              <a:ext cx="479520" cy="289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2</a:t>
              </a: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 </a:t>
              </a:r>
              <a:r>
                <a:rPr b="1" lang="en-US" sz="600" spc="-1" strike="noStrike">
                  <a:solidFill>
                    <a:srgbClr val="c00000"/>
                  </a:solidFill>
                  <a:latin typeface="Times New Roman"/>
                  <a:ea typeface="Times New Roman"/>
                </a:rPr>
                <a:t>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187"/>
            <p:cNvSpPr/>
            <p:nvPr/>
          </p:nvSpPr>
          <p:spPr>
            <a:xfrm>
              <a:off x="5563080" y="3249720"/>
              <a:ext cx="432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TextBox 193"/>
            <p:cNvSpPr/>
            <p:nvPr/>
          </p:nvSpPr>
          <p:spPr>
            <a:xfrm>
              <a:off x="5559120" y="3106800"/>
              <a:ext cx="412920" cy="16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直接连接符 190"/>
            <p:cNvSpPr/>
            <p:nvPr/>
          </p:nvSpPr>
          <p:spPr>
            <a:xfrm flipH="1">
              <a:off x="5651280" y="3232080"/>
              <a:ext cx="144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直接连接符 191"/>
            <p:cNvSpPr/>
            <p:nvPr/>
          </p:nvSpPr>
          <p:spPr>
            <a:xfrm flipH="1">
              <a:off x="5653080" y="3363840"/>
              <a:ext cx="1440" cy="68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2" name="矩形 195"/>
          <p:cNvSpPr/>
          <p:nvPr/>
        </p:nvSpPr>
        <p:spPr>
          <a:xfrm>
            <a:off x="5566320" y="3117960"/>
            <a:ext cx="3546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O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直接连接符 197"/>
          <p:cNvSpPr/>
          <p:nvPr/>
        </p:nvSpPr>
        <p:spPr>
          <a:xfrm>
            <a:off x="5357880" y="3343320"/>
            <a:ext cx="217440" cy="0"/>
          </a:xfrm>
          <a:prstGeom prst="line">
            <a:avLst/>
          </a:prstGeom>
          <a:ln w="19080">
            <a:solidFill>
              <a:srgbClr val="000000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弧形 199"/>
          <p:cNvSpPr/>
          <p:nvPr/>
        </p:nvSpPr>
        <p:spPr>
          <a:xfrm rot="4361400">
            <a:off x="4424040" y="3279600"/>
            <a:ext cx="492120" cy="939960"/>
          </a:xfrm>
          <a:custGeom>
            <a:avLst/>
            <a:gdLst/>
            <a:ahLst/>
            <a:rect l="l" t="t" r="r" b="b"/>
            <a:pathLst>
              <a:path stroke="0" w="492125" h="939800">
                <a:moveTo>
                  <a:pt x="246062" y="0"/>
                </a:moveTo>
                <a:cubicBezTo>
                  <a:pt x="381959" y="0"/>
                  <a:pt x="492125" y="210381"/>
                  <a:pt x="492125" y="469900"/>
                </a:cubicBezTo>
                <a:lnTo>
                  <a:pt x="246063" y="469900"/>
                </a:lnTo>
                <a:cubicBezTo>
                  <a:pt x="246063" y="313267"/>
                  <a:pt x="246062" y="156633"/>
                  <a:pt x="246062" y="0"/>
                </a:cubicBezTo>
                <a:close/>
              </a:path>
              <a:path fill="none" w="492125" h="939800">
                <a:moveTo>
                  <a:pt x="246062" y="0"/>
                </a:moveTo>
                <a:cubicBezTo>
                  <a:pt x="381959" y="0"/>
                  <a:pt x="492125" y="210381"/>
                  <a:pt x="492125" y="46990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5" name="组合 233"/>
          <p:cNvGrpSpPr/>
          <p:nvPr/>
        </p:nvGrpSpPr>
        <p:grpSpPr>
          <a:xfrm>
            <a:off x="4354560" y="3894840"/>
            <a:ext cx="609480" cy="658800"/>
            <a:chOff x="4354560" y="3894840"/>
            <a:chExt cx="609480" cy="658800"/>
          </a:xfrm>
        </p:grpSpPr>
        <p:grpSp>
          <p:nvGrpSpPr>
            <p:cNvPr id="166" name="组合 209"/>
            <p:cNvGrpSpPr/>
            <p:nvPr/>
          </p:nvGrpSpPr>
          <p:grpSpPr>
            <a:xfrm>
              <a:off x="4354560" y="3989520"/>
              <a:ext cx="609480" cy="564120"/>
              <a:chOff x="4354560" y="3989520"/>
              <a:chExt cx="609480" cy="564120"/>
            </a:xfrm>
          </p:grpSpPr>
          <p:grpSp>
            <p:nvGrpSpPr>
              <p:cNvPr id="167" name="组合 182"/>
              <p:cNvGrpSpPr/>
              <p:nvPr/>
            </p:nvGrpSpPr>
            <p:grpSpPr>
              <a:xfrm>
                <a:off x="4354560" y="3989520"/>
                <a:ext cx="609480" cy="564120"/>
                <a:chOff x="4354560" y="3989520"/>
                <a:chExt cx="609480" cy="564120"/>
              </a:xfrm>
            </p:grpSpPr>
            <p:sp>
              <p:nvSpPr>
                <p:cNvPr id="168" name="TextBox 201"/>
                <p:cNvSpPr/>
                <p:nvPr/>
              </p:nvSpPr>
              <p:spPr>
                <a:xfrm>
                  <a:off x="4473360" y="4264200"/>
                  <a:ext cx="490680" cy="289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O</a:t>
                  </a:r>
                  <a:r>
                    <a:rPr b="1" lang="en-US" sz="600" spc="-1" strike="noStrike">
                      <a:solidFill>
                        <a:srgbClr val="c00000"/>
                      </a:solidFill>
                      <a:latin typeface="Times New Roman"/>
                      <a:ea typeface="Times New Roman"/>
                    </a:rPr>
                    <a:t>P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9" name="TextBox 202"/>
                <p:cNvSpPr/>
                <p:nvPr/>
              </p:nvSpPr>
              <p:spPr>
                <a:xfrm>
                  <a:off x="4354560" y="4127760"/>
                  <a:ext cx="4647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HCOH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0" name="TextBox 206"/>
                <p:cNvSpPr/>
                <p:nvPr/>
              </p:nvSpPr>
              <p:spPr>
                <a:xfrm>
                  <a:off x="4476600" y="3989520"/>
                  <a:ext cx="412560" cy="16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1" name="直接连接符 204"/>
                <p:cNvSpPr/>
                <p:nvPr/>
              </p:nvSpPr>
              <p:spPr>
                <a:xfrm flipH="1">
                  <a:off x="4568760" y="4114800"/>
                  <a:ext cx="144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72" name="直接连接符 205"/>
                <p:cNvSpPr/>
                <p:nvPr/>
              </p:nvSpPr>
              <p:spPr>
                <a:xfrm flipH="1">
                  <a:off x="4570200" y="4246560"/>
                  <a:ext cx="1440" cy="68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73" name="矩形 208"/>
              <p:cNvSpPr/>
              <p:nvPr/>
            </p:nvSpPr>
            <p:spPr>
              <a:xfrm>
                <a:off x="4460760" y="3991680"/>
                <a:ext cx="34236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</a:t>
                </a:r>
                <a:r>
                  <a:rPr b="1" lang="en-US" sz="600" spc="-1" strike="noStrike">
                    <a:solidFill>
                      <a:srgbClr val="c00000"/>
                    </a:solidFill>
                    <a:latin typeface="Times New Roman"/>
                    <a:ea typeface="Times New Roman"/>
                  </a:rPr>
                  <a:t>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4" name="TextBox 210"/>
            <p:cNvSpPr/>
            <p:nvPr/>
          </p:nvSpPr>
          <p:spPr>
            <a:xfrm rot="2700000">
              <a:off x="4419360" y="3917520"/>
              <a:ext cx="160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=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TextBox 211"/>
            <p:cNvSpPr/>
            <p:nvPr/>
          </p:nvSpPr>
          <p:spPr>
            <a:xfrm>
              <a:off x="4362480" y="3903840"/>
              <a:ext cx="412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76" name="弧形 213"/>
          <p:cNvSpPr/>
          <p:nvPr/>
        </p:nvSpPr>
        <p:spPr>
          <a:xfrm rot="6190200">
            <a:off x="3569040" y="3569040"/>
            <a:ext cx="673200" cy="973080"/>
          </a:xfrm>
          <a:custGeom>
            <a:avLst/>
            <a:gdLst/>
            <a:ahLst/>
            <a:rect l="l" t="t" r="r" b="b"/>
            <a:pathLst>
              <a:path stroke="0" w="673100" h="973138">
                <a:moveTo>
                  <a:pt x="336550" y="0"/>
                </a:moveTo>
                <a:cubicBezTo>
                  <a:pt x="522421" y="0"/>
                  <a:pt x="673100" y="217844"/>
                  <a:pt x="673100" y="486569"/>
                </a:cubicBezTo>
                <a:lnTo>
                  <a:pt x="336550" y="486569"/>
                </a:lnTo>
                <a:lnTo>
                  <a:pt x="336550" y="0"/>
                </a:lnTo>
                <a:close/>
              </a:path>
              <a:path fill="none" w="673100" h="973138">
                <a:moveTo>
                  <a:pt x="336550" y="0"/>
                </a:moveTo>
                <a:cubicBezTo>
                  <a:pt x="522421" y="0"/>
                  <a:pt x="673100" y="217844"/>
                  <a:pt x="673100" y="486569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弧形 216"/>
          <p:cNvSpPr/>
          <p:nvPr/>
        </p:nvSpPr>
        <p:spPr>
          <a:xfrm>
            <a:off x="5267160" y="2478240"/>
            <a:ext cx="511200" cy="1199880"/>
          </a:xfrm>
          <a:custGeom>
            <a:avLst/>
            <a:gdLst/>
            <a:ahLst/>
            <a:rect l="l" t="t" r="r" b="b"/>
            <a:pathLst>
              <a:path stroke="0" w="511175" h="1200150">
                <a:moveTo>
                  <a:pt x="255587" y="0"/>
                </a:moveTo>
                <a:cubicBezTo>
                  <a:pt x="396744" y="0"/>
                  <a:pt x="511175" y="268663"/>
                  <a:pt x="511175" y="600075"/>
                </a:cubicBezTo>
                <a:lnTo>
                  <a:pt x="255588" y="600075"/>
                </a:lnTo>
                <a:cubicBezTo>
                  <a:pt x="255588" y="400050"/>
                  <a:pt x="255587" y="200025"/>
                  <a:pt x="255587" y="0"/>
                </a:cubicBezTo>
                <a:close/>
              </a:path>
              <a:path fill="none" w="511175" h="1200150">
                <a:moveTo>
                  <a:pt x="255587" y="0"/>
                </a:moveTo>
                <a:cubicBezTo>
                  <a:pt x="396744" y="0"/>
                  <a:pt x="511175" y="268663"/>
                  <a:pt x="511175" y="600075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78" name="组合 217"/>
          <p:cNvGrpSpPr/>
          <p:nvPr/>
        </p:nvGrpSpPr>
        <p:grpSpPr>
          <a:xfrm>
            <a:off x="3462480" y="4191120"/>
            <a:ext cx="603000" cy="563400"/>
            <a:chOff x="3462480" y="4191120"/>
            <a:chExt cx="603000" cy="563400"/>
          </a:xfrm>
        </p:grpSpPr>
        <p:grpSp>
          <p:nvGrpSpPr>
            <p:cNvPr id="179" name="组合 182"/>
            <p:cNvGrpSpPr/>
            <p:nvPr/>
          </p:nvGrpSpPr>
          <p:grpSpPr>
            <a:xfrm>
              <a:off x="3462480" y="4191120"/>
              <a:ext cx="603000" cy="563400"/>
              <a:chOff x="3462480" y="4191120"/>
              <a:chExt cx="603000" cy="563400"/>
            </a:xfrm>
          </p:grpSpPr>
          <p:sp>
            <p:nvSpPr>
              <p:cNvPr id="180" name="TextBox 220"/>
              <p:cNvSpPr/>
              <p:nvPr/>
            </p:nvSpPr>
            <p:spPr>
              <a:xfrm>
                <a:off x="3543480" y="4465080"/>
                <a:ext cx="522000" cy="289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</a:t>
                </a:r>
                <a:r>
                  <a:rPr b="1" lang="en-US" sz="600" spc="-1" strike="noStrike">
                    <a:solidFill>
                      <a:srgbClr val="c00000"/>
                    </a:solidFill>
                    <a:latin typeface="Times New Roman"/>
                    <a:ea typeface="Times New Roman"/>
                  </a:rPr>
                  <a:t>P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1" name="TextBox 221"/>
              <p:cNvSpPr/>
              <p:nvPr/>
            </p:nvSpPr>
            <p:spPr>
              <a:xfrm>
                <a:off x="3462480" y="4248000"/>
                <a:ext cx="464400" cy="276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  HCO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2" name="TextBox 225"/>
              <p:cNvSpPr/>
              <p:nvPr/>
            </p:nvSpPr>
            <p:spPr>
              <a:xfrm>
                <a:off x="3546360" y="4191120"/>
                <a:ext cx="411120" cy="16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3" name="直接连接符 223"/>
              <p:cNvSpPr/>
              <p:nvPr/>
            </p:nvSpPr>
            <p:spPr>
              <a:xfrm flipH="1">
                <a:off x="3638520" y="431640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直接连接符 224"/>
              <p:cNvSpPr/>
              <p:nvPr/>
            </p:nvSpPr>
            <p:spPr>
              <a:xfrm flipH="1">
                <a:off x="3639960" y="447840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5" name="矩形 219"/>
            <p:cNvSpPr/>
            <p:nvPr/>
          </p:nvSpPr>
          <p:spPr>
            <a:xfrm>
              <a:off x="3548520" y="4199040"/>
              <a:ext cx="433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OH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6" name="弧形 230"/>
          <p:cNvSpPr/>
          <p:nvPr/>
        </p:nvSpPr>
        <p:spPr>
          <a:xfrm rot="4361400">
            <a:off x="4618800" y="2191320"/>
            <a:ext cx="1058760" cy="797040"/>
          </a:xfrm>
          <a:custGeom>
            <a:avLst/>
            <a:gdLst/>
            <a:ahLst/>
            <a:rect l="l" t="t" r="r" b="b"/>
            <a:pathLst>
              <a:path stroke="0" w="1058863" h="796925">
                <a:moveTo>
                  <a:pt x="529431" y="0"/>
                </a:moveTo>
                <a:cubicBezTo>
                  <a:pt x="821828" y="0"/>
                  <a:pt x="1058863" y="178398"/>
                  <a:pt x="1058863" y="398463"/>
                </a:cubicBezTo>
                <a:lnTo>
                  <a:pt x="529432" y="398463"/>
                </a:lnTo>
                <a:cubicBezTo>
                  <a:pt x="529432" y="265642"/>
                  <a:pt x="529431" y="132821"/>
                  <a:pt x="529431" y="0"/>
                </a:cubicBezTo>
                <a:close/>
              </a:path>
              <a:path fill="none" w="1058863" h="796925">
                <a:moveTo>
                  <a:pt x="529431" y="0"/>
                </a:moveTo>
                <a:cubicBezTo>
                  <a:pt x="821828" y="0"/>
                  <a:pt x="1058863" y="178398"/>
                  <a:pt x="1058863" y="39846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87" name="组合 235"/>
          <p:cNvGrpSpPr/>
          <p:nvPr/>
        </p:nvGrpSpPr>
        <p:grpSpPr>
          <a:xfrm>
            <a:off x="2451240" y="4108320"/>
            <a:ext cx="811080" cy="655200"/>
            <a:chOff x="2451240" y="4108320"/>
            <a:chExt cx="811080" cy="655200"/>
          </a:xfrm>
        </p:grpSpPr>
        <p:grpSp>
          <p:nvGrpSpPr>
            <p:cNvPr id="188" name="组合 182"/>
            <p:cNvGrpSpPr/>
            <p:nvPr/>
          </p:nvGrpSpPr>
          <p:grpSpPr>
            <a:xfrm>
              <a:off x="2451240" y="4108320"/>
              <a:ext cx="811080" cy="655200"/>
              <a:chOff x="2451240" y="4108320"/>
              <a:chExt cx="811080" cy="655200"/>
            </a:xfrm>
          </p:grpSpPr>
          <p:sp>
            <p:nvSpPr>
              <p:cNvPr id="189" name="TextBox 238"/>
              <p:cNvSpPr/>
              <p:nvPr/>
            </p:nvSpPr>
            <p:spPr>
              <a:xfrm>
                <a:off x="2584440" y="4382640"/>
                <a:ext cx="450720" cy="380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H 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TextBox 239"/>
              <p:cNvSpPr/>
              <p:nvPr/>
            </p:nvSpPr>
            <p:spPr>
              <a:xfrm>
                <a:off x="2451240" y="4236840"/>
                <a:ext cx="8110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 CHO</a:t>
                </a:r>
                <a:r>
                  <a:rPr b="1" lang="en-US" sz="600" spc="-1" strike="noStrike">
                    <a:solidFill>
                      <a:srgbClr val="c00000"/>
                    </a:solidFill>
                    <a:latin typeface="Times New Roman"/>
                    <a:ea typeface="Times New Roman"/>
                  </a:rPr>
                  <a:t>P</a:t>
                </a:r>
                <a:r>
                  <a:rPr b="1" lang="zh-CN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TextBox 243"/>
              <p:cNvSpPr/>
              <p:nvPr/>
            </p:nvSpPr>
            <p:spPr>
              <a:xfrm>
                <a:off x="2587680" y="4108320"/>
                <a:ext cx="411120" cy="160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直接连接符 241"/>
              <p:cNvSpPr/>
              <p:nvPr/>
            </p:nvSpPr>
            <p:spPr>
              <a:xfrm flipH="1">
                <a:off x="2679840" y="423360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直接连接符 242"/>
              <p:cNvSpPr/>
              <p:nvPr/>
            </p:nvSpPr>
            <p:spPr>
              <a:xfrm>
                <a:off x="2681280" y="4365720"/>
                <a:ext cx="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4" name="矩形 237"/>
            <p:cNvSpPr/>
            <p:nvPr/>
          </p:nvSpPr>
          <p:spPr>
            <a:xfrm>
              <a:off x="2589840" y="4116240"/>
              <a:ext cx="4338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OH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95" name="弧形 265"/>
          <p:cNvSpPr/>
          <p:nvPr/>
        </p:nvSpPr>
        <p:spPr>
          <a:xfrm rot="6670800">
            <a:off x="2817360" y="3765240"/>
            <a:ext cx="438120" cy="917640"/>
          </a:xfrm>
          <a:custGeom>
            <a:avLst/>
            <a:gdLst/>
            <a:ahLst/>
            <a:rect l="l" t="t" r="r" b="b"/>
            <a:pathLst>
              <a:path stroke="0" w="438150" h="917575">
                <a:moveTo>
                  <a:pt x="219075" y="0"/>
                </a:moveTo>
                <a:cubicBezTo>
                  <a:pt x="340067" y="0"/>
                  <a:pt x="438150" y="205406"/>
                  <a:pt x="438150" y="458788"/>
                </a:cubicBezTo>
                <a:lnTo>
                  <a:pt x="219075" y="458788"/>
                </a:lnTo>
                <a:lnTo>
                  <a:pt x="219075" y="0"/>
                </a:lnTo>
                <a:close/>
              </a:path>
              <a:path fill="none" w="438150" h="917575">
                <a:moveTo>
                  <a:pt x="219075" y="0"/>
                </a:moveTo>
                <a:cubicBezTo>
                  <a:pt x="340067" y="0"/>
                  <a:pt x="438150" y="205406"/>
                  <a:pt x="438150" y="458788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弧形 267"/>
          <p:cNvSpPr/>
          <p:nvPr/>
        </p:nvSpPr>
        <p:spPr>
          <a:xfrm rot="8401200">
            <a:off x="1868040" y="2985840"/>
            <a:ext cx="439920" cy="1452600"/>
          </a:xfrm>
          <a:custGeom>
            <a:avLst/>
            <a:gdLst/>
            <a:ahLst/>
            <a:rect l="l" t="t" r="r" b="b"/>
            <a:pathLst>
              <a:path stroke="0" w="439737" h="1452562">
                <a:moveTo>
                  <a:pt x="219868" y="0"/>
                </a:moveTo>
                <a:cubicBezTo>
                  <a:pt x="341298" y="0"/>
                  <a:pt x="439737" y="325167"/>
                  <a:pt x="439737" y="726281"/>
                </a:cubicBezTo>
                <a:lnTo>
                  <a:pt x="219869" y="726281"/>
                </a:lnTo>
                <a:cubicBezTo>
                  <a:pt x="219869" y="484187"/>
                  <a:pt x="219868" y="242094"/>
                  <a:pt x="219868" y="0"/>
                </a:cubicBezTo>
                <a:close/>
              </a:path>
              <a:path fill="none" w="439737" h="1452562">
                <a:moveTo>
                  <a:pt x="219868" y="0"/>
                </a:moveTo>
                <a:cubicBezTo>
                  <a:pt x="341298" y="0"/>
                  <a:pt x="439737" y="325167"/>
                  <a:pt x="439737" y="726281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7" name="组合 277"/>
          <p:cNvGrpSpPr/>
          <p:nvPr/>
        </p:nvGrpSpPr>
        <p:grpSpPr>
          <a:xfrm>
            <a:off x="1401840" y="3432240"/>
            <a:ext cx="811080" cy="576000"/>
            <a:chOff x="1401840" y="3432240"/>
            <a:chExt cx="811080" cy="576000"/>
          </a:xfrm>
        </p:grpSpPr>
        <p:grpSp>
          <p:nvGrpSpPr>
            <p:cNvPr id="198" name="组合 268"/>
            <p:cNvGrpSpPr/>
            <p:nvPr/>
          </p:nvGrpSpPr>
          <p:grpSpPr>
            <a:xfrm>
              <a:off x="1401840" y="3432240"/>
              <a:ext cx="811080" cy="576000"/>
              <a:chOff x="1401840" y="3432240"/>
              <a:chExt cx="811080" cy="576000"/>
            </a:xfrm>
          </p:grpSpPr>
          <p:grpSp>
            <p:nvGrpSpPr>
              <p:cNvPr id="199" name="组合 182"/>
              <p:cNvGrpSpPr/>
              <p:nvPr/>
            </p:nvGrpSpPr>
            <p:grpSpPr>
              <a:xfrm>
                <a:off x="1401840" y="3432240"/>
                <a:ext cx="811080" cy="576000"/>
                <a:chOff x="1401840" y="3432240"/>
                <a:chExt cx="811080" cy="576000"/>
              </a:xfrm>
            </p:grpSpPr>
            <p:sp>
              <p:nvSpPr>
                <p:cNvPr id="200" name="TextBox 271"/>
                <p:cNvSpPr/>
                <p:nvPr/>
              </p:nvSpPr>
              <p:spPr>
                <a:xfrm>
                  <a:off x="1530360" y="3706200"/>
                  <a:ext cx="411120" cy="30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1" name="TextBox 272"/>
                <p:cNvSpPr/>
                <p:nvPr/>
              </p:nvSpPr>
              <p:spPr>
                <a:xfrm>
                  <a:off x="1401840" y="3575160"/>
                  <a:ext cx="8110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 CO</a:t>
                  </a:r>
                  <a:r>
                    <a:rPr b="1" lang="en-US" sz="500" spc="-1" strike="noStrike">
                      <a:solidFill>
                        <a:srgbClr val="c00000"/>
                      </a:solidFill>
                      <a:latin typeface="Times New Roman"/>
                      <a:ea typeface="Times New Roman"/>
                    </a:rPr>
                    <a:t>P</a:t>
                  </a:r>
                  <a:r>
                    <a:rPr b="1" lang="zh-CN" sz="600" spc="-1" strike="noStrike">
                      <a:solidFill>
                        <a:srgbClr val="c00000"/>
                      </a:solidFill>
                      <a:latin typeface="Times New Roman"/>
                      <a:ea typeface="Times New Roman"/>
                    </a:rPr>
                    <a:t>  </a:t>
                  </a:r>
                  <a:r>
                    <a:rPr b="1" lang="en-US" sz="600" spc="-1" strike="noStrike">
                      <a:solidFill>
                        <a:srgbClr val="c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2" name="TextBox 273"/>
                <p:cNvSpPr/>
                <p:nvPr/>
              </p:nvSpPr>
              <p:spPr>
                <a:xfrm>
                  <a:off x="1552680" y="3432240"/>
                  <a:ext cx="411120" cy="16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03" name="直接连接符 274"/>
                <p:cNvSpPr/>
                <p:nvPr/>
              </p:nvSpPr>
              <p:spPr>
                <a:xfrm flipH="1">
                  <a:off x="1644480" y="3557520"/>
                  <a:ext cx="144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04" name="矩形 270"/>
              <p:cNvSpPr/>
              <p:nvPr/>
            </p:nvSpPr>
            <p:spPr>
              <a:xfrm>
                <a:off x="1535760" y="3435120"/>
                <a:ext cx="433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H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5" name="TextBox 276"/>
            <p:cNvSpPr/>
            <p:nvPr/>
          </p:nvSpPr>
          <p:spPr>
            <a:xfrm rot="5400000">
              <a:off x="1574280" y="3586320"/>
              <a:ext cx="1605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=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06" name="组合 286"/>
          <p:cNvGrpSpPr/>
          <p:nvPr/>
        </p:nvGrpSpPr>
        <p:grpSpPr>
          <a:xfrm>
            <a:off x="880920" y="2300400"/>
            <a:ext cx="811440" cy="578880"/>
            <a:chOff x="880920" y="2300400"/>
            <a:chExt cx="811440" cy="578880"/>
          </a:xfrm>
        </p:grpSpPr>
        <p:grpSp>
          <p:nvGrpSpPr>
            <p:cNvPr id="207" name="组合 268"/>
            <p:cNvGrpSpPr/>
            <p:nvPr/>
          </p:nvGrpSpPr>
          <p:grpSpPr>
            <a:xfrm>
              <a:off x="880920" y="2300400"/>
              <a:ext cx="811440" cy="578880"/>
              <a:chOff x="880920" y="2300400"/>
              <a:chExt cx="811440" cy="578880"/>
            </a:xfrm>
          </p:grpSpPr>
          <p:grpSp>
            <p:nvGrpSpPr>
              <p:cNvPr id="208" name="组合 182"/>
              <p:cNvGrpSpPr/>
              <p:nvPr/>
            </p:nvGrpSpPr>
            <p:grpSpPr>
              <a:xfrm>
                <a:off x="880920" y="2302560"/>
                <a:ext cx="811440" cy="576720"/>
                <a:chOff x="880920" y="2302560"/>
                <a:chExt cx="811440" cy="576720"/>
              </a:xfrm>
            </p:grpSpPr>
            <p:sp>
              <p:nvSpPr>
                <p:cNvPr id="209" name="TextBox 291"/>
                <p:cNvSpPr/>
                <p:nvPr/>
              </p:nvSpPr>
              <p:spPr>
                <a:xfrm>
                  <a:off x="1015200" y="2577240"/>
                  <a:ext cx="411120" cy="30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0" name="TextBox 292"/>
                <p:cNvSpPr/>
                <p:nvPr/>
              </p:nvSpPr>
              <p:spPr>
                <a:xfrm>
                  <a:off x="880920" y="2445840"/>
                  <a:ext cx="8114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 COH</a:t>
                  </a:r>
                  <a:r>
                    <a:rPr b="1" lang="zh-CN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1" name="TextBox 293"/>
                <p:cNvSpPr/>
                <p:nvPr/>
              </p:nvSpPr>
              <p:spPr>
                <a:xfrm>
                  <a:off x="1041120" y="2302560"/>
                  <a:ext cx="411120" cy="16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12" name="直接连接符 294"/>
                <p:cNvSpPr/>
                <p:nvPr/>
              </p:nvSpPr>
              <p:spPr>
                <a:xfrm flipH="1">
                  <a:off x="1133280" y="2427840"/>
                  <a:ext cx="1440" cy="68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13" name="矩形 290"/>
              <p:cNvSpPr/>
              <p:nvPr/>
            </p:nvSpPr>
            <p:spPr>
              <a:xfrm>
                <a:off x="1018080" y="2300400"/>
                <a:ext cx="433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H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4" name="TextBox 288"/>
            <p:cNvSpPr/>
            <p:nvPr/>
          </p:nvSpPr>
          <p:spPr>
            <a:xfrm rot="5400000">
              <a:off x="1059480" y="2449080"/>
              <a:ext cx="160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=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5" name="弧形 295"/>
          <p:cNvSpPr/>
          <p:nvPr/>
        </p:nvSpPr>
        <p:spPr>
          <a:xfrm rot="10165800">
            <a:off x="1284120" y="1920600"/>
            <a:ext cx="439920" cy="1452600"/>
          </a:xfrm>
          <a:custGeom>
            <a:avLst/>
            <a:gdLst/>
            <a:ahLst/>
            <a:rect l="l" t="t" r="r" b="b"/>
            <a:pathLst>
              <a:path stroke="0" w="439737" h="1452563">
                <a:moveTo>
                  <a:pt x="219868" y="0"/>
                </a:moveTo>
                <a:cubicBezTo>
                  <a:pt x="341298" y="0"/>
                  <a:pt x="439737" y="325168"/>
                  <a:pt x="439737" y="726282"/>
                </a:cubicBezTo>
                <a:lnTo>
                  <a:pt x="219869" y="726282"/>
                </a:lnTo>
                <a:cubicBezTo>
                  <a:pt x="219869" y="484188"/>
                  <a:pt x="219868" y="242094"/>
                  <a:pt x="219868" y="0"/>
                </a:cubicBezTo>
                <a:close/>
              </a:path>
              <a:path fill="none" w="439737" h="1452563">
                <a:moveTo>
                  <a:pt x="219868" y="0"/>
                </a:moveTo>
                <a:cubicBezTo>
                  <a:pt x="341298" y="0"/>
                  <a:pt x="439737" y="325168"/>
                  <a:pt x="439737" y="726282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弧形 306"/>
          <p:cNvSpPr/>
          <p:nvPr/>
        </p:nvSpPr>
        <p:spPr>
          <a:xfrm rot="12578400">
            <a:off x="1385640" y="1135800"/>
            <a:ext cx="438120" cy="1202040"/>
          </a:xfrm>
          <a:custGeom>
            <a:avLst/>
            <a:gdLst/>
            <a:ahLst/>
            <a:rect l="l" t="t" r="r" b="b"/>
            <a:pathLst>
              <a:path stroke="0" w="438150" h="1201738">
                <a:moveTo>
                  <a:pt x="219075" y="0"/>
                </a:moveTo>
                <a:cubicBezTo>
                  <a:pt x="340067" y="0"/>
                  <a:pt x="438150" y="269018"/>
                  <a:pt x="438150" y="600869"/>
                </a:cubicBezTo>
                <a:lnTo>
                  <a:pt x="219075" y="600869"/>
                </a:lnTo>
                <a:lnTo>
                  <a:pt x="219075" y="0"/>
                </a:lnTo>
                <a:close/>
              </a:path>
              <a:path fill="none" w="438150" h="1201738">
                <a:moveTo>
                  <a:pt x="219075" y="0"/>
                </a:moveTo>
                <a:cubicBezTo>
                  <a:pt x="340067" y="0"/>
                  <a:pt x="438150" y="269018"/>
                  <a:pt x="438150" y="600869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7" name="组合 309"/>
          <p:cNvGrpSpPr/>
          <p:nvPr/>
        </p:nvGrpSpPr>
        <p:grpSpPr>
          <a:xfrm>
            <a:off x="1235160" y="1220760"/>
            <a:ext cx="960480" cy="563400"/>
            <a:chOff x="1235160" y="1220760"/>
            <a:chExt cx="960480" cy="563400"/>
          </a:xfrm>
        </p:grpSpPr>
        <p:grpSp>
          <p:nvGrpSpPr>
            <p:cNvPr id="218" name="组合 268"/>
            <p:cNvGrpSpPr/>
            <p:nvPr/>
          </p:nvGrpSpPr>
          <p:grpSpPr>
            <a:xfrm>
              <a:off x="1235160" y="1220760"/>
              <a:ext cx="960480" cy="563400"/>
              <a:chOff x="1235160" y="1220760"/>
              <a:chExt cx="960480" cy="563400"/>
            </a:xfrm>
          </p:grpSpPr>
          <p:grpSp>
            <p:nvGrpSpPr>
              <p:cNvPr id="219" name="组合 182"/>
              <p:cNvGrpSpPr/>
              <p:nvPr/>
            </p:nvGrpSpPr>
            <p:grpSpPr>
              <a:xfrm>
                <a:off x="1235160" y="1220760"/>
                <a:ext cx="960480" cy="563400"/>
                <a:chOff x="1235160" y="1220760"/>
                <a:chExt cx="960480" cy="563400"/>
              </a:xfrm>
            </p:grpSpPr>
            <p:sp>
              <p:nvSpPr>
                <p:cNvPr id="220" name="TextBox 302"/>
                <p:cNvSpPr/>
                <p:nvPr/>
              </p:nvSpPr>
              <p:spPr>
                <a:xfrm>
                  <a:off x="1363680" y="1494720"/>
                  <a:ext cx="411120" cy="289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3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1" name="TextBox 303"/>
                <p:cNvSpPr/>
                <p:nvPr/>
              </p:nvSpPr>
              <p:spPr>
                <a:xfrm>
                  <a:off x="1235160" y="1363320"/>
                  <a:ext cx="9604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 C=O</a:t>
                  </a:r>
                  <a:r>
                    <a:rPr b="1" lang="zh-CN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2" name="TextBox 304"/>
                <p:cNvSpPr/>
                <p:nvPr/>
              </p:nvSpPr>
              <p:spPr>
                <a:xfrm>
                  <a:off x="1366920" y="1220760"/>
                  <a:ext cx="411120" cy="16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23" name="直接连接符 305"/>
                <p:cNvSpPr/>
                <p:nvPr/>
              </p:nvSpPr>
              <p:spPr>
                <a:xfrm flipH="1">
                  <a:off x="1459080" y="1346040"/>
                  <a:ext cx="144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24" name="矩形 301"/>
              <p:cNvSpPr/>
              <p:nvPr/>
            </p:nvSpPr>
            <p:spPr>
              <a:xfrm>
                <a:off x="1369080" y="1228680"/>
                <a:ext cx="433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H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5" name="直接连接符 307"/>
            <p:cNvSpPr/>
            <p:nvPr/>
          </p:nvSpPr>
          <p:spPr>
            <a:xfrm flipH="1">
              <a:off x="1455840" y="1477800"/>
              <a:ext cx="144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6" name="弧形 308"/>
          <p:cNvSpPr/>
          <p:nvPr/>
        </p:nvSpPr>
        <p:spPr>
          <a:xfrm rot="14545800">
            <a:off x="1899000" y="387720"/>
            <a:ext cx="439920" cy="1200240"/>
          </a:xfrm>
          <a:custGeom>
            <a:avLst/>
            <a:gdLst/>
            <a:ahLst/>
            <a:rect l="l" t="t" r="r" b="b"/>
            <a:pathLst>
              <a:path stroke="0" w="439738" h="1200150">
                <a:moveTo>
                  <a:pt x="219869" y="0"/>
                </a:moveTo>
                <a:cubicBezTo>
                  <a:pt x="341299" y="0"/>
                  <a:pt x="439738" y="268663"/>
                  <a:pt x="439738" y="600075"/>
                </a:cubicBezTo>
                <a:lnTo>
                  <a:pt x="219869" y="600075"/>
                </a:lnTo>
                <a:lnTo>
                  <a:pt x="219869" y="0"/>
                </a:lnTo>
                <a:close/>
              </a:path>
              <a:path fill="none" w="439738" h="1200150">
                <a:moveTo>
                  <a:pt x="219869" y="0"/>
                </a:moveTo>
                <a:cubicBezTo>
                  <a:pt x="341299" y="0"/>
                  <a:pt x="439738" y="268663"/>
                  <a:pt x="439738" y="600075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27" name="组合 310"/>
          <p:cNvGrpSpPr/>
          <p:nvPr/>
        </p:nvGrpSpPr>
        <p:grpSpPr>
          <a:xfrm>
            <a:off x="1889280" y="474840"/>
            <a:ext cx="960120" cy="551520"/>
            <a:chOff x="1889280" y="474840"/>
            <a:chExt cx="960120" cy="551520"/>
          </a:xfrm>
        </p:grpSpPr>
        <p:grpSp>
          <p:nvGrpSpPr>
            <p:cNvPr id="228" name="组合 268"/>
            <p:cNvGrpSpPr/>
            <p:nvPr/>
          </p:nvGrpSpPr>
          <p:grpSpPr>
            <a:xfrm>
              <a:off x="1889280" y="474840"/>
              <a:ext cx="960120" cy="551520"/>
              <a:chOff x="1889280" y="474840"/>
              <a:chExt cx="960120" cy="551520"/>
            </a:xfrm>
          </p:grpSpPr>
          <p:grpSp>
            <p:nvGrpSpPr>
              <p:cNvPr id="229" name="组合 182"/>
              <p:cNvGrpSpPr/>
              <p:nvPr/>
            </p:nvGrpSpPr>
            <p:grpSpPr>
              <a:xfrm>
                <a:off x="1889280" y="474840"/>
                <a:ext cx="960120" cy="551520"/>
                <a:chOff x="1889280" y="474840"/>
                <a:chExt cx="960120" cy="551520"/>
              </a:xfrm>
            </p:grpSpPr>
            <p:sp>
              <p:nvSpPr>
                <p:cNvPr id="230" name="TextBox 315"/>
                <p:cNvSpPr/>
                <p:nvPr/>
              </p:nvSpPr>
              <p:spPr>
                <a:xfrm>
                  <a:off x="2017800" y="749520"/>
                  <a:ext cx="411120" cy="276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3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1" name="TextBox 316"/>
                <p:cNvSpPr/>
                <p:nvPr/>
              </p:nvSpPr>
              <p:spPr>
                <a:xfrm>
                  <a:off x="1889280" y="617760"/>
                  <a:ext cx="96012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 CHOH</a:t>
                  </a:r>
                  <a:r>
                    <a:rPr b="1" lang="zh-CN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2" name="TextBox 317"/>
                <p:cNvSpPr/>
                <p:nvPr/>
              </p:nvSpPr>
              <p:spPr>
                <a:xfrm>
                  <a:off x="2021040" y="474840"/>
                  <a:ext cx="411120" cy="16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33" name="直接连接符 318"/>
                <p:cNvSpPr/>
                <p:nvPr/>
              </p:nvSpPr>
              <p:spPr>
                <a:xfrm flipH="1">
                  <a:off x="2112840" y="600120"/>
                  <a:ext cx="144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34" name="矩形 314"/>
              <p:cNvSpPr/>
              <p:nvPr/>
            </p:nvSpPr>
            <p:spPr>
              <a:xfrm>
                <a:off x="2023200" y="482760"/>
                <a:ext cx="4338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H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5" name="直接连接符 312"/>
            <p:cNvSpPr/>
            <p:nvPr/>
          </p:nvSpPr>
          <p:spPr>
            <a:xfrm flipH="1">
              <a:off x="2109600" y="731880"/>
              <a:ext cx="1440" cy="68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6" name="弧形 319"/>
          <p:cNvSpPr/>
          <p:nvPr/>
        </p:nvSpPr>
        <p:spPr>
          <a:xfrm flipH="1" rot="2971800">
            <a:off x="4964040" y="3794040"/>
            <a:ext cx="392040" cy="350640"/>
          </a:xfrm>
          <a:custGeom>
            <a:avLst/>
            <a:gdLst/>
            <a:ahLst/>
            <a:rect l="l" t="t" r="r" b="b"/>
            <a:pathLst>
              <a:path stroke="0" w="392112" h="350838">
                <a:moveTo>
                  <a:pt x="196056" y="0"/>
                </a:moveTo>
                <a:cubicBezTo>
                  <a:pt x="304335" y="0"/>
                  <a:pt x="392112" y="78538"/>
                  <a:pt x="392112" y="175419"/>
                </a:cubicBezTo>
                <a:lnTo>
                  <a:pt x="196056" y="175419"/>
                </a:lnTo>
                <a:lnTo>
                  <a:pt x="196056" y="0"/>
                </a:lnTo>
                <a:close/>
              </a:path>
              <a:path fill="none" w="392112" h="350838">
                <a:moveTo>
                  <a:pt x="196056" y="0"/>
                </a:moveTo>
                <a:cubicBezTo>
                  <a:pt x="304335" y="0"/>
                  <a:pt x="392112" y="78538"/>
                  <a:pt x="392112" y="175419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Box 320"/>
          <p:cNvSpPr/>
          <p:nvPr/>
        </p:nvSpPr>
        <p:spPr>
          <a:xfrm>
            <a:off x="5235480" y="3767040"/>
            <a:ext cx="428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Pi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弧形 321"/>
          <p:cNvSpPr/>
          <p:nvPr/>
        </p:nvSpPr>
        <p:spPr>
          <a:xfrm rot="11197800">
            <a:off x="2755440" y="1625760"/>
            <a:ext cx="1030320" cy="1349280"/>
          </a:xfrm>
          <a:custGeom>
            <a:avLst/>
            <a:gdLst/>
            <a:ahLst/>
            <a:rect l="l" t="t" r="r" b="b"/>
            <a:pathLst>
              <a:path stroke="0" w="1030288" h="1349375">
                <a:moveTo>
                  <a:pt x="515144" y="0"/>
                </a:moveTo>
                <a:cubicBezTo>
                  <a:pt x="720868" y="0"/>
                  <a:pt x="906867" y="160307"/>
                  <a:pt x="988258" y="407762"/>
                </a:cubicBezTo>
                <a:cubicBezTo>
                  <a:pt x="1046102" y="583629"/>
                  <a:pt x="1044162" y="783403"/>
                  <a:pt x="982922" y="957286"/>
                </a:cubicBezTo>
                <a:cubicBezTo>
                  <a:pt x="895689" y="1204970"/>
                  <a:pt x="703168" y="1359496"/>
                  <a:pt x="495064" y="1348863"/>
                </a:cubicBezTo>
                <a:lnTo>
                  <a:pt x="515144" y="674688"/>
                </a:lnTo>
                <a:lnTo>
                  <a:pt x="515144" y="0"/>
                </a:lnTo>
                <a:close/>
              </a:path>
              <a:path fill="none" w="1030288" h="1349375">
                <a:moveTo>
                  <a:pt x="515144" y="0"/>
                </a:moveTo>
                <a:cubicBezTo>
                  <a:pt x="720868" y="0"/>
                  <a:pt x="906867" y="160307"/>
                  <a:pt x="988258" y="407762"/>
                </a:cubicBezTo>
                <a:cubicBezTo>
                  <a:pt x="1046102" y="583629"/>
                  <a:pt x="1044162" y="783403"/>
                  <a:pt x="982922" y="957286"/>
                </a:cubicBezTo>
                <a:cubicBezTo>
                  <a:pt x="895689" y="1204970"/>
                  <a:pt x="703168" y="1359496"/>
                  <a:pt x="495064" y="134886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弧形 322"/>
          <p:cNvSpPr/>
          <p:nvPr/>
        </p:nvSpPr>
        <p:spPr>
          <a:xfrm flipH="1" flipV="1" rot="10576800">
            <a:off x="3163680" y="1630440"/>
            <a:ext cx="1155600" cy="1349280"/>
          </a:xfrm>
          <a:custGeom>
            <a:avLst/>
            <a:gdLst/>
            <a:ahLst/>
            <a:rect l="l" t="t" r="r" b="b"/>
            <a:pathLst>
              <a:path stroke="0" w="1155700" h="1349375">
                <a:moveTo>
                  <a:pt x="577850" y="0"/>
                </a:moveTo>
                <a:cubicBezTo>
                  <a:pt x="799540" y="0"/>
                  <a:pt x="1001688" y="148085"/>
                  <a:pt x="1098141" y="381144"/>
                </a:cubicBezTo>
                <a:cubicBezTo>
                  <a:pt x="1177303" y="572422"/>
                  <a:pt x="1174682" y="796061"/>
                  <a:pt x="1091069" y="984739"/>
                </a:cubicBezTo>
                <a:cubicBezTo>
                  <a:pt x="988482" y="1216233"/>
                  <a:pt x="780867" y="1358028"/>
                  <a:pt x="557766" y="1348968"/>
                </a:cubicBezTo>
                <a:lnTo>
                  <a:pt x="577850" y="674688"/>
                </a:lnTo>
                <a:lnTo>
                  <a:pt x="577850" y="0"/>
                </a:lnTo>
                <a:close/>
              </a:path>
              <a:path fill="none" w="1155700" h="1349375">
                <a:moveTo>
                  <a:pt x="577850" y="0"/>
                </a:moveTo>
                <a:cubicBezTo>
                  <a:pt x="799540" y="0"/>
                  <a:pt x="1001688" y="148085"/>
                  <a:pt x="1098141" y="381144"/>
                </a:cubicBezTo>
                <a:cubicBezTo>
                  <a:pt x="1177303" y="572422"/>
                  <a:pt x="1174682" y="796061"/>
                  <a:pt x="1091069" y="984739"/>
                </a:cubicBezTo>
                <a:cubicBezTo>
                  <a:pt x="988482" y="1216233"/>
                  <a:pt x="780867" y="1358028"/>
                  <a:pt x="557766" y="1348968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Box 323"/>
          <p:cNvSpPr/>
          <p:nvPr/>
        </p:nvSpPr>
        <p:spPr>
          <a:xfrm>
            <a:off x="3213000" y="2900520"/>
            <a:ext cx="857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(NADH+H</a:t>
            </a:r>
            <a:r>
              <a:rPr b="1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Box 324"/>
          <p:cNvSpPr/>
          <p:nvPr/>
        </p:nvSpPr>
        <p:spPr>
          <a:xfrm>
            <a:off x="3321000" y="1538280"/>
            <a:ext cx="8571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(NAD</a:t>
            </a:r>
            <a:r>
              <a:rPr b="1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弧形 326"/>
          <p:cNvSpPr/>
          <p:nvPr/>
        </p:nvSpPr>
        <p:spPr>
          <a:xfrm flipH="1" rot="9424800">
            <a:off x="4590360" y="2016000"/>
            <a:ext cx="191880" cy="1884240"/>
          </a:xfrm>
          <a:custGeom>
            <a:avLst/>
            <a:gdLst/>
            <a:ahLst/>
            <a:rect l="l" t="t" r="r" b="b"/>
            <a:pathLst>
              <a:path stroke="0" w="192088" h="1884363">
                <a:moveTo>
                  <a:pt x="96044" y="0"/>
                </a:moveTo>
                <a:cubicBezTo>
                  <a:pt x="147012" y="0"/>
                  <a:pt x="189105" y="390562"/>
                  <a:pt x="191939" y="889783"/>
                </a:cubicBezTo>
                <a:cubicBezTo>
                  <a:pt x="192154" y="927730"/>
                  <a:pt x="192136" y="965770"/>
                  <a:pt x="191883" y="1003695"/>
                </a:cubicBezTo>
                <a:cubicBezTo>
                  <a:pt x="187008" y="1734580"/>
                  <a:pt x="102710" y="2133782"/>
                  <a:pt x="41340" y="1716604"/>
                </a:cubicBezTo>
                <a:lnTo>
                  <a:pt x="96044" y="942182"/>
                </a:lnTo>
                <a:lnTo>
                  <a:pt x="96044" y="0"/>
                </a:lnTo>
                <a:close/>
              </a:path>
              <a:path fill="none" w="192088" h="1884363">
                <a:moveTo>
                  <a:pt x="96044" y="0"/>
                </a:moveTo>
                <a:cubicBezTo>
                  <a:pt x="147012" y="0"/>
                  <a:pt x="189105" y="390562"/>
                  <a:pt x="191939" y="889783"/>
                </a:cubicBezTo>
                <a:cubicBezTo>
                  <a:pt x="192154" y="927730"/>
                  <a:pt x="192136" y="965770"/>
                  <a:pt x="191883" y="1003695"/>
                </a:cubicBezTo>
                <a:cubicBezTo>
                  <a:pt x="187008" y="1734580"/>
                  <a:pt x="102710" y="2133782"/>
                  <a:pt x="41340" y="1716604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弧形 327"/>
          <p:cNvSpPr/>
          <p:nvPr/>
        </p:nvSpPr>
        <p:spPr>
          <a:xfrm rot="1584600">
            <a:off x="2134800" y="1739520"/>
            <a:ext cx="620640" cy="776160"/>
          </a:xfrm>
          <a:custGeom>
            <a:avLst/>
            <a:gdLst/>
            <a:ahLst/>
            <a:rect l="l" t="t" r="r" b="b"/>
            <a:pathLst>
              <a:path stroke="0" w="620712" h="776288">
                <a:moveTo>
                  <a:pt x="328559" y="668"/>
                </a:moveTo>
                <a:cubicBezTo>
                  <a:pt x="466201" y="10782"/>
                  <a:pt x="582005" y="133251"/>
                  <a:pt x="612847" y="301320"/>
                </a:cubicBezTo>
                <a:lnTo>
                  <a:pt x="310356" y="388144"/>
                </a:lnTo>
                <a:lnTo>
                  <a:pt x="328559" y="668"/>
                </a:lnTo>
                <a:close/>
              </a:path>
              <a:path fill="none" w="620712" h="776288">
                <a:moveTo>
                  <a:pt x="328559" y="668"/>
                </a:moveTo>
                <a:cubicBezTo>
                  <a:pt x="466201" y="10782"/>
                  <a:pt x="582005" y="133251"/>
                  <a:pt x="612847" y="30132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弧形 328"/>
          <p:cNvSpPr/>
          <p:nvPr/>
        </p:nvSpPr>
        <p:spPr>
          <a:xfrm flipH="1" rot="7783200">
            <a:off x="1784160" y="434160"/>
            <a:ext cx="277560" cy="1497240"/>
          </a:xfrm>
          <a:custGeom>
            <a:avLst/>
            <a:gdLst/>
            <a:ahLst/>
            <a:rect l="l" t="t" r="r" b="b"/>
            <a:pathLst>
              <a:path stroke="0" w="277813" h="1497013">
                <a:moveTo>
                  <a:pt x="169041" y="17826"/>
                </a:moveTo>
                <a:cubicBezTo>
                  <a:pt x="232595" y="93934"/>
                  <a:pt x="277813" y="397686"/>
                  <a:pt x="277813" y="748507"/>
                </a:cubicBezTo>
                <a:lnTo>
                  <a:pt x="138907" y="748507"/>
                </a:lnTo>
                <a:lnTo>
                  <a:pt x="169041" y="17826"/>
                </a:lnTo>
                <a:close/>
              </a:path>
              <a:path fill="none" w="277813" h="1497013">
                <a:moveTo>
                  <a:pt x="169041" y="17826"/>
                </a:moveTo>
                <a:cubicBezTo>
                  <a:pt x="232595" y="93934"/>
                  <a:pt x="277813" y="397686"/>
                  <a:pt x="277813" y="748507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TextBox 329"/>
          <p:cNvSpPr/>
          <p:nvPr/>
        </p:nvSpPr>
        <p:spPr>
          <a:xfrm>
            <a:off x="2381400" y="1660680"/>
            <a:ext cx="48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2H</a:t>
            </a:r>
            <a:r>
              <a:rPr b="1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TextBox 330"/>
          <p:cNvSpPr/>
          <p:nvPr/>
        </p:nvSpPr>
        <p:spPr>
          <a:xfrm>
            <a:off x="1781280" y="928800"/>
            <a:ext cx="482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2H</a:t>
            </a:r>
            <a:r>
              <a:rPr b="1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弧形 331"/>
          <p:cNvSpPr/>
          <p:nvPr/>
        </p:nvSpPr>
        <p:spPr>
          <a:xfrm>
            <a:off x="1284120" y="1446120"/>
            <a:ext cx="668520" cy="374760"/>
          </a:xfrm>
          <a:custGeom>
            <a:avLst/>
            <a:gdLst/>
            <a:ahLst/>
            <a:rect l="l" t="t" r="r" b="b"/>
            <a:pathLst>
              <a:path stroke="0" w="668337" h="374650">
                <a:moveTo>
                  <a:pt x="334168" y="0"/>
                </a:moveTo>
                <a:cubicBezTo>
                  <a:pt x="513956" y="0"/>
                  <a:pt x="661520" y="79740"/>
                  <a:pt x="668112" y="180456"/>
                </a:cubicBezTo>
                <a:cubicBezTo>
                  <a:pt x="674944" y="284840"/>
                  <a:pt x="528161" y="372191"/>
                  <a:pt x="341875" y="374600"/>
                </a:cubicBezTo>
                <a:lnTo>
                  <a:pt x="334169" y="187325"/>
                </a:lnTo>
                <a:cubicBezTo>
                  <a:pt x="334169" y="124883"/>
                  <a:pt x="334168" y="62442"/>
                  <a:pt x="334168" y="0"/>
                </a:cubicBezTo>
                <a:close/>
              </a:path>
              <a:path fill="none" w="668337" h="374650">
                <a:moveTo>
                  <a:pt x="334168" y="0"/>
                </a:moveTo>
                <a:cubicBezTo>
                  <a:pt x="513956" y="0"/>
                  <a:pt x="661520" y="79740"/>
                  <a:pt x="668112" y="180456"/>
                </a:cubicBezTo>
                <a:cubicBezTo>
                  <a:pt x="674944" y="284840"/>
                  <a:pt x="528161" y="372191"/>
                  <a:pt x="341875" y="37460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弧形 332"/>
          <p:cNvSpPr/>
          <p:nvPr/>
        </p:nvSpPr>
        <p:spPr>
          <a:xfrm>
            <a:off x="1546200" y="1614600"/>
            <a:ext cx="749160" cy="645840"/>
          </a:xfrm>
          <a:custGeom>
            <a:avLst/>
            <a:gdLst/>
            <a:ahLst/>
            <a:rect l="l" t="t" r="r" b="b"/>
            <a:pathLst>
              <a:path stroke="0" w="749300" h="646112">
                <a:moveTo>
                  <a:pt x="413021" y="1699"/>
                </a:moveTo>
                <a:cubicBezTo>
                  <a:pt x="617534" y="19856"/>
                  <a:pt x="766871" y="176736"/>
                  <a:pt x="747661" y="353242"/>
                </a:cubicBezTo>
                <a:lnTo>
                  <a:pt x="374650" y="323056"/>
                </a:lnTo>
                <a:lnTo>
                  <a:pt x="413021" y="1699"/>
                </a:lnTo>
                <a:close/>
              </a:path>
              <a:path fill="none" w="749300" h="646112">
                <a:moveTo>
                  <a:pt x="413021" y="1699"/>
                </a:moveTo>
                <a:cubicBezTo>
                  <a:pt x="617534" y="19856"/>
                  <a:pt x="766871" y="176736"/>
                  <a:pt x="747661" y="353242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TextBox 333"/>
          <p:cNvSpPr/>
          <p:nvPr/>
        </p:nvSpPr>
        <p:spPr>
          <a:xfrm>
            <a:off x="1455840" y="1824120"/>
            <a:ext cx="64296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CO</a:t>
            </a:r>
            <a:r>
              <a:rPr b="1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0" name="组合 335"/>
          <p:cNvGrpSpPr/>
          <p:nvPr/>
        </p:nvGrpSpPr>
        <p:grpSpPr>
          <a:xfrm>
            <a:off x="2060640" y="1940040"/>
            <a:ext cx="960480" cy="433080"/>
            <a:chOff x="2060640" y="1940040"/>
            <a:chExt cx="960480" cy="433080"/>
          </a:xfrm>
        </p:grpSpPr>
        <p:grpSp>
          <p:nvGrpSpPr>
            <p:cNvPr id="251" name="组合 182"/>
            <p:cNvGrpSpPr/>
            <p:nvPr/>
          </p:nvGrpSpPr>
          <p:grpSpPr>
            <a:xfrm>
              <a:off x="2060640" y="1940040"/>
              <a:ext cx="960480" cy="433080"/>
              <a:chOff x="2060640" y="1940040"/>
              <a:chExt cx="960480" cy="433080"/>
            </a:xfrm>
          </p:grpSpPr>
          <p:sp>
            <p:nvSpPr>
              <p:cNvPr id="252" name="TextBox 340"/>
              <p:cNvSpPr/>
              <p:nvPr/>
            </p:nvSpPr>
            <p:spPr>
              <a:xfrm>
                <a:off x="2189160" y="2071080"/>
                <a:ext cx="411120" cy="30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TextBox 341"/>
              <p:cNvSpPr/>
              <p:nvPr/>
            </p:nvSpPr>
            <p:spPr>
              <a:xfrm>
                <a:off x="2060640" y="1940040"/>
                <a:ext cx="96048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O</a:t>
                </a:r>
                <a:r>
                  <a:rPr b="1" lang="zh-CN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4" name="直接连接符 337"/>
            <p:cNvSpPr/>
            <p:nvPr/>
          </p:nvSpPr>
          <p:spPr>
            <a:xfrm flipH="1">
              <a:off x="2295360" y="2059200"/>
              <a:ext cx="144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55" name="弧形 344"/>
          <p:cNvSpPr/>
          <p:nvPr/>
        </p:nvSpPr>
        <p:spPr>
          <a:xfrm rot="12578400">
            <a:off x="2817360" y="770760"/>
            <a:ext cx="135000" cy="1003320"/>
          </a:xfrm>
          <a:custGeom>
            <a:avLst/>
            <a:gdLst/>
            <a:ahLst/>
            <a:rect l="l" t="t" r="r" b="b"/>
            <a:pathLst>
              <a:path stroke="0" w="134937" h="1003300">
                <a:moveTo>
                  <a:pt x="67468" y="0"/>
                </a:moveTo>
                <a:cubicBezTo>
                  <a:pt x="103139" y="0"/>
                  <a:pt x="132646" y="206450"/>
                  <a:pt x="134812" y="471181"/>
                </a:cubicBezTo>
                <a:cubicBezTo>
                  <a:pt x="135056" y="500983"/>
                  <a:pt x="134941" y="530888"/>
                  <a:pt x="134470" y="560539"/>
                </a:cubicBezTo>
                <a:lnTo>
                  <a:pt x="67469" y="501650"/>
                </a:lnTo>
                <a:cubicBezTo>
                  <a:pt x="67469" y="334433"/>
                  <a:pt x="67468" y="167217"/>
                  <a:pt x="67468" y="0"/>
                </a:cubicBezTo>
                <a:close/>
              </a:path>
              <a:path fill="none" w="134937" h="1003300">
                <a:moveTo>
                  <a:pt x="67468" y="0"/>
                </a:moveTo>
                <a:cubicBezTo>
                  <a:pt x="103139" y="0"/>
                  <a:pt x="132646" y="206450"/>
                  <a:pt x="134812" y="471181"/>
                </a:cubicBezTo>
                <a:cubicBezTo>
                  <a:pt x="135056" y="500983"/>
                  <a:pt x="134941" y="530888"/>
                  <a:pt x="134470" y="560539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6" name="组合 345"/>
          <p:cNvGrpSpPr/>
          <p:nvPr/>
        </p:nvGrpSpPr>
        <p:grpSpPr>
          <a:xfrm>
            <a:off x="2651040" y="992160"/>
            <a:ext cx="960480" cy="420840"/>
            <a:chOff x="2651040" y="992160"/>
            <a:chExt cx="960480" cy="420840"/>
          </a:xfrm>
        </p:grpSpPr>
        <p:grpSp>
          <p:nvGrpSpPr>
            <p:cNvPr id="257" name="组合 182"/>
            <p:cNvGrpSpPr/>
            <p:nvPr/>
          </p:nvGrpSpPr>
          <p:grpSpPr>
            <a:xfrm>
              <a:off x="2651040" y="992160"/>
              <a:ext cx="960480" cy="420840"/>
              <a:chOff x="2651040" y="992160"/>
              <a:chExt cx="960480" cy="420840"/>
            </a:xfrm>
          </p:grpSpPr>
          <p:sp>
            <p:nvSpPr>
              <p:cNvPr id="258" name="TextBox 348"/>
              <p:cNvSpPr/>
              <p:nvPr/>
            </p:nvSpPr>
            <p:spPr>
              <a:xfrm>
                <a:off x="2833920" y="1123560"/>
                <a:ext cx="411120" cy="289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3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9" name="TextBox 349"/>
              <p:cNvSpPr/>
              <p:nvPr/>
            </p:nvSpPr>
            <p:spPr>
              <a:xfrm>
                <a:off x="2651040" y="992160"/>
                <a:ext cx="960480" cy="19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H</a:t>
                </a:r>
                <a:r>
                  <a:rPr b="1" lang="zh-CN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60" name="直接连接符 347"/>
            <p:cNvSpPr/>
            <p:nvPr/>
          </p:nvSpPr>
          <p:spPr>
            <a:xfrm flipH="1">
              <a:off x="2925720" y="1106280"/>
              <a:ext cx="1440" cy="68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61" name="弧形 351"/>
          <p:cNvSpPr/>
          <p:nvPr/>
        </p:nvSpPr>
        <p:spPr>
          <a:xfrm flipV="1" rot="8534400">
            <a:off x="4105080" y="4325040"/>
            <a:ext cx="398160" cy="401760"/>
          </a:xfrm>
          <a:custGeom>
            <a:avLst/>
            <a:gdLst/>
            <a:ahLst/>
            <a:rect l="l" t="t" r="r" b="b"/>
            <a:pathLst>
              <a:path stroke="0" w="398463" h="401637">
                <a:moveTo>
                  <a:pt x="86" y="206707"/>
                </a:moveTo>
                <a:cubicBezTo>
                  <a:pt x="-2014" y="134554"/>
                  <a:pt x="34466" y="66817"/>
                  <a:pt x="95636" y="29283"/>
                </a:cubicBezTo>
                <a:cubicBezTo>
                  <a:pt x="157456" y="-8650"/>
                  <a:pt x="234823" y="-9807"/>
                  <a:pt x="297733" y="26260"/>
                </a:cubicBezTo>
                <a:cubicBezTo>
                  <a:pt x="360003" y="61960"/>
                  <a:pt x="398464" y="128610"/>
                  <a:pt x="398464" y="200818"/>
                </a:cubicBezTo>
                <a:lnTo>
                  <a:pt x="199232" y="200819"/>
                </a:lnTo>
                <a:lnTo>
                  <a:pt x="86" y="206707"/>
                </a:lnTo>
                <a:close/>
              </a:path>
              <a:path fill="none" w="398463" h="401637">
                <a:moveTo>
                  <a:pt x="86" y="206707"/>
                </a:moveTo>
                <a:cubicBezTo>
                  <a:pt x="-2014" y="134554"/>
                  <a:pt x="34466" y="66817"/>
                  <a:pt x="95636" y="29283"/>
                </a:cubicBezTo>
                <a:cubicBezTo>
                  <a:pt x="157456" y="-8650"/>
                  <a:pt x="234823" y="-9807"/>
                  <a:pt x="297733" y="26260"/>
                </a:cubicBezTo>
                <a:cubicBezTo>
                  <a:pt x="360003" y="61960"/>
                  <a:pt x="398464" y="128610"/>
                  <a:pt x="398464" y="200818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TextBox 352"/>
          <p:cNvSpPr/>
          <p:nvPr/>
        </p:nvSpPr>
        <p:spPr>
          <a:xfrm>
            <a:off x="4035600" y="4622760"/>
            <a:ext cx="428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AT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TextBox 353"/>
          <p:cNvSpPr/>
          <p:nvPr/>
        </p:nvSpPr>
        <p:spPr>
          <a:xfrm>
            <a:off x="4284720" y="4403880"/>
            <a:ext cx="428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AD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TextBox 354"/>
          <p:cNvSpPr/>
          <p:nvPr/>
        </p:nvSpPr>
        <p:spPr>
          <a:xfrm>
            <a:off x="2092320" y="3984480"/>
            <a:ext cx="428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g2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弧形 355"/>
          <p:cNvSpPr/>
          <p:nvPr/>
        </p:nvSpPr>
        <p:spPr>
          <a:xfrm flipV="1" rot="8534400">
            <a:off x="1890000" y="4119480"/>
            <a:ext cx="312840" cy="162000"/>
          </a:xfrm>
          <a:custGeom>
            <a:avLst/>
            <a:gdLst/>
            <a:ahLst/>
            <a:rect l="l" t="t" r="r" b="b"/>
            <a:pathLst>
              <a:path stroke="0" w="312737" h="161925">
                <a:moveTo>
                  <a:pt x="254" y="85579"/>
                </a:moveTo>
                <a:cubicBezTo>
                  <a:pt x="-3834" y="48519"/>
                  <a:pt x="41276" y="14768"/>
                  <a:pt x="109701" y="3690"/>
                </a:cubicBezTo>
                <a:cubicBezTo>
                  <a:pt x="139131" y="-1075"/>
                  <a:pt x="170624" y="-1228"/>
                  <a:pt x="200222" y="3249"/>
                </a:cubicBezTo>
                <a:cubicBezTo>
                  <a:pt x="266905" y="13337"/>
                  <a:pt x="312738" y="44993"/>
                  <a:pt x="312738" y="80963"/>
                </a:cubicBezTo>
                <a:lnTo>
                  <a:pt x="156369" y="80963"/>
                </a:lnTo>
                <a:lnTo>
                  <a:pt x="254" y="85579"/>
                </a:lnTo>
                <a:close/>
              </a:path>
              <a:path fill="none" w="312737" h="161925">
                <a:moveTo>
                  <a:pt x="254" y="85579"/>
                </a:moveTo>
                <a:cubicBezTo>
                  <a:pt x="-3834" y="48519"/>
                  <a:pt x="41276" y="14768"/>
                  <a:pt x="109701" y="3690"/>
                </a:cubicBezTo>
                <a:cubicBezTo>
                  <a:pt x="139131" y="-1075"/>
                  <a:pt x="170624" y="-1228"/>
                  <a:pt x="200222" y="3249"/>
                </a:cubicBezTo>
                <a:cubicBezTo>
                  <a:pt x="266905" y="13337"/>
                  <a:pt x="312738" y="44993"/>
                  <a:pt x="312738" y="8096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TextBox 356"/>
          <p:cNvSpPr/>
          <p:nvPr/>
        </p:nvSpPr>
        <p:spPr>
          <a:xfrm>
            <a:off x="1795320" y="4278240"/>
            <a:ext cx="53676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H</a:t>
            </a:r>
            <a:r>
              <a:rPr b="1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弧形 357"/>
          <p:cNvSpPr/>
          <p:nvPr/>
        </p:nvSpPr>
        <p:spPr>
          <a:xfrm flipV="1" rot="14189400">
            <a:off x="1041840" y="3028320"/>
            <a:ext cx="399960" cy="401400"/>
          </a:xfrm>
          <a:custGeom>
            <a:avLst/>
            <a:gdLst/>
            <a:ahLst/>
            <a:rect l="l" t="t" r="r" b="b"/>
            <a:pathLst>
              <a:path stroke="0" w="400050" h="401638">
                <a:moveTo>
                  <a:pt x="87" y="206731"/>
                </a:moveTo>
                <a:cubicBezTo>
                  <a:pt x="-2034" y="134444"/>
                  <a:pt x="34723" y="66595"/>
                  <a:pt x="96318" y="29100"/>
                </a:cubicBezTo>
                <a:cubicBezTo>
                  <a:pt x="158239" y="-8593"/>
                  <a:pt x="235616" y="-9744"/>
                  <a:pt x="298621" y="26092"/>
                </a:cubicBezTo>
                <a:cubicBezTo>
                  <a:pt x="361306" y="61746"/>
                  <a:pt x="400050" y="128488"/>
                  <a:pt x="400050" y="200819"/>
                </a:cubicBezTo>
                <a:lnTo>
                  <a:pt x="200025" y="200819"/>
                </a:lnTo>
                <a:lnTo>
                  <a:pt x="87" y="206731"/>
                </a:lnTo>
                <a:close/>
              </a:path>
              <a:path fill="none" w="400050" h="401638">
                <a:moveTo>
                  <a:pt x="87" y="206731"/>
                </a:moveTo>
                <a:cubicBezTo>
                  <a:pt x="-2034" y="134444"/>
                  <a:pt x="34723" y="66595"/>
                  <a:pt x="96318" y="29100"/>
                </a:cubicBezTo>
                <a:cubicBezTo>
                  <a:pt x="158239" y="-8593"/>
                  <a:pt x="235616" y="-9744"/>
                  <a:pt x="298621" y="26092"/>
                </a:cubicBezTo>
                <a:cubicBezTo>
                  <a:pt x="361306" y="61746"/>
                  <a:pt x="400050" y="128488"/>
                  <a:pt x="400050" y="200819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TextBox 358"/>
          <p:cNvSpPr/>
          <p:nvPr/>
        </p:nvSpPr>
        <p:spPr>
          <a:xfrm>
            <a:off x="1052640" y="3332160"/>
            <a:ext cx="428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AD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TextBox 359"/>
          <p:cNvSpPr/>
          <p:nvPr/>
        </p:nvSpPr>
        <p:spPr>
          <a:xfrm>
            <a:off x="852480" y="2992320"/>
            <a:ext cx="428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AT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TextBox 360"/>
          <p:cNvSpPr/>
          <p:nvPr/>
        </p:nvSpPr>
        <p:spPr>
          <a:xfrm>
            <a:off x="5595840" y="43668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TextBox 361"/>
          <p:cNvSpPr/>
          <p:nvPr/>
        </p:nvSpPr>
        <p:spPr>
          <a:xfrm>
            <a:off x="4626000" y="43488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TextBox 362"/>
          <p:cNvSpPr/>
          <p:nvPr/>
        </p:nvSpPr>
        <p:spPr>
          <a:xfrm>
            <a:off x="5197320" y="1589040"/>
            <a:ext cx="349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TextBox 363"/>
          <p:cNvSpPr/>
          <p:nvPr/>
        </p:nvSpPr>
        <p:spPr>
          <a:xfrm>
            <a:off x="5521320" y="262404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TextBox 364"/>
          <p:cNvSpPr/>
          <p:nvPr/>
        </p:nvSpPr>
        <p:spPr>
          <a:xfrm>
            <a:off x="5335560" y="319248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5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TextBox 365"/>
          <p:cNvSpPr/>
          <p:nvPr/>
        </p:nvSpPr>
        <p:spPr>
          <a:xfrm>
            <a:off x="4976640" y="380196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6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TextBox 366"/>
          <p:cNvSpPr/>
          <p:nvPr/>
        </p:nvSpPr>
        <p:spPr>
          <a:xfrm>
            <a:off x="4065480" y="418788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7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Box 367"/>
          <p:cNvSpPr/>
          <p:nvPr/>
        </p:nvSpPr>
        <p:spPr>
          <a:xfrm>
            <a:off x="3139920" y="4335480"/>
            <a:ext cx="349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8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Box 368"/>
          <p:cNvSpPr/>
          <p:nvPr/>
        </p:nvSpPr>
        <p:spPr>
          <a:xfrm>
            <a:off x="1852560" y="395280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9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Box 369"/>
          <p:cNvSpPr/>
          <p:nvPr/>
        </p:nvSpPr>
        <p:spPr>
          <a:xfrm>
            <a:off x="1386000" y="300672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Box 370"/>
          <p:cNvSpPr/>
          <p:nvPr/>
        </p:nvSpPr>
        <p:spPr>
          <a:xfrm>
            <a:off x="1017720" y="1874880"/>
            <a:ext cx="347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1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TextBox 371"/>
          <p:cNvSpPr/>
          <p:nvPr/>
        </p:nvSpPr>
        <p:spPr>
          <a:xfrm>
            <a:off x="1290600" y="69048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TextBox 372"/>
          <p:cNvSpPr/>
          <p:nvPr/>
        </p:nvSpPr>
        <p:spPr>
          <a:xfrm>
            <a:off x="2122560" y="157464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Box 373"/>
          <p:cNvSpPr/>
          <p:nvPr/>
        </p:nvSpPr>
        <p:spPr>
          <a:xfrm>
            <a:off x="2517840" y="123192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284" name="Picture 2" descr="F:\油料所工作\05241.tif"/>
          <p:cNvPicPr/>
          <p:nvPr/>
        </p:nvPicPr>
        <p:blipFill>
          <a:blip r:embed="rId3"/>
          <a:stretch/>
        </p:blipFill>
        <p:spPr>
          <a:xfrm>
            <a:off x="1015920" y="87480"/>
            <a:ext cx="809640" cy="485640"/>
          </a:xfrm>
          <a:prstGeom prst="rect">
            <a:avLst/>
          </a:prstGeom>
          <a:ln w="0">
            <a:noFill/>
          </a:ln>
        </p:spPr>
      </p:pic>
      <p:pic>
        <p:nvPicPr>
          <p:cNvPr id="285" name="Picture 4" descr="F:\油料所工作\05243.tif"/>
          <p:cNvPicPr/>
          <p:nvPr/>
        </p:nvPicPr>
        <p:blipFill>
          <a:blip r:embed="rId4"/>
          <a:stretch/>
        </p:blipFill>
        <p:spPr>
          <a:xfrm>
            <a:off x="5946840" y="1071720"/>
            <a:ext cx="809640" cy="701640"/>
          </a:xfrm>
          <a:prstGeom prst="rect">
            <a:avLst/>
          </a:prstGeom>
          <a:ln w="0">
            <a:noFill/>
          </a:ln>
        </p:spPr>
      </p:pic>
      <p:pic>
        <p:nvPicPr>
          <p:cNvPr id="286" name="Picture 5" descr="F:\油料所工作\05244.tif"/>
          <p:cNvPicPr/>
          <p:nvPr/>
        </p:nvPicPr>
        <p:blipFill>
          <a:blip r:embed="rId5"/>
          <a:stretch/>
        </p:blipFill>
        <p:spPr>
          <a:xfrm>
            <a:off x="5784840" y="2600280"/>
            <a:ext cx="811080" cy="216000"/>
          </a:xfrm>
          <a:prstGeom prst="rect">
            <a:avLst/>
          </a:prstGeom>
          <a:ln w="0">
            <a:noFill/>
          </a:ln>
        </p:spPr>
      </p:pic>
      <p:pic>
        <p:nvPicPr>
          <p:cNvPr id="287" name="Picture 6" descr="F:\油料所工作\05245.tif"/>
          <p:cNvPicPr/>
          <p:nvPr/>
        </p:nvPicPr>
        <p:blipFill>
          <a:blip r:embed="rId6"/>
          <a:stretch/>
        </p:blipFill>
        <p:spPr>
          <a:xfrm>
            <a:off x="5924520" y="3191040"/>
            <a:ext cx="809640" cy="269640"/>
          </a:xfrm>
          <a:prstGeom prst="rect">
            <a:avLst/>
          </a:prstGeom>
          <a:ln w="0">
            <a:noFill/>
          </a:ln>
        </p:spPr>
      </p:pic>
      <p:pic>
        <p:nvPicPr>
          <p:cNvPr id="288" name="Picture 7" descr="F:\油料所工作\05246.tif"/>
          <p:cNvPicPr/>
          <p:nvPr/>
        </p:nvPicPr>
        <p:blipFill>
          <a:blip r:embed="rId7"/>
          <a:stretch/>
        </p:blipFill>
        <p:spPr>
          <a:xfrm>
            <a:off x="5035680" y="3994200"/>
            <a:ext cx="809640" cy="108000"/>
          </a:xfrm>
          <a:prstGeom prst="rect">
            <a:avLst/>
          </a:prstGeom>
          <a:ln w="0">
            <a:noFill/>
          </a:ln>
        </p:spPr>
      </p:pic>
      <p:pic>
        <p:nvPicPr>
          <p:cNvPr id="289" name="Picture 8" descr="F:\油料所工作\05248.tif"/>
          <p:cNvPicPr/>
          <p:nvPr/>
        </p:nvPicPr>
        <p:blipFill>
          <a:blip r:embed="rId8"/>
          <a:stretch/>
        </p:blipFill>
        <p:spPr>
          <a:xfrm>
            <a:off x="2955960" y="4157640"/>
            <a:ext cx="811080" cy="108000"/>
          </a:xfrm>
          <a:prstGeom prst="rect">
            <a:avLst/>
          </a:prstGeom>
          <a:ln w="0">
            <a:noFill/>
          </a:ln>
        </p:spPr>
      </p:pic>
      <p:pic>
        <p:nvPicPr>
          <p:cNvPr id="290" name="Picture 9" descr="F:\油料所工作\05249.tif"/>
          <p:cNvPicPr/>
          <p:nvPr/>
        </p:nvPicPr>
        <p:blipFill>
          <a:blip r:embed="rId9"/>
          <a:stretch/>
        </p:blipFill>
        <p:spPr>
          <a:xfrm>
            <a:off x="1060560" y="3865680"/>
            <a:ext cx="809640" cy="377640"/>
          </a:xfrm>
          <a:prstGeom prst="rect">
            <a:avLst/>
          </a:prstGeom>
          <a:ln w="0">
            <a:noFill/>
          </a:ln>
        </p:spPr>
      </p:pic>
      <p:pic>
        <p:nvPicPr>
          <p:cNvPr id="291" name="Picture 10" descr="F:\油料所工作\052410.tif"/>
          <p:cNvPicPr/>
          <p:nvPr/>
        </p:nvPicPr>
        <p:blipFill>
          <a:blip r:embed="rId10"/>
          <a:stretch/>
        </p:blipFill>
        <p:spPr>
          <a:xfrm>
            <a:off x="1641600" y="2900520"/>
            <a:ext cx="809640" cy="323640"/>
          </a:xfrm>
          <a:prstGeom prst="rect">
            <a:avLst/>
          </a:prstGeom>
          <a:ln w="0">
            <a:noFill/>
          </a:ln>
        </p:spPr>
      </p:pic>
      <p:pic>
        <p:nvPicPr>
          <p:cNvPr id="292" name="Picture 11" descr="F:\油料所工作\052412.tif"/>
          <p:cNvPicPr/>
          <p:nvPr/>
        </p:nvPicPr>
        <p:blipFill>
          <a:blip r:embed="rId11"/>
          <a:srcRect l="0" t="0" r="0" b="50333"/>
          <a:stretch/>
        </p:blipFill>
        <p:spPr>
          <a:xfrm>
            <a:off x="1014480" y="852480"/>
            <a:ext cx="809640" cy="54000"/>
          </a:xfrm>
          <a:prstGeom prst="rect">
            <a:avLst/>
          </a:prstGeom>
          <a:ln w="0">
            <a:noFill/>
          </a:ln>
        </p:spPr>
      </p:pic>
      <p:pic>
        <p:nvPicPr>
          <p:cNvPr id="293" name="Picture 12" descr="F:\油料所工作\052413.tif"/>
          <p:cNvPicPr/>
          <p:nvPr/>
        </p:nvPicPr>
        <p:blipFill>
          <a:blip r:embed="rId12"/>
          <a:stretch/>
        </p:blipFill>
        <p:spPr>
          <a:xfrm>
            <a:off x="1398600" y="1967040"/>
            <a:ext cx="811080" cy="323640"/>
          </a:xfrm>
          <a:prstGeom prst="rect">
            <a:avLst/>
          </a:prstGeom>
          <a:ln w="0">
            <a:noFill/>
          </a:ln>
        </p:spPr>
      </p:pic>
      <p:sp>
        <p:nvSpPr>
          <p:cNvPr id="294" name="TextBox 262"/>
          <p:cNvSpPr/>
          <p:nvPr/>
        </p:nvSpPr>
        <p:spPr>
          <a:xfrm>
            <a:off x="776160" y="20016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TextBox 263"/>
          <p:cNvSpPr/>
          <p:nvPr/>
        </p:nvSpPr>
        <p:spPr>
          <a:xfrm>
            <a:off x="3429000" y="20304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TextBox 264"/>
          <p:cNvSpPr/>
          <p:nvPr/>
        </p:nvSpPr>
        <p:spPr>
          <a:xfrm>
            <a:off x="6664320" y="134460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TextBox 275"/>
          <p:cNvSpPr/>
          <p:nvPr/>
        </p:nvSpPr>
        <p:spPr>
          <a:xfrm>
            <a:off x="6535800" y="262260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TextBox 278"/>
          <p:cNvSpPr/>
          <p:nvPr/>
        </p:nvSpPr>
        <p:spPr>
          <a:xfrm>
            <a:off x="6540480" y="335268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5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TextBox 279"/>
          <p:cNvSpPr/>
          <p:nvPr/>
        </p:nvSpPr>
        <p:spPr>
          <a:xfrm>
            <a:off x="5799240" y="396252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6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TextBox 280"/>
          <p:cNvSpPr/>
          <p:nvPr/>
        </p:nvSpPr>
        <p:spPr>
          <a:xfrm>
            <a:off x="3735360" y="412272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8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TextBox 281"/>
          <p:cNvSpPr/>
          <p:nvPr/>
        </p:nvSpPr>
        <p:spPr>
          <a:xfrm>
            <a:off x="1017720" y="3191040"/>
            <a:ext cx="347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0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TextBox 282"/>
          <p:cNvSpPr/>
          <p:nvPr/>
        </p:nvSpPr>
        <p:spPr>
          <a:xfrm>
            <a:off x="1766880" y="183996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TextBox 283"/>
          <p:cNvSpPr/>
          <p:nvPr/>
        </p:nvSpPr>
        <p:spPr>
          <a:xfrm>
            <a:off x="3878280" y="93996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04" name="组合 15"/>
          <p:cNvGrpSpPr/>
          <p:nvPr/>
        </p:nvGrpSpPr>
        <p:grpSpPr>
          <a:xfrm>
            <a:off x="422280" y="7534440"/>
            <a:ext cx="985680" cy="1738080"/>
            <a:chOff x="422280" y="7534440"/>
            <a:chExt cx="985680" cy="1738080"/>
          </a:xfrm>
        </p:grpSpPr>
        <p:grpSp>
          <p:nvGrpSpPr>
            <p:cNvPr id="305" name="组合 12"/>
            <p:cNvGrpSpPr/>
            <p:nvPr/>
          </p:nvGrpSpPr>
          <p:grpSpPr>
            <a:xfrm>
              <a:off x="422280" y="7534440"/>
              <a:ext cx="938160" cy="96840"/>
              <a:chOff x="422280" y="7534440"/>
              <a:chExt cx="938160" cy="96840"/>
            </a:xfrm>
          </p:grpSpPr>
          <p:sp>
            <p:nvSpPr>
              <p:cNvPr id="306" name="矩形 104"/>
              <p:cNvSpPr/>
              <p:nvPr/>
            </p:nvSpPr>
            <p:spPr>
              <a:xfrm>
                <a:off x="422280" y="7534440"/>
                <a:ext cx="150840" cy="96840"/>
              </a:xfrm>
              <a:prstGeom prst="rect">
                <a:avLst/>
              </a:prstGeom>
              <a:noFill/>
              <a:ln w="12600">
                <a:solidFill>
                  <a:srgbClr val="948a54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7" name="矩形 105"/>
              <p:cNvSpPr/>
              <p:nvPr/>
            </p:nvSpPr>
            <p:spPr>
              <a:xfrm>
                <a:off x="574560" y="7534440"/>
                <a:ext cx="161640" cy="96840"/>
              </a:xfrm>
              <a:prstGeom prst="rect">
                <a:avLst/>
              </a:prstGeom>
              <a:noFill/>
              <a:ln w="12600">
                <a:solidFill>
                  <a:srgbClr val="948a54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8" name="矩形 106"/>
              <p:cNvSpPr/>
              <p:nvPr/>
            </p:nvSpPr>
            <p:spPr>
              <a:xfrm>
                <a:off x="743040" y="7534440"/>
                <a:ext cx="150840" cy="96840"/>
              </a:xfrm>
              <a:prstGeom prst="rect">
                <a:avLst/>
              </a:prstGeom>
              <a:noFill/>
              <a:ln w="12600">
                <a:solidFill>
                  <a:srgbClr val="948a54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矩形 107"/>
              <p:cNvSpPr/>
              <p:nvPr/>
            </p:nvSpPr>
            <p:spPr>
              <a:xfrm>
                <a:off x="901800" y="7534440"/>
                <a:ext cx="150840" cy="96840"/>
              </a:xfrm>
              <a:prstGeom prst="rect">
                <a:avLst/>
              </a:prstGeom>
              <a:noFill/>
              <a:ln w="12600">
                <a:solidFill>
                  <a:srgbClr val="948a54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0" name="矩形 109"/>
              <p:cNvSpPr/>
              <p:nvPr/>
            </p:nvSpPr>
            <p:spPr>
              <a:xfrm>
                <a:off x="1209600" y="7534440"/>
                <a:ext cx="150840" cy="96840"/>
              </a:xfrm>
              <a:prstGeom prst="rect">
                <a:avLst/>
              </a:prstGeom>
              <a:noFill/>
              <a:ln w="12600">
                <a:solidFill>
                  <a:srgbClr val="948a54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1" name="TextBox 14"/>
            <p:cNvSpPr/>
            <p:nvPr/>
          </p:nvSpPr>
          <p:spPr>
            <a:xfrm rot="5400000">
              <a:off x="-256320" y="8362800"/>
              <a:ext cx="158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sc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AF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TextBox 145"/>
            <p:cNvSpPr/>
            <p:nvPr/>
          </p:nvSpPr>
          <p:spPr>
            <a:xfrm rot="5400000">
              <a:off x="-103680" y="8372160"/>
              <a:ext cx="158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sc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AF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TextBox 146"/>
            <p:cNvSpPr/>
            <p:nvPr/>
          </p:nvSpPr>
          <p:spPr>
            <a:xfrm rot="5400000">
              <a:off x="48240" y="8372160"/>
              <a:ext cx="158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sc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AF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TextBox 147"/>
            <p:cNvSpPr/>
            <p:nvPr/>
          </p:nvSpPr>
          <p:spPr>
            <a:xfrm rot="5400000">
              <a:off x="200520" y="8372160"/>
              <a:ext cx="158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AF2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TextBox 148"/>
            <p:cNvSpPr/>
            <p:nvPr/>
          </p:nvSpPr>
          <p:spPr>
            <a:xfrm rot="5400000">
              <a:off x="343800" y="8362800"/>
              <a:ext cx="158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AF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TextBox 149"/>
            <p:cNvSpPr/>
            <p:nvPr/>
          </p:nvSpPr>
          <p:spPr>
            <a:xfrm rot="5400000">
              <a:off x="507600" y="8362800"/>
              <a:ext cx="15847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WT</a:t>
              </a:r>
              <a:r>
                <a:rPr b="1" i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DAF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7" name="TextBox 1"/>
          <p:cNvSpPr/>
          <p:nvPr/>
        </p:nvSpPr>
        <p:spPr>
          <a:xfrm>
            <a:off x="54000" y="330120"/>
            <a:ext cx="4856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A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318" name="Picture 84" descr="F:\油料所工作\bar.tif"/>
          <p:cNvPicPr/>
          <p:nvPr/>
        </p:nvPicPr>
        <p:blipFill>
          <a:blip r:embed="rId13"/>
          <a:srcRect l="0" t="0" r="41333" b="0"/>
          <a:stretch/>
        </p:blipFill>
        <p:spPr>
          <a:xfrm>
            <a:off x="1525680" y="7545240"/>
            <a:ext cx="95040" cy="900360"/>
          </a:xfrm>
          <a:prstGeom prst="rect">
            <a:avLst/>
          </a:prstGeom>
          <a:ln w="0">
            <a:noFill/>
          </a:ln>
        </p:spPr>
      </p:pic>
      <p:sp>
        <p:nvSpPr>
          <p:cNvPr id="319" name="TextBox 192"/>
          <p:cNvSpPr/>
          <p:nvPr/>
        </p:nvSpPr>
        <p:spPr>
          <a:xfrm>
            <a:off x="1647720" y="7577280"/>
            <a:ext cx="382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ax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TextBox 195"/>
          <p:cNvSpPr/>
          <p:nvPr/>
        </p:nvSpPr>
        <p:spPr>
          <a:xfrm>
            <a:off x="1654200" y="8218440"/>
            <a:ext cx="380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i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TextBox 370"/>
          <p:cNvSpPr/>
          <p:nvPr/>
        </p:nvSpPr>
        <p:spPr>
          <a:xfrm>
            <a:off x="1441440" y="88416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文本框 327"/>
          <p:cNvSpPr/>
          <p:nvPr/>
        </p:nvSpPr>
        <p:spPr>
          <a:xfrm>
            <a:off x="4479840" y="4352760"/>
            <a:ext cx="11271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1,3-bisphosphoglycer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文本框 327"/>
          <p:cNvSpPr/>
          <p:nvPr/>
        </p:nvSpPr>
        <p:spPr>
          <a:xfrm>
            <a:off x="3249720" y="4622760"/>
            <a:ext cx="890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3-phosphoglycer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文本框 327"/>
          <p:cNvSpPr/>
          <p:nvPr/>
        </p:nvSpPr>
        <p:spPr>
          <a:xfrm>
            <a:off x="2392200" y="4462560"/>
            <a:ext cx="11271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2-phosphoglycer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文本框 327"/>
          <p:cNvSpPr/>
          <p:nvPr/>
        </p:nvSpPr>
        <p:spPr>
          <a:xfrm>
            <a:off x="1765440" y="3668760"/>
            <a:ext cx="11271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phosphoenolpyruv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文本框 327"/>
          <p:cNvSpPr/>
          <p:nvPr/>
        </p:nvSpPr>
        <p:spPr>
          <a:xfrm>
            <a:off x="1035000" y="1495440"/>
            <a:ext cx="11271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pyruv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文本框 327"/>
          <p:cNvSpPr/>
          <p:nvPr/>
        </p:nvSpPr>
        <p:spPr>
          <a:xfrm>
            <a:off x="566640" y="2763720"/>
            <a:ext cx="11271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enolpyruv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文本框 327"/>
          <p:cNvSpPr/>
          <p:nvPr/>
        </p:nvSpPr>
        <p:spPr>
          <a:xfrm>
            <a:off x="2022480" y="852480"/>
            <a:ext cx="11271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lact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文本框 327"/>
          <p:cNvSpPr/>
          <p:nvPr/>
        </p:nvSpPr>
        <p:spPr>
          <a:xfrm>
            <a:off x="2820960" y="1281240"/>
            <a:ext cx="500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alcoho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文本框 327"/>
          <p:cNvSpPr/>
          <p:nvPr/>
        </p:nvSpPr>
        <p:spPr>
          <a:xfrm>
            <a:off x="2693880" y="566640"/>
            <a:ext cx="484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glucos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文本框 327"/>
          <p:cNvSpPr/>
          <p:nvPr/>
        </p:nvSpPr>
        <p:spPr>
          <a:xfrm>
            <a:off x="3970440" y="665280"/>
            <a:ext cx="1071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glucose- 6-phosph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文本框 327"/>
          <p:cNvSpPr/>
          <p:nvPr/>
        </p:nvSpPr>
        <p:spPr>
          <a:xfrm>
            <a:off x="4535640" y="1255680"/>
            <a:ext cx="1071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fructose- 6-phosph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文本框 327"/>
          <p:cNvSpPr/>
          <p:nvPr/>
        </p:nvSpPr>
        <p:spPr>
          <a:xfrm>
            <a:off x="5678640" y="2281320"/>
            <a:ext cx="1071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fructose- 1,6-biphosph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文本框 327"/>
          <p:cNvSpPr/>
          <p:nvPr/>
        </p:nvSpPr>
        <p:spPr>
          <a:xfrm>
            <a:off x="4964040" y="3495600"/>
            <a:ext cx="13575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Dihydroxyacetone phosph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文本框 327"/>
          <p:cNvSpPr/>
          <p:nvPr/>
        </p:nvSpPr>
        <p:spPr>
          <a:xfrm>
            <a:off x="5578560" y="3041640"/>
            <a:ext cx="1357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Glyceraldehyde-3-phosph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36" name="组合 32"/>
          <p:cNvGrpSpPr/>
          <p:nvPr/>
        </p:nvGrpSpPr>
        <p:grpSpPr>
          <a:xfrm>
            <a:off x="3348360" y="4862520"/>
            <a:ext cx="1074240" cy="801000"/>
            <a:chOff x="3348360" y="4862520"/>
            <a:chExt cx="1074240" cy="801000"/>
          </a:xfrm>
        </p:grpSpPr>
        <p:grpSp>
          <p:nvGrpSpPr>
            <p:cNvPr id="337" name="组合 268"/>
            <p:cNvGrpSpPr/>
            <p:nvPr/>
          </p:nvGrpSpPr>
          <p:grpSpPr>
            <a:xfrm>
              <a:off x="3462120" y="5013000"/>
              <a:ext cx="960480" cy="650520"/>
              <a:chOff x="3462120" y="5013000"/>
              <a:chExt cx="960480" cy="650520"/>
            </a:xfrm>
          </p:grpSpPr>
          <p:grpSp>
            <p:nvGrpSpPr>
              <p:cNvPr id="338" name="组合 182"/>
              <p:cNvGrpSpPr/>
              <p:nvPr/>
            </p:nvGrpSpPr>
            <p:grpSpPr>
              <a:xfrm>
                <a:off x="3462120" y="5016960"/>
                <a:ext cx="960480" cy="646560"/>
                <a:chOff x="3462120" y="5016960"/>
                <a:chExt cx="960480" cy="646560"/>
              </a:xfrm>
            </p:grpSpPr>
            <p:sp>
              <p:nvSpPr>
                <p:cNvPr id="339" name="TextBox 340"/>
                <p:cNvSpPr/>
                <p:nvPr/>
              </p:nvSpPr>
              <p:spPr>
                <a:xfrm>
                  <a:off x="3555720" y="5282640"/>
                  <a:ext cx="411120" cy="380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0" name="TextBox 316"/>
                <p:cNvSpPr/>
                <p:nvPr/>
              </p:nvSpPr>
              <p:spPr>
                <a:xfrm>
                  <a:off x="3462120" y="5152680"/>
                  <a:ext cx="9604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1" name="TextBox 342"/>
                <p:cNvSpPr/>
                <p:nvPr/>
              </p:nvSpPr>
              <p:spPr>
                <a:xfrm>
                  <a:off x="3576600" y="5016960"/>
                  <a:ext cx="411120" cy="1605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42" name="直接连接符 343"/>
                <p:cNvSpPr/>
                <p:nvPr/>
              </p:nvSpPr>
              <p:spPr>
                <a:xfrm flipH="1">
                  <a:off x="3668400" y="5142600"/>
                  <a:ext cx="144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43" name="矩形 335"/>
              <p:cNvSpPr/>
              <p:nvPr/>
            </p:nvSpPr>
            <p:spPr>
              <a:xfrm>
                <a:off x="3562200" y="5013000"/>
                <a:ext cx="338040" cy="19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44" name="组合 21"/>
            <p:cNvGrpSpPr/>
            <p:nvPr/>
          </p:nvGrpSpPr>
          <p:grpSpPr>
            <a:xfrm>
              <a:off x="3348360" y="4862520"/>
              <a:ext cx="735120" cy="749160"/>
              <a:chOff x="3348360" y="4862520"/>
              <a:chExt cx="735120" cy="749160"/>
            </a:xfrm>
          </p:grpSpPr>
          <p:sp>
            <p:nvSpPr>
              <p:cNvPr id="345" name="矩形 9"/>
              <p:cNvSpPr/>
              <p:nvPr/>
            </p:nvSpPr>
            <p:spPr>
              <a:xfrm>
                <a:off x="3698280" y="515556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6" name="矩形 5"/>
              <p:cNvSpPr/>
              <p:nvPr/>
            </p:nvSpPr>
            <p:spPr>
              <a:xfrm>
                <a:off x="3559680" y="486252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直接连接符 320"/>
              <p:cNvSpPr/>
              <p:nvPr/>
            </p:nvSpPr>
            <p:spPr>
              <a:xfrm>
                <a:off x="3664080" y="5273640"/>
                <a:ext cx="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8" name="直接连接符 2"/>
              <p:cNvSpPr/>
              <p:nvPr/>
            </p:nvSpPr>
            <p:spPr>
              <a:xfrm flipH="1">
                <a:off x="3660480" y="49910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9" name="直接连接符 4"/>
              <p:cNvSpPr/>
              <p:nvPr/>
            </p:nvSpPr>
            <p:spPr>
              <a:xfrm flipH="1">
                <a:off x="3660480" y="5408640"/>
                <a:ext cx="144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0" name="矩形 6"/>
              <p:cNvSpPr/>
              <p:nvPr/>
            </p:nvSpPr>
            <p:spPr>
              <a:xfrm>
                <a:off x="3559680" y="542628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直接连接符 329"/>
              <p:cNvSpPr/>
              <p:nvPr/>
            </p:nvSpPr>
            <p:spPr>
              <a:xfrm>
                <a:off x="3702240" y="5245200"/>
                <a:ext cx="6804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2" name="直接连接符 330"/>
              <p:cNvSpPr/>
              <p:nvPr/>
            </p:nvSpPr>
            <p:spPr>
              <a:xfrm>
                <a:off x="3565440" y="5243760"/>
                <a:ext cx="66600" cy="1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720" bIns="-457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3" name="矩形 11"/>
              <p:cNvSpPr/>
              <p:nvPr/>
            </p:nvSpPr>
            <p:spPr>
              <a:xfrm>
                <a:off x="3348360" y="5151960"/>
                <a:ext cx="2995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O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54" name="弧形 345"/>
          <p:cNvSpPr/>
          <p:nvPr/>
        </p:nvSpPr>
        <p:spPr>
          <a:xfrm>
            <a:off x="3629160" y="5389560"/>
            <a:ext cx="819000" cy="428760"/>
          </a:xfrm>
          <a:custGeom>
            <a:avLst/>
            <a:gdLst/>
            <a:ahLst/>
            <a:rect l="l" t="t" r="r" b="b"/>
            <a:pathLst>
              <a:path stroke="0" w="819150" h="428625">
                <a:moveTo>
                  <a:pt x="409575" y="0"/>
                </a:moveTo>
                <a:cubicBezTo>
                  <a:pt x="635777" y="0"/>
                  <a:pt x="819150" y="95951"/>
                  <a:pt x="819150" y="214313"/>
                </a:cubicBezTo>
                <a:lnTo>
                  <a:pt x="409575" y="214313"/>
                </a:lnTo>
                <a:lnTo>
                  <a:pt x="409575" y="0"/>
                </a:lnTo>
                <a:close/>
              </a:path>
              <a:path fill="none" w="819150" h="428625">
                <a:moveTo>
                  <a:pt x="409575" y="0"/>
                </a:moveTo>
                <a:cubicBezTo>
                  <a:pt x="635777" y="0"/>
                  <a:pt x="819150" y="95951"/>
                  <a:pt x="819150" y="21431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55" name="组合 33"/>
          <p:cNvGrpSpPr/>
          <p:nvPr/>
        </p:nvGrpSpPr>
        <p:grpSpPr>
          <a:xfrm>
            <a:off x="4434480" y="5249880"/>
            <a:ext cx="1013760" cy="748440"/>
            <a:chOff x="4434480" y="5249880"/>
            <a:chExt cx="1013760" cy="748440"/>
          </a:xfrm>
        </p:grpSpPr>
        <p:grpSp>
          <p:nvGrpSpPr>
            <p:cNvPr id="356" name="组合 268"/>
            <p:cNvGrpSpPr/>
            <p:nvPr/>
          </p:nvGrpSpPr>
          <p:grpSpPr>
            <a:xfrm>
              <a:off x="4487400" y="5398200"/>
              <a:ext cx="960840" cy="554400"/>
              <a:chOff x="4487400" y="5398200"/>
              <a:chExt cx="960840" cy="554400"/>
            </a:xfrm>
          </p:grpSpPr>
          <p:grpSp>
            <p:nvGrpSpPr>
              <p:cNvPr id="357" name="组合 182"/>
              <p:cNvGrpSpPr/>
              <p:nvPr/>
            </p:nvGrpSpPr>
            <p:grpSpPr>
              <a:xfrm>
                <a:off x="4487400" y="5403600"/>
                <a:ext cx="960840" cy="549000"/>
                <a:chOff x="4487400" y="5403600"/>
                <a:chExt cx="960840" cy="549000"/>
              </a:xfrm>
            </p:grpSpPr>
            <p:sp>
              <p:nvSpPr>
                <p:cNvPr id="358" name="TextBox 315"/>
                <p:cNvSpPr/>
                <p:nvPr/>
              </p:nvSpPr>
              <p:spPr>
                <a:xfrm>
                  <a:off x="4576320" y="5675760"/>
                  <a:ext cx="411120" cy="2768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59" name="TextBox 316"/>
                <p:cNvSpPr/>
                <p:nvPr/>
              </p:nvSpPr>
              <p:spPr>
                <a:xfrm>
                  <a:off x="4487400" y="5528520"/>
                  <a:ext cx="9608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0" name="TextBox 317"/>
                <p:cNvSpPr/>
                <p:nvPr/>
              </p:nvSpPr>
              <p:spPr>
                <a:xfrm>
                  <a:off x="4593960" y="5403600"/>
                  <a:ext cx="411120" cy="1641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1" name="直接连接符 367"/>
                <p:cNvSpPr/>
                <p:nvPr/>
              </p:nvSpPr>
              <p:spPr>
                <a:xfrm flipH="1">
                  <a:off x="4684320" y="5526000"/>
                  <a:ext cx="1440" cy="673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520" bIns="20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62" name="矩形 363"/>
              <p:cNvSpPr/>
              <p:nvPr/>
            </p:nvSpPr>
            <p:spPr>
              <a:xfrm>
                <a:off x="4578120" y="5398200"/>
                <a:ext cx="338040" cy="19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63" name="组合 41"/>
            <p:cNvGrpSpPr/>
            <p:nvPr/>
          </p:nvGrpSpPr>
          <p:grpSpPr>
            <a:xfrm>
              <a:off x="4434480" y="5249880"/>
              <a:ext cx="694440" cy="748440"/>
              <a:chOff x="4434480" y="5249880"/>
              <a:chExt cx="694440" cy="748440"/>
            </a:xfrm>
          </p:grpSpPr>
          <p:sp>
            <p:nvSpPr>
              <p:cNvPr id="364" name="矩形 42"/>
              <p:cNvSpPr/>
              <p:nvPr/>
            </p:nvSpPr>
            <p:spPr>
              <a:xfrm>
                <a:off x="4743720" y="555732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5" name="矩形 43"/>
              <p:cNvSpPr/>
              <p:nvPr/>
            </p:nvSpPr>
            <p:spPr>
              <a:xfrm>
                <a:off x="4577040" y="524988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直接连接符 353"/>
              <p:cNvSpPr/>
              <p:nvPr/>
            </p:nvSpPr>
            <p:spPr>
              <a:xfrm flipH="1">
                <a:off x="4685760" y="5661000"/>
                <a:ext cx="108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直接连接符 354"/>
              <p:cNvSpPr/>
              <p:nvPr/>
            </p:nvSpPr>
            <p:spPr>
              <a:xfrm flipH="1">
                <a:off x="4683960" y="5380200"/>
                <a:ext cx="108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8" name="直接连接符 356"/>
              <p:cNvSpPr/>
              <p:nvPr/>
            </p:nvSpPr>
            <p:spPr>
              <a:xfrm flipH="1">
                <a:off x="4683960" y="5797800"/>
                <a:ext cx="108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9" name="矩形 47"/>
              <p:cNvSpPr/>
              <p:nvPr/>
            </p:nvSpPr>
            <p:spPr>
              <a:xfrm>
                <a:off x="4572000" y="581292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0" name="直接连接符 359"/>
              <p:cNvSpPr/>
              <p:nvPr/>
            </p:nvSpPr>
            <p:spPr>
              <a:xfrm>
                <a:off x="4725720" y="5634000"/>
                <a:ext cx="66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直接连接符 360"/>
              <p:cNvSpPr/>
              <p:nvPr/>
            </p:nvSpPr>
            <p:spPr>
              <a:xfrm>
                <a:off x="4587480" y="5632560"/>
                <a:ext cx="680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2" name="矩形 50"/>
              <p:cNvSpPr/>
              <p:nvPr/>
            </p:nvSpPr>
            <p:spPr>
              <a:xfrm>
                <a:off x="4434480" y="5539680"/>
                <a:ext cx="24012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73" name="直接连接符 368"/>
          <p:cNvSpPr/>
          <p:nvPr/>
        </p:nvSpPr>
        <p:spPr>
          <a:xfrm flipH="1">
            <a:off x="4708080" y="5667480"/>
            <a:ext cx="1800" cy="680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1240" bIns="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弧形 369"/>
          <p:cNvSpPr/>
          <p:nvPr/>
        </p:nvSpPr>
        <p:spPr>
          <a:xfrm>
            <a:off x="4614840" y="6033960"/>
            <a:ext cx="720720" cy="816120"/>
          </a:xfrm>
          <a:custGeom>
            <a:avLst/>
            <a:gdLst/>
            <a:ahLst/>
            <a:rect l="l" t="t" r="r" b="b"/>
            <a:pathLst>
              <a:path stroke="0" w="720725" h="815975">
                <a:moveTo>
                  <a:pt x="360362" y="0"/>
                </a:moveTo>
                <a:cubicBezTo>
                  <a:pt x="559385" y="0"/>
                  <a:pt x="720725" y="182662"/>
                  <a:pt x="720725" y="407988"/>
                </a:cubicBezTo>
                <a:lnTo>
                  <a:pt x="360363" y="407988"/>
                </a:lnTo>
                <a:cubicBezTo>
                  <a:pt x="360363" y="271992"/>
                  <a:pt x="360362" y="135996"/>
                  <a:pt x="360362" y="0"/>
                </a:cubicBezTo>
                <a:close/>
              </a:path>
              <a:path fill="none" w="720725" h="815975">
                <a:moveTo>
                  <a:pt x="360362" y="0"/>
                </a:moveTo>
                <a:cubicBezTo>
                  <a:pt x="559385" y="0"/>
                  <a:pt x="720725" y="182662"/>
                  <a:pt x="720725" y="407988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5" name="组合 73"/>
          <p:cNvGrpSpPr/>
          <p:nvPr/>
        </p:nvGrpSpPr>
        <p:grpSpPr>
          <a:xfrm>
            <a:off x="5064480" y="6480000"/>
            <a:ext cx="1052280" cy="794880"/>
            <a:chOff x="5064480" y="6480000"/>
            <a:chExt cx="1052280" cy="794880"/>
          </a:xfrm>
        </p:grpSpPr>
        <p:grpSp>
          <p:nvGrpSpPr>
            <p:cNvPr id="376" name="组合 52"/>
            <p:cNvGrpSpPr/>
            <p:nvPr/>
          </p:nvGrpSpPr>
          <p:grpSpPr>
            <a:xfrm>
              <a:off x="5064480" y="6480000"/>
              <a:ext cx="1052280" cy="794880"/>
              <a:chOff x="5064480" y="6480000"/>
              <a:chExt cx="1052280" cy="794880"/>
            </a:xfrm>
          </p:grpSpPr>
          <p:grpSp>
            <p:nvGrpSpPr>
              <p:cNvPr id="377" name="组合 268"/>
              <p:cNvGrpSpPr/>
              <p:nvPr/>
            </p:nvGrpSpPr>
            <p:grpSpPr>
              <a:xfrm>
                <a:off x="5154480" y="6620760"/>
                <a:ext cx="962280" cy="654120"/>
                <a:chOff x="5154480" y="6620760"/>
                <a:chExt cx="962280" cy="654120"/>
              </a:xfrm>
            </p:grpSpPr>
            <p:grpSp>
              <p:nvGrpSpPr>
                <p:cNvPr id="378" name="组合 182"/>
                <p:cNvGrpSpPr/>
                <p:nvPr/>
              </p:nvGrpSpPr>
              <p:grpSpPr>
                <a:xfrm>
                  <a:off x="5154480" y="6635520"/>
                  <a:ext cx="962280" cy="639360"/>
                  <a:chOff x="5154480" y="6635520"/>
                  <a:chExt cx="962280" cy="639360"/>
                </a:xfrm>
              </p:grpSpPr>
              <p:sp>
                <p:nvSpPr>
                  <p:cNvPr id="379" name="TextBox 315"/>
                  <p:cNvSpPr/>
                  <p:nvPr/>
                </p:nvSpPr>
                <p:spPr>
                  <a:xfrm>
                    <a:off x="5248080" y="6894000"/>
                    <a:ext cx="411120" cy="380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H</a:t>
                    </a:r>
                    <a:r>
                      <a:rPr b="1" lang="en-US" sz="600" spc="-1" strike="noStrike" baseline="-250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TextBox 316"/>
                  <p:cNvSpPr/>
                  <p:nvPr/>
                </p:nvSpPr>
                <p:spPr>
                  <a:xfrm>
                    <a:off x="5154480" y="6759720"/>
                    <a:ext cx="96228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 </a:t>
                    </a: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1" name="TextBox 317"/>
                  <p:cNvSpPr/>
                  <p:nvPr/>
                </p:nvSpPr>
                <p:spPr>
                  <a:xfrm>
                    <a:off x="5265720" y="6635520"/>
                    <a:ext cx="411120" cy="157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2" name="直接连接符 390"/>
                  <p:cNvSpPr/>
                  <p:nvPr/>
                </p:nvSpPr>
                <p:spPr>
                  <a:xfrm flipH="1">
                    <a:off x="5356080" y="6757560"/>
                    <a:ext cx="1440" cy="6732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0520" bIns="20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83" name="矩形 386"/>
                <p:cNvSpPr/>
                <p:nvPr/>
              </p:nvSpPr>
              <p:spPr>
                <a:xfrm>
                  <a:off x="5244840" y="6620760"/>
                  <a:ext cx="338040" cy="198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84" name="组合 60"/>
              <p:cNvGrpSpPr/>
              <p:nvPr/>
            </p:nvGrpSpPr>
            <p:grpSpPr>
              <a:xfrm>
                <a:off x="5064480" y="6480000"/>
                <a:ext cx="711720" cy="748080"/>
                <a:chOff x="5064480" y="6480000"/>
                <a:chExt cx="711720" cy="748080"/>
              </a:xfrm>
            </p:grpSpPr>
            <p:sp>
              <p:nvSpPr>
                <p:cNvPr id="385" name="矩形 61"/>
                <p:cNvSpPr/>
                <p:nvPr/>
              </p:nvSpPr>
              <p:spPr>
                <a:xfrm>
                  <a:off x="5391000" y="6772320"/>
                  <a:ext cx="385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O</a:t>
                  </a:r>
                  <a:r>
                    <a:rPr b="1" lang="en-US" sz="600" spc="-1" strike="noStrike" baseline="30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-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矩形 62"/>
                <p:cNvSpPr/>
                <p:nvPr/>
              </p:nvSpPr>
              <p:spPr>
                <a:xfrm>
                  <a:off x="5243040" y="6480000"/>
                  <a:ext cx="385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O</a:t>
                  </a:r>
                  <a:r>
                    <a:rPr b="1" lang="en-US" sz="600" spc="-1" strike="noStrike" baseline="30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-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直接连接符 378"/>
                <p:cNvSpPr/>
                <p:nvPr/>
              </p:nvSpPr>
              <p:spPr>
                <a:xfrm>
                  <a:off x="5351400" y="6895800"/>
                  <a:ext cx="0" cy="684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600" bIns="21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直接连接符 379"/>
                <p:cNvSpPr/>
                <p:nvPr/>
              </p:nvSpPr>
              <p:spPr>
                <a:xfrm flipH="1">
                  <a:off x="5347800" y="6615000"/>
                  <a:ext cx="1080" cy="662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440" bIns="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直接连接符 380"/>
                <p:cNvSpPr/>
                <p:nvPr/>
              </p:nvSpPr>
              <p:spPr>
                <a:xfrm flipH="1">
                  <a:off x="5347800" y="7031520"/>
                  <a:ext cx="108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矩形 66"/>
                <p:cNvSpPr/>
                <p:nvPr/>
              </p:nvSpPr>
              <p:spPr>
                <a:xfrm>
                  <a:off x="5248080" y="7042680"/>
                  <a:ext cx="385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O</a:t>
                  </a:r>
                  <a:r>
                    <a:rPr b="1" lang="en-US" sz="600" spc="-1" strike="noStrike" baseline="30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-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直接连接符 382"/>
                <p:cNvSpPr/>
                <p:nvPr/>
              </p:nvSpPr>
              <p:spPr>
                <a:xfrm>
                  <a:off x="5391000" y="6867720"/>
                  <a:ext cx="6660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直接连接符 383"/>
                <p:cNvSpPr/>
                <p:nvPr/>
              </p:nvSpPr>
              <p:spPr>
                <a:xfrm>
                  <a:off x="5253480" y="6867720"/>
                  <a:ext cx="6804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矩形 69"/>
                <p:cNvSpPr/>
                <p:nvPr/>
              </p:nvSpPr>
              <p:spPr>
                <a:xfrm>
                  <a:off x="5064480" y="6902280"/>
                  <a:ext cx="29952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OH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394" name="直接连接符 372"/>
            <p:cNvSpPr/>
            <p:nvPr/>
          </p:nvSpPr>
          <p:spPr>
            <a:xfrm>
              <a:off x="5258160" y="6980400"/>
              <a:ext cx="68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文本框 72"/>
            <p:cNvSpPr/>
            <p:nvPr/>
          </p:nvSpPr>
          <p:spPr>
            <a:xfrm>
              <a:off x="5113080" y="6771960"/>
              <a:ext cx="169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396" name="组合 74"/>
          <p:cNvGrpSpPr/>
          <p:nvPr/>
        </p:nvGrpSpPr>
        <p:grpSpPr>
          <a:xfrm>
            <a:off x="4740120" y="7763040"/>
            <a:ext cx="998640" cy="780840"/>
            <a:chOff x="4740120" y="7763040"/>
            <a:chExt cx="998640" cy="780840"/>
          </a:xfrm>
        </p:grpSpPr>
        <p:grpSp>
          <p:nvGrpSpPr>
            <p:cNvPr id="397" name="组合 75"/>
            <p:cNvGrpSpPr/>
            <p:nvPr/>
          </p:nvGrpSpPr>
          <p:grpSpPr>
            <a:xfrm>
              <a:off x="4778640" y="7763040"/>
              <a:ext cx="960120" cy="780840"/>
              <a:chOff x="4778640" y="7763040"/>
              <a:chExt cx="960120" cy="780840"/>
            </a:xfrm>
          </p:grpSpPr>
          <p:grpSp>
            <p:nvGrpSpPr>
              <p:cNvPr id="398" name="组合 268"/>
              <p:cNvGrpSpPr/>
              <p:nvPr/>
            </p:nvGrpSpPr>
            <p:grpSpPr>
              <a:xfrm>
                <a:off x="4778640" y="7896960"/>
                <a:ext cx="960120" cy="646920"/>
                <a:chOff x="4778640" y="7896960"/>
                <a:chExt cx="960120" cy="646920"/>
              </a:xfrm>
            </p:grpSpPr>
            <p:grpSp>
              <p:nvGrpSpPr>
                <p:cNvPr id="399" name="组合 182"/>
                <p:cNvGrpSpPr/>
                <p:nvPr/>
              </p:nvGrpSpPr>
              <p:grpSpPr>
                <a:xfrm>
                  <a:off x="4778640" y="7896960"/>
                  <a:ext cx="960120" cy="646920"/>
                  <a:chOff x="4778640" y="7896960"/>
                  <a:chExt cx="960120" cy="646920"/>
                </a:xfrm>
              </p:grpSpPr>
              <p:sp>
                <p:nvSpPr>
                  <p:cNvPr id="400" name="TextBox 315"/>
                  <p:cNvSpPr/>
                  <p:nvPr/>
                </p:nvSpPr>
                <p:spPr>
                  <a:xfrm>
                    <a:off x="4862160" y="8163000"/>
                    <a:ext cx="411120" cy="380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=O</a:t>
                    </a:r>
                    <a:r>
                      <a:rPr b="1" lang="en-US" sz="600" spc="-1" strike="noStrike" baseline="-250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1" name="TextBox 316"/>
                  <p:cNvSpPr/>
                  <p:nvPr/>
                </p:nvSpPr>
                <p:spPr>
                  <a:xfrm>
                    <a:off x="4778640" y="8026920"/>
                    <a:ext cx="96012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 </a:t>
                    </a: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2" name="TextBox 317"/>
                  <p:cNvSpPr/>
                  <p:nvPr/>
                </p:nvSpPr>
                <p:spPr>
                  <a:xfrm>
                    <a:off x="4887720" y="7896960"/>
                    <a:ext cx="411120" cy="1598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3" name="直接连接符 409"/>
                  <p:cNvSpPr/>
                  <p:nvPr/>
                </p:nvSpPr>
                <p:spPr>
                  <a:xfrm flipH="1">
                    <a:off x="4979880" y="8021880"/>
                    <a:ext cx="1440" cy="662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440" bIns="194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04" name="矩形 405"/>
                <p:cNvSpPr/>
                <p:nvPr/>
              </p:nvSpPr>
              <p:spPr>
                <a:xfrm>
                  <a:off x="4890960" y="7903800"/>
                  <a:ext cx="338040" cy="198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05" name="组合 85"/>
              <p:cNvGrpSpPr/>
              <p:nvPr/>
            </p:nvGrpSpPr>
            <p:grpSpPr>
              <a:xfrm>
                <a:off x="4879800" y="7763040"/>
                <a:ext cx="527400" cy="749880"/>
                <a:chOff x="4879800" y="7763040"/>
                <a:chExt cx="527400" cy="749880"/>
              </a:xfrm>
            </p:grpSpPr>
            <p:sp>
              <p:nvSpPr>
                <p:cNvPr id="406" name="矩形 86"/>
                <p:cNvSpPr/>
                <p:nvPr/>
              </p:nvSpPr>
              <p:spPr>
                <a:xfrm>
                  <a:off x="5022000" y="8033040"/>
                  <a:ext cx="385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O</a:t>
                  </a:r>
                  <a:r>
                    <a:rPr b="1" lang="en-US" sz="600" spc="-1" strike="noStrike" baseline="30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-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矩形 87"/>
                <p:cNvSpPr/>
                <p:nvPr/>
              </p:nvSpPr>
              <p:spPr>
                <a:xfrm>
                  <a:off x="4892760" y="7763040"/>
                  <a:ext cx="385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O</a:t>
                  </a:r>
                  <a:r>
                    <a:rPr b="1" lang="en-US" sz="600" spc="-1" strike="noStrike" baseline="30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-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直接连接符 398"/>
                <p:cNvSpPr/>
                <p:nvPr/>
              </p:nvSpPr>
              <p:spPr>
                <a:xfrm>
                  <a:off x="4977720" y="8156520"/>
                  <a:ext cx="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直接连接符 399"/>
                <p:cNvSpPr/>
                <p:nvPr/>
              </p:nvSpPr>
              <p:spPr>
                <a:xfrm flipH="1">
                  <a:off x="4975920" y="7874280"/>
                  <a:ext cx="1080" cy="68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直接连接符 400"/>
                <p:cNvSpPr/>
                <p:nvPr/>
              </p:nvSpPr>
              <p:spPr>
                <a:xfrm flipH="1">
                  <a:off x="4975920" y="8291520"/>
                  <a:ext cx="108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矩形 92"/>
                <p:cNvSpPr/>
                <p:nvPr/>
              </p:nvSpPr>
              <p:spPr>
                <a:xfrm>
                  <a:off x="4897440" y="8327520"/>
                  <a:ext cx="385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O</a:t>
                  </a:r>
                  <a:r>
                    <a:rPr b="1" lang="en-US" sz="600" spc="-1" strike="noStrike" baseline="30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-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直接连接符 402"/>
                <p:cNvSpPr/>
                <p:nvPr/>
              </p:nvSpPr>
              <p:spPr>
                <a:xfrm>
                  <a:off x="5017680" y="8128080"/>
                  <a:ext cx="6660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直接连接符 403"/>
                <p:cNvSpPr/>
                <p:nvPr/>
              </p:nvSpPr>
              <p:spPr>
                <a:xfrm>
                  <a:off x="4879800" y="8126640"/>
                  <a:ext cx="67680" cy="10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414" name="文本框 98"/>
            <p:cNvSpPr/>
            <p:nvPr/>
          </p:nvSpPr>
          <p:spPr>
            <a:xfrm>
              <a:off x="4740120" y="8032680"/>
              <a:ext cx="169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15" name="弧形 410"/>
          <p:cNvSpPr/>
          <p:nvPr/>
        </p:nvSpPr>
        <p:spPr>
          <a:xfrm rot="4121400">
            <a:off x="4456080" y="6921360"/>
            <a:ext cx="996840" cy="797040"/>
          </a:xfrm>
          <a:custGeom>
            <a:avLst/>
            <a:gdLst/>
            <a:ahLst/>
            <a:rect l="l" t="t" r="r" b="b"/>
            <a:pathLst>
              <a:path stroke="0" w="996950" h="796925">
                <a:moveTo>
                  <a:pt x="498475" y="0"/>
                </a:moveTo>
                <a:cubicBezTo>
                  <a:pt x="773775" y="0"/>
                  <a:pt x="996950" y="178398"/>
                  <a:pt x="996950" y="398463"/>
                </a:cubicBezTo>
                <a:lnTo>
                  <a:pt x="498475" y="398463"/>
                </a:lnTo>
                <a:lnTo>
                  <a:pt x="498475" y="0"/>
                </a:lnTo>
                <a:close/>
              </a:path>
              <a:path fill="none" w="996950" h="796925">
                <a:moveTo>
                  <a:pt x="498475" y="0"/>
                </a:moveTo>
                <a:cubicBezTo>
                  <a:pt x="773775" y="0"/>
                  <a:pt x="996950" y="178398"/>
                  <a:pt x="996950" y="39846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弧形 411"/>
          <p:cNvSpPr/>
          <p:nvPr/>
        </p:nvSpPr>
        <p:spPr>
          <a:xfrm rot="4361400">
            <a:off x="4157280" y="7924680"/>
            <a:ext cx="492120" cy="939960"/>
          </a:xfrm>
          <a:custGeom>
            <a:avLst/>
            <a:gdLst/>
            <a:ahLst/>
            <a:rect l="l" t="t" r="r" b="b"/>
            <a:pathLst>
              <a:path stroke="0" w="492125" h="939800">
                <a:moveTo>
                  <a:pt x="246062" y="0"/>
                </a:moveTo>
                <a:cubicBezTo>
                  <a:pt x="381959" y="0"/>
                  <a:pt x="492125" y="210381"/>
                  <a:pt x="492125" y="469900"/>
                </a:cubicBezTo>
                <a:lnTo>
                  <a:pt x="246063" y="469900"/>
                </a:lnTo>
                <a:cubicBezTo>
                  <a:pt x="246063" y="313267"/>
                  <a:pt x="246062" y="156633"/>
                  <a:pt x="246062" y="0"/>
                </a:cubicBezTo>
                <a:close/>
              </a:path>
              <a:path fill="none" w="492125" h="939800">
                <a:moveTo>
                  <a:pt x="246062" y="0"/>
                </a:moveTo>
                <a:cubicBezTo>
                  <a:pt x="381959" y="0"/>
                  <a:pt x="492125" y="210381"/>
                  <a:pt x="492125" y="46990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7" name="组合 99"/>
          <p:cNvGrpSpPr/>
          <p:nvPr/>
        </p:nvGrpSpPr>
        <p:grpSpPr>
          <a:xfrm>
            <a:off x="4075200" y="8307360"/>
            <a:ext cx="1003320" cy="790920"/>
            <a:chOff x="4075200" y="8307360"/>
            <a:chExt cx="1003320" cy="790920"/>
          </a:xfrm>
        </p:grpSpPr>
        <p:sp>
          <p:nvSpPr>
            <p:cNvPr id="418" name="文本框 118"/>
            <p:cNvSpPr/>
            <p:nvPr/>
          </p:nvSpPr>
          <p:spPr>
            <a:xfrm>
              <a:off x="4075200" y="8589960"/>
              <a:ext cx="169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19" name="组合 100"/>
            <p:cNvGrpSpPr/>
            <p:nvPr/>
          </p:nvGrpSpPr>
          <p:grpSpPr>
            <a:xfrm>
              <a:off x="4118400" y="8307360"/>
              <a:ext cx="960120" cy="790920"/>
              <a:chOff x="4118400" y="8307360"/>
              <a:chExt cx="960120" cy="790920"/>
            </a:xfrm>
          </p:grpSpPr>
          <p:grpSp>
            <p:nvGrpSpPr>
              <p:cNvPr id="420" name="组合 268"/>
              <p:cNvGrpSpPr/>
              <p:nvPr/>
            </p:nvGrpSpPr>
            <p:grpSpPr>
              <a:xfrm>
                <a:off x="4118400" y="8443080"/>
                <a:ext cx="960120" cy="655200"/>
                <a:chOff x="4118400" y="8443080"/>
                <a:chExt cx="960120" cy="655200"/>
              </a:xfrm>
            </p:grpSpPr>
            <p:grpSp>
              <p:nvGrpSpPr>
                <p:cNvPr id="421" name="组合 182"/>
                <p:cNvGrpSpPr/>
                <p:nvPr/>
              </p:nvGrpSpPr>
              <p:grpSpPr>
                <a:xfrm>
                  <a:off x="4118400" y="8443080"/>
                  <a:ext cx="960120" cy="655200"/>
                  <a:chOff x="4118400" y="8443080"/>
                  <a:chExt cx="960120" cy="655200"/>
                </a:xfrm>
              </p:grpSpPr>
              <p:sp>
                <p:nvSpPr>
                  <p:cNvPr id="422" name="TextBox 315"/>
                  <p:cNvSpPr/>
                  <p:nvPr/>
                </p:nvSpPr>
                <p:spPr>
                  <a:xfrm>
                    <a:off x="4206600" y="8717400"/>
                    <a:ext cx="411120" cy="380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=O</a:t>
                    </a:r>
                    <a:r>
                      <a:rPr b="1" lang="en-US" sz="600" spc="-1" strike="noStrike" baseline="-250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3" name="TextBox 316"/>
                  <p:cNvSpPr/>
                  <p:nvPr/>
                </p:nvSpPr>
                <p:spPr>
                  <a:xfrm>
                    <a:off x="4118400" y="8591400"/>
                    <a:ext cx="960120" cy="1980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 </a:t>
                    </a: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H</a:t>
                    </a:r>
                    <a:r>
                      <a:rPr b="1" lang="en-US" sz="600" spc="-1" strike="noStrike" baseline="-250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4" name="TextBox 317"/>
                  <p:cNvSpPr/>
                  <p:nvPr/>
                </p:nvSpPr>
                <p:spPr>
                  <a:xfrm>
                    <a:off x="4209840" y="8443080"/>
                    <a:ext cx="411120" cy="1598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5" name="直接连接符 428"/>
                  <p:cNvSpPr/>
                  <p:nvPr/>
                </p:nvSpPr>
                <p:spPr>
                  <a:xfrm>
                    <a:off x="4302000" y="8568360"/>
                    <a:ext cx="0" cy="66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26" name="矩形 424"/>
                <p:cNvSpPr/>
                <p:nvPr/>
              </p:nvSpPr>
              <p:spPr>
                <a:xfrm>
                  <a:off x="4213080" y="8451360"/>
                  <a:ext cx="338040" cy="198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27" name="组合 108"/>
              <p:cNvGrpSpPr/>
              <p:nvPr/>
            </p:nvGrpSpPr>
            <p:grpSpPr>
              <a:xfrm>
                <a:off x="4200120" y="8307360"/>
                <a:ext cx="403920" cy="747720"/>
                <a:chOff x="4200120" y="8307360"/>
                <a:chExt cx="403920" cy="747720"/>
              </a:xfrm>
            </p:grpSpPr>
            <p:sp>
              <p:nvSpPr>
                <p:cNvPr id="428" name="矩形 110"/>
                <p:cNvSpPr/>
                <p:nvPr/>
              </p:nvSpPr>
              <p:spPr>
                <a:xfrm>
                  <a:off x="4213440" y="8307360"/>
                  <a:ext cx="385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O</a:t>
                  </a:r>
                  <a:r>
                    <a:rPr b="1" lang="en-US" sz="600" spc="-1" strike="noStrike" baseline="30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-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直接连接符 418"/>
                <p:cNvSpPr/>
                <p:nvPr/>
              </p:nvSpPr>
              <p:spPr>
                <a:xfrm>
                  <a:off x="4298760" y="8696880"/>
                  <a:ext cx="0" cy="676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0880" bIns="20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直接连接符 419"/>
                <p:cNvSpPr/>
                <p:nvPr/>
              </p:nvSpPr>
              <p:spPr>
                <a:xfrm flipH="1">
                  <a:off x="4296240" y="8418600"/>
                  <a:ext cx="108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直接连接符 420"/>
                <p:cNvSpPr/>
                <p:nvPr/>
              </p:nvSpPr>
              <p:spPr>
                <a:xfrm flipH="1">
                  <a:off x="4296240" y="8835480"/>
                  <a:ext cx="1080" cy="662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440" bIns="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矩形 114"/>
                <p:cNvSpPr/>
                <p:nvPr/>
              </p:nvSpPr>
              <p:spPr>
                <a:xfrm>
                  <a:off x="4218840" y="8869680"/>
                  <a:ext cx="385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O</a:t>
                  </a:r>
                  <a:r>
                    <a:rPr b="1" lang="en-US" sz="600" spc="-1" strike="noStrike" baseline="30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-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直接连接符 422"/>
                <p:cNvSpPr/>
                <p:nvPr/>
              </p:nvSpPr>
              <p:spPr>
                <a:xfrm>
                  <a:off x="4200120" y="8670240"/>
                  <a:ext cx="6804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434" name="弧形 429"/>
          <p:cNvSpPr/>
          <p:nvPr/>
        </p:nvSpPr>
        <p:spPr>
          <a:xfrm rot="6670800">
            <a:off x="3360960" y="8044560"/>
            <a:ext cx="439560" cy="917640"/>
          </a:xfrm>
          <a:custGeom>
            <a:avLst/>
            <a:gdLst/>
            <a:ahLst/>
            <a:rect l="l" t="t" r="r" b="b"/>
            <a:pathLst>
              <a:path stroke="0" w="439738" h="917575">
                <a:moveTo>
                  <a:pt x="219869" y="0"/>
                </a:moveTo>
                <a:cubicBezTo>
                  <a:pt x="341299" y="0"/>
                  <a:pt x="439738" y="205406"/>
                  <a:pt x="439738" y="458788"/>
                </a:cubicBezTo>
                <a:lnTo>
                  <a:pt x="219869" y="458788"/>
                </a:lnTo>
                <a:lnTo>
                  <a:pt x="219869" y="0"/>
                </a:lnTo>
                <a:close/>
              </a:path>
              <a:path fill="none" w="439738" h="917575">
                <a:moveTo>
                  <a:pt x="219869" y="0"/>
                </a:moveTo>
                <a:cubicBezTo>
                  <a:pt x="341299" y="0"/>
                  <a:pt x="439738" y="205406"/>
                  <a:pt x="439738" y="458788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5" name="组合 145"/>
          <p:cNvGrpSpPr/>
          <p:nvPr/>
        </p:nvGrpSpPr>
        <p:grpSpPr>
          <a:xfrm>
            <a:off x="2446200" y="8115480"/>
            <a:ext cx="960480" cy="804240"/>
            <a:chOff x="2446200" y="8115480"/>
            <a:chExt cx="960480" cy="804240"/>
          </a:xfrm>
        </p:grpSpPr>
        <p:grpSp>
          <p:nvGrpSpPr>
            <p:cNvPr id="436" name="组合 120"/>
            <p:cNvGrpSpPr/>
            <p:nvPr/>
          </p:nvGrpSpPr>
          <p:grpSpPr>
            <a:xfrm>
              <a:off x="2446200" y="8227800"/>
              <a:ext cx="960480" cy="691920"/>
              <a:chOff x="2446200" y="8227800"/>
              <a:chExt cx="960480" cy="691920"/>
            </a:xfrm>
          </p:grpSpPr>
          <p:grpSp>
            <p:nvGrpSpPr>
              <p:cNvPr id="437" name="组合 268"/>
              <p:cNvGrpSpPr/>
              <p:nvPr/>
            </p:nvGrpSpPr>
            <p:grpSpPr>
              <a:xfrm>
                <a:off x="2446200" y="8255880"/>
                <a:ext cx="960480" cy="663840"/>
                <a:chOff x="2446200" y="8255880"/>
                <a:chExt cx="960480" cy="663840"/>
              </a:xfrm>
            </p:grpSpPr>
            <p:grpSp>
              <p:nvGrpSpPr>
                <p:cNvPr id="438" name="组合 182"/>
                <p:cNvGrpSpPr/>
                <p:nvPr/>
              </p:nvGrpSpPr>
              <p:grpSpPr>
                <a:xfrm>
                  <a:off x="2446200" y="8255880"/>
                  <a:ext cx="960480" cy="663840"/>
                  <a:chOff x="2446200" y="8255880"/>
                  <a:chExt cx="960480" cy="663840"/>
                </a:xfrm>
              </p:grpSpPr>
              <p:sp>
                <p:nvSpPr>
                  <p:cNvPr id="439" name="TextBox 315"/>
                  <p:cNvSpPr/>
                  <p:nvPr/>
                </p:nvSpPr>
                <p:spPr>
                  <a:xfrm>
                    <a:off x="2541240" y="8538840"/>
                    <a:ext cx="411120" cy="380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 baseline="-250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0" name="TextBox 316"/>
                  <p:cNvSpPr/>
                  <p:nvPr/>
                </p:nvSpPr>
                <p:spPr>
                  <a:xfrm>
                    <a:off x="2446200" y="8404560"/>
                    <a:ext cx="960480" cy="1980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     </a:t>
                    </a: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H</a:t>
                    </a:r>
                    <a:r>
                      <a:rPr b="1" lang="en-US" sz="600" spc="-1" strike="noStrike" baseline="-250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2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1" name="TextBox 317"/>
                  <p:cNvSpPr/>
                  <p:nvPr/>
                </p:nvSpPr>
                <p:spPr>
                  <a:xfrm>
                    <a:off x="2538000" y="8255880"/>
                    <a:ext cx="411120" cy="16056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2" name="直接连接符 443"/>
                  <p:cNvSpPr/>
                  <p:nvPr/>
                </p:nvSpPr>
                <p:spPr>
                  <a:xfrm>
                    <a:off x="2630160" y="8381160"/>
                    <a:ext cx="0" cy="66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43" name="矩形 439"/>
                <p:cNvSpPr/>
                <p:nvPr/>
              </p:nvSpPr>
              <p:spPr>
                <a:xfrm>
                  <a:off x="2541240" y="8262720"/>
                  <a:ext cx="338040" cy="198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44" name="组合 128"/>
              <p:cNvGrpSpPr/>
              <p:nvPr/>
            </p:nvGrpSpPr>
            <p:grpSpPr>
              <a:xfrm>
                <a:off x="2546280" y="8227800"/>
                <a:ext cx="385200" cy="514080"/>
                <a:chOff x="2546280" y="8227800"/>
                <a:chExt cx="385200" cy="514080"/>
              </a:xfrm>
            </p:grpSpPr>
            <p:sp>
              <p:nvSpPr>
                <p:cNvPr id="445" name="矩形 133"/>
                <p:cNvSpPr/>
                <p:nvPr/>
              </p:nvSpPr>
              <p:spPr>
                <a:xfrm>
                  <a:off x="2546280" y="8556480"/>
                  <a:ext cx="3852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OO</a:t>
                  </a:r>
                  <a:r>
                    <a:rPr b="1" lang="en-US" sz="600" spc="-1" strike="noStrike" baseline="30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-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直接连接符 436"/>
                <p:cNvSpPr/>
                <p:nvPr/>
              </p:nvSpPr>
              <p:spPr>
                <a:xfrm>
                  <a:off x="2624040" y="8227800"/>
                  <a:ext cx="0" cy="68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直接连接符 437"/>
                <p:cNvSpPr/>
                <p:nvPr/>
              </p:nvSpPr>
              <p:spPr>
                <a:xfrm>
                  <a:off x="2624040" y="8523000"/>
                  <a:ext cx="0" cy="68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448" name="矩形 144"/>
            <p:cNvSpPr/>
            <p:nvPr/>
          </p:nvSpPr>
          <p:spPr>
            <a:xfrm>
              <a:off x="2545560" y="8115480"/>
              <a:ext cx="3852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O</a:t>
              </a:r>
              <a:r>
                <a:rPr b="1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--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49" name="弧形 444"/>
          <p:cNvSpPr/>
          <p:nvPr/>
        </p:nvSpPr>
        <p:spPr>
          <a:xfrm rot="10165800">
            <a:off x="2123640" y="7351200"/>
            <a:ext cx="735120" cy="939960"/>
          </a:xfrm>
          <a:custGeom>
            <a:avLst/>
            <a:gdLst/>
            <a:ahLst/>
            <a:rect l="l" t="t" r="r" b="b"/>
            <a:pathLst>
              <a:path stroke="0" w="735013" h="939800">
                <a:moveTo>
                  <a:pt x="367506" y="0"/>
                </a:moveTo>
                <a:cubicBezTo>
                  <a:pt x="570475" y="0"/>
                  <a:pt x="735013" y="210381"/>
                  <a:pt x="735013" y="469900"/>
                </a:cubicBezTo>
                <a:lnTo>
                  <a:pt x="367507" y="469900"/>
                </a:lnTo>
                <a:cubicBezTo>
                  <a:pt x="367507" y="313267"/>
                  <a:pt x="367506" y="156633"/>
                  <a:pt x="367506" y="0"/>
                </a:cubicBezTo>
                <a:close/>
              </a:path>
              <a:path fill="none" w="735013" h="939800">
                <a:moveTo>
                  <a:pt x="367506" y="0"/>
                </a:moveTo>
                <a:cubicBezTo>
                  <a:pt x="570475" y="0"/>
                  <a:pt x="735013" y="210381"/>
                  <a:pt x="735013" y="469900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50" name="组合 193"/>
          <p:cNvGrpSpPr/>
          <p:nvPr/>
        </p:nvGrpSpPr>
        <p:grpSpPr>
          <a:xfrm>
            <a:off x="1897200" y="7277040"/>
            <a:ext cx="960480" cy="826560"/>
            <a:chOff x="1897200" y="7277040"/>
            <a:chExt cx="960480" cy="826560"/>
          </a:xfrm>
        </p:grpSpPr>
        <p:grpSp>
          <p:nvGrpSpPr>
            <p:cNvPr id="451" name="组合 146"/>
            <p:cNvGrpSpPr/>
            <p:nvPr/>
          </p:nvGrpSpPr>
          <p:grpSpPr>
            <a:xfrm>
              <a:off x="1897200" y="7277040"/>
              <a:ext cx="960480" cy="826560"/>
              <a:chOff x="1897200" y="7277040"/>
              <a:chExt cx="960480" cy="826560"/>
            </a:xfrm>
          </p:grpSpPr>
          <p:grpSp>
            <p:nvGrpSpPr>
              <p:cNvPr id="452" name="组合 147"/>
              <p:cNvGrpSpPr/>
              <p:nvPr/>
            </p:nvGrpSpPr>
            <p:grpSpPr>
              <a:xfrm>
                <a:off x="1897200" y="7411680"/>
                <a:ext cx="960480" cy="691920"/>
                <a:chOff x="1897200" y="7411680"/>
                <a:chExt cx="960480" cy="691920"/>
              </a:xfrm>
            </p:grpSpPr>
            <p:grpSp>
              <p:nvGrpSpPr>
                <p:cNvPr id="453" name="组合 268"/>
                <p:cNvGrpSpPr/>
                <p:nvPr/>
              </p:nvGrpSpPr>
              <p:grpSpPr>
                <a:xfrm>
                  <a:off x="1897200" y="7430040"/>
                  <a:ext cx="960480" cy="673560"/>
                  <a:chOff x="1897200" y="7430040"/>
                  <a:chExt cx="960480" cy="673560"/>
                </a:xfrm>
              </p:grpSpPr>
              <p:sp>
                <p:nvSpPr>
                  <p:cNvPr id="454" name="矩形 154"/>
                  <p:cNvSpPr/>
                  <p:nvPr/>
                </p:nvSpPr>
                <p:spPr>
                  <a:xfrm>
                    <a:off x="1992600" y="7430040"/>
                    <a:ext cx="29520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H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grpSp>
                <p:nvGrpSpPr>
                  <p:cNvPr id="455" name="组合 182"/>
                  <p:cNvGrpSpPr/>
                  <p:nvPr/>
                </p:nvGrpSpPr>
                <p:grpSpPr>
                  <a:xfrm>
                    <a:off x="1897200" y="7444800"/>
                    <a:ext cx="960480" cy="658800"/>
                    <a:chOff x="1897200" y="7444800"/>
                    <a:chExt cx="960480" cy="658800"/>
                  </a:xfrm>
                </p:grpSpPr>
                <p:sp>
                  <p:nvSpPr>
                    <p:cNvPr id="456" name="TextBox 315"/>
                    <p:cNvSpPr/>
                    <p:nvPr/>
                  </p:nvSpPr>
                  <p:spPr>
                    <a:xfrm>
                      <a:off x="2022480" y="7722720"/>
                      <a:ext cx="409680" cy="380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7" name="TextBox 316"/>
                    <p:cNvSpPr/>
                    <p:nvPr/>
                  </p:nvSpPr>
                  <p:spPr>
                    <a:xfrm>
                      <a:off x="1897200" y="7579440"/>
                      <a:ext cx="960480" cy="1854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 </a:t>
                      </a: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8" name="TextBox 317"/>
                    <p:cNvSpPr/>
                    <p:nvPr/>
                  </p:nvSpPr>
                  <p:spPr>
                    <a:xfrm>
                      <a:off x="2017800" y="7444800"/>
                      <a:ext cx="411120" cy="1620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59" name="直接连接符 460"/>
                    <p:cNvSpPr/>
                    <p:nvPr/>
                  </p:nvSpPr>
                  <p:spPr>
                    <a:xfrm>
                      <a:off x="2116080" y="7565400"/>
                      <a:ext cx="0" cy="6660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9800" bIns="198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</p:grpSp>
            <p:grpSp>
              <p:nvGrpSpPr>
                <p:cNvPr id="460" name="组合 155"/>
                <p:cNvGrpSpPr/>
                <p:nvPr/>
              </p:nvGrpSpPr>
              <p:grpSpPr>
                <a:xfrm>
                  <a:off x="1981440" y="7411680"/>
                  <a:ext cx="385200" cy="495360"/>
                  <a:chOff x="1981440" y="7411680"/>
                  <a:chExt cx="385200" cy="495360"/>
                </a:xfrm>
              </p:grpSpPr>
              <p:sp>
                <p:nvSpPr>
                  <p:cNvPr id="461" name="矩形 156"/>
                  <p:cNvSpPr/>
                  <p:nvPr/>
                </p:nvSpPr>
                <p:spPr>
                  <a:xfrm>
                    <a:off x="1981440" y="7721640"/>
                    <a:ext cx="38520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OO</a:t>
                    </a:r>
                    <a:r>
                      <a:rPr b="1" lang="en-US" sz="600" spc="-1" strike="noStrike" baseline="300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-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2" name="直接连接符 453"/>
                  <p:cNvSpPr/>
                  <p:nvPr/>
                </p:nvSpPr>
                <p:spPr>
                  <a:xfrm>
                    <a:off x="2106720" y="7411680"/>
                    <a:ext cx="0" cy="680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3" name="直接连接符 454"/>
                  <p:cNvSpPr/>
                  <p:nvPr/>
                </p:nvSpPr>
                <p:spPr>
                  <a:xfrm>
                    <a:off x="2106720" y="7705080"/>
                    <a:ext cx="0" cy="680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464" name="矩形 159"/>
              <p:cNvSpPr/>
              <p:nvPr/>
            </p:nvSpPr>
            <p:spPr>
              <a:xfrm>
                <a:off x="1994760" y="727704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65" name="直接连接符 447"/>
            <p:cNvSpPr/>
            <p:nvPr/>
          </p:nvSpPr>
          <p:spPr>
            <a:xfrm flipH="1">
              <a:off x="2099880" y="7564680"/>
              <a:ext cx="108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66" name="组合 228"/>
          <p:cNvGrpSpPr/>
          <p:nvPr/>
        </p:nvGrpSpPr>
        <p:grpSpPr>
          <a:xfrm>
            <a:off x="1623240" y="6213600"/>
            <a:ext cx="1059480" cy="826560"/>
            <a:chOff x="1623240" y="6213600"/>
            <a:chExt cx="1059480" cy="826560"/>
          </a:xfrm>
        </p:grpSpPr>
        <p:grpSp>
          <p:nvGrpSpPr>
            <p:cNvPr id="467" name="组合 211"/>
            <p:cNvGrpSpPr/>
            <p:nvPr/>
          </p:nvGrpSpPr>
          <p:grpSpPr>
            <a:xfrm>
              <a:off x="1721160" y="6213600"/>
              <a:ext cx="961560" cy="826560"/>
              <a:chOff x="1721160" y="6213600"/>
              <a:chExt cx="961560" cy="826560"/>
            </a:xfrm>
          </p:grpSpPr>
          <p:grpSp>
            <p:nvGrpSpPr>
              <p:cNvPr id="468" name="组合 212"/>
              <p:cNvGrpSpPr/>
              <p:nvPr/>
            </p:nvGrpSpPr>
            <p:grpSpPr>
              <a:xfrm>
                <a:off x="1721160" y="6348600"/>
                <a:ext cx="961560" cy="691560"/>
                <a:chOff x="1721160" y="6348600"/>
                <a:chExt cx="961560" cy="691560"/>
              </a:xfrm>
            </p:grpSpPr>
            <p:grpSp>
              <p:nvGrpSpPr>
                <p:cNvPr id="469" name="组合 268"/>
                <p:cNvGrpSpPr/>
                <p:nvPr/>
              </p:nvGrpSpPr>
              <p:grpSpPr>
                <a:xfrm>
                  <a:off x="1721160" y="6363720"/>
                  <a:ext cx="961560" cy="676440"/>
                  <a:chOff x="1721160" y="6363720"/>
                  <a:chExt cx="961560" cy="676440"/>
                </a:xfrm>
              </p:grpSpPr>
              <p:grpSp>
                <p:nvGrpSpPr>
                  <p:cNvPr id="470" name="组合 182"/>
                  <p:cNvGrpSpPr/>
                  <p:nvPr/>
                </p:nvGrpSpPr>
                <p:grpSpPr>
                  <a:xfrm>
                    <a:off x="1721160" y="6378840"/>
                    <a:ext cx="961560" cy="661320"/>
                    <a:chOff x="1721160" y="6378840"/>
                    <a:chExt cx="961560" cy="661320"/>
                  </a:xfrm>
                </p:grpSpPr>
                <p:sp>
                  <p:nvSpPr>
                    <p:cNvPr id="471" name="TextBox 315"/>
                    <p:cNvSpPr/>
                    <p:nvPr/>
                  </p:nvSpPr>
                  <p:spPr>
                    <a:xfrm>
                      <a:off x="1834920" y="6659280"/>
                      <a:ext cx="412560" cy="380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2" name="TextBox 316"/>
                    <p:cNvSpPr/>
                    <p:nvPr/>
                  </p:nvSpPr>
                  <p:spPr>
                    <a:xfrm>
                      <a:off x="1721160" y="6503040"/>
                      <a:ext cx="961560" cy="1980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 </a:t>
                      </a: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</a:t>
                      </a:r>
                      <a:r>
                        <a:rPr b="1" lang="en-US" sz="6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3" name="TextBox 317"/>
                    <p:cNvSpPr/>
                    <p:nvPr/>
                  </p:nvSpPr>
                  <p:spPr>
                    <a:xfrm>
                      <a:off x="1831680" y="6378840"/>
                      <a:ext cx="411120" cy="1620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74" name="直接连接符 478"/>
                    <p:cNvSpPr/>
                    <p:nvPr/>
                  </p:nvSpPr>
                  <p:spPr>
                    <a:xfrm flipH="1">
                      <a:off x="1923840" y="6505560"/>
                      <a:ext cx="1440" cy="6228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15480" bIns="1548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475" name="矩形 219"/>
                  <p:cNvSpPr/>
                  <p:nvPr/>
                </p:nvSpPr>
                <p:spPr>
                  <a:xfrm>
                    <a:off x="1803240" y="6363720"/>
                    <a:ext cx="39420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    H 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76" name="组合 220"/>
                <p:cNvGrpSpPr/>
                <p:nvPr/>
              </p:nvGrpSpPr>
              <p:grpSpPr>
                <a:xfrm>
                  <a:off x="1810440" y="6348600"/>
                  <a:ext cx="385200" cy="504000"/>
                  <a:chOff x="1810440" y="6348600"/>
                  <a:chExt cx="385200" cy="504000"/>
                </a:xfrm>
              </p:grpSpPr>
              <p:sp>
                <p:nvSpPr>
                  <p:cNvPr id="477" name="矩形 221"/>
                  <p:cNvSpPr/>
                  <p:nvPr/>
                </p:nvSpPr>
                <p:spPr>
                  <a:xfrm>
                    <a:off x="1810440" y="6667200"/>
                    <a:ext cx="38520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OO</a:t>
                    </a:r>
                    <a:r>
                      <a:rPr b="1" lang="en-US" sz="600" spc="-1" strike="noStrike" baseline="300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-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8" name="直接连接符 471"/>
                  <p:cNvSpPr/>
                  <p:nvPr/>
                </p:nvSpPr>
                <p:spPr>
                  <a:xfrm flipH="1">
                    <a:off x="1921680" y="6348600"/>
                    <a:ext cx="1080" cy="684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600" bIns="216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9" name="直接连接符 472"/>
                  <p:cNvSpPr/>
                  <p:nvPr/>
                </p:nvSpPr>
                <p:spPr>
                  <a:xfrm flipH="1">
                    <a:off x="1921680" y="6642360"/>
                    <a:ext cx="1440" cy="66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480" name="矩形 224"/>
              <p:cNvSpPr/>
              <p:nvPr/>
            </p:nvSpPr>
            <p:spPr>
              <a:xfrm>
                <a:off x="1814400" y="621360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81" name="直接连接符 463"/>
            <p:cNvSpPr/>
            <p:nvPr/>
          </p:nvSpPr>
          <p:spPr>
            <a:xfrm>
              <a:off x="1954440" y="6456240"/>
              <a:ext cx="68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直接连接符 464"/>
            <p:cNvSpPr/>
            <p:nvPr/>
          </p:nvSpPr>
          <p:spPr>
            <a:xfrm>
              <a:off x="1816200" y="6451560"/>
              <a:ext cx="66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矩形 227"/>
            <p:cNvSpPr/>
            <p:nvPr/>
          </p:nvSpPr>
          <p:spPr>
            <a:xfrm>
              <a:off x="1623240" y="6367320"/>
              <a:ext cx="299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84" name="组合 229"/>
          <p:cNvGrpSpPr/>
          <p:nvPr/>
        </p:nvGrpSpPr>
        <p:grpSpPr>
          <a:xfrm>
            <a:off x="2191320" y="5307120"/>
            <a:ext cx="1066320" cy="816840"/>
            <a:chOff x="2191320" y="5307120"/>
            <a:chExt cx="1066320" cy="816840"/>
          </a:xfrm>
        </p:grpSpPr>
        <p:grpSp>
          <p:nvGrpSpPr>
            <p:cNvPr id="485" name="组合 231"/>
            <p:cNvGrpSpPr/>
            <p:nvPr/>
          </p:nvGrpSpPr>
          <p:grpSpPr>
            <a:xfrm>
              <a:off x="2296800" y="5307120"/>
              <a:ext cx="960840" cy="816840"/>
              <a:chOff x="2296800" y="5307120"/>
              <a:chExt cx="960840" cy="816840"/>
            </a:xfrm>
          </p:grpSpPr>
          <p:grpSp>
            <p:nvGrpSpPr>
              <p:cNvPr id="486" name="组合 232"/>
              <p:cNvGrpSpPr/>
              <p:nvPr/>
            </p:nvGrpSpPr>
            <p:grpSpPr>
              <a:xfrm>
                <a:off x="2296800" y="5437080"/>
                <a:ext cx="960840" cy="686880"/>
                <a:chOff x="2296800" y="5437080"/>
                <a:chExt cx="960840" cy="686880"/>
              </a:xfrm>
            </p:grpSpPr>
            <p:grpSp>
              <p:nvGrpSpPr>
                <p:cNvPr id="487" name="组合 268"/>
                <p:cNvGrpSpPr/>
                <p:nvPr/>
              </p:nvGrpSpPr>
              <p:grpSpPr>
                <a:xfrm>
                  <a:off x="2296800" y="5458320"/>
                  <a:ext cx="960840" cy="665640"/>
                  <a:chOff x="2296800" y="5458320"/>
                  <a:chExt cx="960840" cy="665640"/>
                </a:xfrm>
              </p:grpSpPr>
              <p:grpSp>
                <p:nvGrpSpPr>
                  <p:cNvPr id="488" name="组合 182"/>
                  <p:cNvGrpSpPr/>
                  <p:nvPr/>
                </p:nvGrpSpPr>
                <p:grpSpPr>
                  <a:xfrm>
                    <a:off x="2296800" y="5462640"/>
                    <a:ext cx="960840" cy="661320"/>
                    <a:chOff x="2296800" y="5462640"/>
                    <a:chExt cx="960840" cy="661320"/>
                  </a:xfrm>
                </p:grpSpPr>
                <p:sp>
                  <p:nvSpPr>
                    <p:cNvPr id="489" name="TextBox 315"/>
                    <p:cNvSpPr/>
                    <p:nvPr/>
                  </p:nvSpPr>
                  <p:spPr>
                    <a:xfrm>
                      <a:off x="2406240" y="5743080"/>
                      <a:ext cx="411120" cy="38088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0" name="TextBox 316"/>
                    <p:cNvSpPr/>
                    <p:nvPr/>
                  </p:nvSpPr>
                  <p:spPr>
                    <a:xfrm>
                      <a:off x="2296800" y="5596560"/>
                      <a:ext cx="960840" cy="19800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   </a:t>
                      </a:r>
                      <a:r>
                        <a:rPr b="1" lang="en-US" sz="6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H</a:t>
                      </a:r>
                      <a:r>
                        <a:rPr b="1" lang="en-US" sz="600" spc="-1" strike="noStrike" baseline="-25000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1" name="TextBox 317"/>
                    <p:cNvSpPr/>
                    <p:nvPr/>
                  </p:nvSpPr>
                  <p:spPr>
                    <a:xfrm>
                      <a:off x="2401560" y="5462640"/>
                      <a:ext cx="411120" cy="156960"/>
                    </a:xfrm>
                    <a:prstGeom prst="rect">
                      <a:avLst/>
                    </a:prstGeom>
                    <a:noFill/>
                    <a:ln w="0">
                      <a:noFill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46800" bIns="46800" anchor="t">
                      <a:sp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  <p:sp>
                  <p:nvSpPr>
                    <p:cNvPr id="492" name="直接连接符 496"/>
                    <p:cNvSpPr/>
                    <p:nvPr/>
                  </p:nvSpPr>
                  <p:spPr>
                    <a:xfrm flipH="1">
                      <a:off x="2493720" y="5584320"/>
                      <a:ext cx="1440" cy="67320"/>
                    </a:xfrm>
                    <a:prstGeom prst="line">
                      <a:avLst/>
                    </a:prstGeom>
                    <a:ln w="9360">
                      <a:solidFill>
                        <a:srgbClr val="000000"/>
                      </a:solidFill>
                      <a:miter/>
                    </a:ln>
                  </p:spPr>
                  <p:style>
                    <a:lnRef idx="0"/>
                    <a:fillRef idx="0"/>
                    <a:effectRef idx="0"/>
                    <a:fontRef idx="minor"/>
                  </p:style>
                  <p:txBody>
                    <a:bodyPr lIns="90000" rIns="90000" tIns="20520" bIns="2052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p:txBody>
                </p:sp>
              </p:grpSp>
              <p:sp>
                <p:nvSpPr>
                  <p:cNvPr id="493" name="矩形 239"/>
                  <p:cNvSpPr/>
                  <p:nvPr/>
                </p:nvSpPr>
                <p:spPr>
                  <a:xfrm>
                    <a:off x="2375640" y="5458320"/>
                    <a:ext cx="39420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    H 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94" name="组合 240"/>
                <p:cNvGrpSpPr/>
                <p:nvPr/>
              </p:nvGrpSpPr>
              <p:grpSpPr>
                <a:xfrm>
                  <a:off x="2397240" y="5437080"/>
                  <a:ext cx="385200" cy="505800"/>
                  <a:chOff x="2397240" y="5437080"/>
                  <a:chExt cx="385200" cy="505800"/>
                </a:xfrm>
              </p:grpSpPr>
              <p:sp>
                <p:nvSpPr>
                  <p:cNvPr id="495" name="矩形 241"/>
                  <p:cNvSpPr/>
                  <p:nvPr/>
                </p:nvSpPr>
                <p:spPr>
                  <a:xfrm>
                    <a:off x="2397240" y="5757480"/>
                    <a:ext cx="385200" cy="18540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6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COO</a:t>
                    </a:r>
                    <a:r>
                      <a:rPr b="1" lang="en-US" sz="600" spc="-1" strike="noStrike" baseline="30000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--</a:t>
                    </a:r>
                    <a:endParaRPr b="0" lang="en-US" sz="6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6" name="直接连接符 489"/>
                  <p:cNvSpPr/>
                  <p:nvPr/>
                </p:nvSpPr>
                <p:spPr>
                  <a:xfrm>
                    <a:off x="2489040" y="5437080"/>
                    <a:ext cx="0" cy="680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240" bIns="212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7" name="直接连接符 490"/>
                  <p:cNvSpPr/>
                  <p:nvPr/>
                </p:nvSpPr>
                <p:spPr>
                  <a:xfrm>
                    <a:off x="2489040" y="5732280"/>
                    <a:ext cx="0" cy="666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9800" bIns="19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498" name="矩形 244"/>
              <p:cNvSpPr/>
              <p:nvPr/>
            </p:nvSpPr>
            <p:spPr>
              <a:xfrm>
                <a:off x="2391480" y="530712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99" name="直接连接符 481"/>
            <p:cNvSpPr/>
            <p:nvPr/>
          </p:nvSpPr>
          <p:spPr>
            <a:xfrm>
              <a:off x="2522520" y="5551560"/>
              <a:ext cx="6660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直接连接符 482"/>
            <p:cNvSpPr/>
            <p:nvPr/>
          </p:nvSpPr>
          <p:spPr>
            <a:xfrm>
              <a:off x="2388960" y="5549760"/>
              <a:ext cx="66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矩形 247"/>
            <p:cNvSpPr/>
            <p:nvPr/>
          </p:nvSpPr>
          <p:spPr>
            <a:xfrm>
              <a:off x="2191320" y="5457240"/>
              <a:ext cx="2995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2" name="弧形 497"/>
          <p:cNvSpPr/>
          <p:nvPr/>
        </p:nvSpPr>
        <p:spPr>
          <a:xfrm rot="10165800">
            <a:off x="1816920" y="6844680"/>
            <a:ext cx="344520" cy="718920"/>
          </a:xfrm>
          <a:custGeom>
            <a:avLst/>
            <a:gdLst/>
            <a:ahLst/>
            <a:rect l="l" t="t" r="r" b="b"/>
            <a:pathLst>
              <a:path stroke="0" w="344487" h="719138">
                <a:moveTo>
                  <a:pt x="172243" y="0"/>
                </a:moveTo>
                <a:cubicBezTo>
                  <a:pt x="250392" y="0"/>
                  <a:pt x="318748" y="109833"/>
                  <a:pt x="338750" y="267540"/>
                </a:cubicBezTo>
                <a:cubicBezTo>
                  <a:pt x="346901" y="331808"/>
                  <a:pt x="346357" y="399535"/>
                  <a:pt x="337179" y="463196"/>
                </a:cubicBezTo>
                <a:cubicBezTo>
                  <a:pt x="313112" y="630128"/>
                  <a:pt x="235151" y="736974"/>
                  <a:pt x="152209" y="716698"/>
                </a:cubicBezTo>
                <a:lnTo>
                  <a:pt x="172244" y="359569"/>
                </a:lnTo>
                <a:cubicBezTo>
                  <a:pt x="172244" y="239713"/>
                  <a:pt x="172243" y="119856"/>
                  <a:pt x="172243" y="0"/>
                </a:cubicBezTo>
                <a:close/>
              </a:path>
              <a:path fill="none" w="344487" h="719138">
                <a:moveTo>
                  <a:pt x="172243" y="0"/>
                </a:moveTo>
                <a:cubicBezTo>
                  <a:pt x="250392" y="0"/>
                  <a:pt x="318748" y="109833"/>
                  <a:pt x="338750" y="267540"/>
                </a:cubicBezTo>
                <a:cubicBezTo>
                  <a:pt x="346901" y="331808"/>
                  <a:pt x="346357" y="399535"/>
                  <a:pt x="337179" y="463196"/>
                </a:cubicBezTo>
                <a:cubicBezTo>
                  <a:pt x="313112" y="630128"/>
                  <a:pt x="235151" y="736974"/>
                  <a:pt x="152209" y="716698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弧形 498"/>
          <p:cNvSpPr/>
          <p:nvPr/>
        </p:nvSpPr>
        <p:spPr>
          <a:xfrm rot="14545800">
            <a:off x="2347560" y="5479560"/>
            <a:ext cx="590760" cy="1092240"/>
          </a:xfrm>
          <a:custGeom>
            <a:avLst/>
            <a:gdLst/>
            <a:ahLst/>
            <a:rect l="l" t="t" r="r" b="b"/>
            <a:pathLst>
              <a:path stroke="0" w="590550" h="1092200">
                <a:moveTo>
                  <a:pt x="295275" y="0"/>
                </a:moveTo>
                <a:cubicBezTo>
                  <a:pt x="453413" y="0"/>
                  <a:pt x="583477" y="230419"/>
                  <a:pt x="590277" y="522618"/>
                </a:cubicBezTo>
                <a:lnTo>
                  <a:pt x="295275" y="546100"/>
                </a:lnTo>
                <a:lnTo>
                  <a:pt x="295275" y="0"/>
                </a:lnTo>
                <a:close/>
              </a:path>
              <a:path fill="none" w="590550" h="1092200">
                <a:moveTo>
                  <a:pt x="295275" y="0"/>
                </a:moveTo>
                <a:cubicBezTo>
                  <a:pt x="453413" y="0"/>
                  <a:pt x="583477" y="230419"/>
                  <a:pt x="590277" y="522618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弧形 499"/>
          <p:cNvSpPr/>
          <p:nvPr/>
        </p:nvSpPr>
        <p:spPr>
          <a:xfrm rot="20400000">
            <a:off x="2860200" y="5355720"/>
            <a:ext cx="594000" cy="287640"/>
          </a:xfrm>
          <a:custGeom>
            <a:avLst/>
            <a:gdLst/>
            <a:ahLst/>
            <a:rect l="l" t="t" r="r" b="b"/>
            <a:pathLst>
              <a:path stroke="0" w="593725" h="287338">
                <a:moveTo>
                  <a:pt x="1200" y="130762"/>
                </a:moveTo>
                <a:cubicBezTo>
                  <a:pt x="15109" y="56138"/>
                  <a:pt x="145184" y="-783"/>
                  <a:pt x="299997" y="8"/>
                </a:cubicBezTo>
                <a:cubicBezTo>
                  <a:pt x="462718" y="839"/>
                  <a:pt x="593726" y="64915"/>
                  <a:pt x="593726" y="143669"/>
                </a:cubicBezTo>
                <a:lnTo>
                  <a:pt x="296863" y="143669"/>
                </a:lnTo>
                <a:lnTo>
                  <a:pt x="1200" y="130762"/>
                </a:lnTo>
                <a:close/>
              </a:path>
              <a:path fill="none" w="593725" h="287338">
                <a:moveTo>
                  <a:pt x="1200" y="130762"/>
                </a:moveTo>
                <a:cubicBezTo>
                  <a:pt x="15109" y="56138"/>
                  <a:pt x="145184" y="-783"/>
                  <a:pt x="299997" y="8"/>
                </a:cubicBezTo>
                <a:cubicBezTo>
                  <a:pt x="462718" y="839"/>
                  <a:pt x="593726" y="64915"/>
                  <a:pt x="593726" y="143669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弧形 500"/>
          <p:cNvSpPr/>
          <p:nvPr/>
        </p:nvSpPr>
        <p:spPr>
          <a:xfrm flipV="1">
            <a:off x="2857680" y="4960800"/>
            <a:ext cx="457200" cy="395280"/>
          </a:xfrm>
          <a:custGeom>
            <a:avLst/>
            <a:gdLst/>
            <a:ahLst/>
            <a:rect l="l" t="t" r="r" b="b"/>
            <a:pathLst>
              <a:path stroke="0" w="457200" h="395287">
                <a:moveTo>
                  <a:pt x="291" y="187677"/>
                </a:moveTo>
                <a:cubicBezTo>
                  <a:pt x="3841" y="126893"/>
                  <a:pt x="39584" y="70912"/>
                  <a:pt x="97183" y="35924"/>
                </a:cubicBezTo>
                <a:cubicBezTo>
                  <a:pt x="144706" y="7057"/>
                  <a:pt x="203155" y="-5089"/>
                  <a:pt x="260661" y="1953"/>
                </a:cubicBezTo>
                <a:lnTo>
                  <a:pt x="228600" y="197644"/>
                </a:lnTo>
                <a:lnTo>
                  <a:pt x="291" y="187677"/>
                </a:lnTo>
                <a:close/>
              </a:path>
              <a:path fill="none" w="457200" h="395287">
                <a:moveTo>
                  <a:pt x="291" y="187677"/>
                </a:moveTo>
                <a:cubicBezTo>
                  <a:pt x="3841" y="126893"/>
                  <a:pt x="39584" y="70912"/>
                  <a:pt x="97183" y="35924"/>
                </a:cubicBezTo>
                <a:cubicBezTo>
                  <a:pt x="144706" y="7057"/>
                  <a:pt x="203155" y="-5089"/>
                  <a:pt x="260661" y="195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6" name="组合 263"/>
          <p:cNvGrpSpPr/>
          <p:nvPr/>
        </p:nvGrpSpPr>
        <p:grpSpPr>
          <a:xfrm>
            <a:off x="2514600" y="4849920"/>
            <a:ext cx="957240" cy="353520"/>
            <a:chOff x="2514600" y="4849920"/>
            <a:chExt cx="957240" cy="353520"/>
          </a:xfrm>
        </p:grpSpPr>
        <p:sp>
          <p:nvSpPr>
            <p:cNvPr id="507" name="文本框 253"/>
            <p:cNvSpPr/>
            <p:nvPr/>
          </p:nvSpPr>
          <p:spPr>
            <a:xfrm>
              <a:off x="2710800" y="5000400"/>
              <a:ext cx="199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文本框 251"/>
            <p:cNvSpPr/>
            <p:nvPr/>
          </p:nvSpPr>
          <p:spPr>
            <a:xfrm>
              <a:off x="2514600" y="5005440"/>
              <a:ext cx="862560" cy="19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直接连接符 504"/>
            <p:cNvSpPr/>
            <p:nvPr/>
          </p:nvSpPr>
          <p:spPr>
            <a:xfrm>
              <a:off x="2730240" y="5085000"/>
              <a:ext cx="66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直接连接符 505"/>
            <p:cNvSpPr/>
            <p:nvPr/>
          </p:nvSpPr>
          <p:spPr>
            <a:xfrm>
              <a:off x="2847960" y="5092560"/>
              <a:ext cx="68040" cy="1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文本框 256"/>
            <p:cNvSpPr/>
            <p:nvPr/>
          </p:nvSpPr>
          <p:spPr>
            <a:xfrm>
              <a:off x="2833200" y="5000400"/>
              <a:ext cx="315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直接连接符 507"/>
            <p:cNvSpPr/>
            <p:nvPr/>
          </p:nvSpPr>
          <p:spPr>
            <a:xfrm>
              <a:off x="2974680" y="5094360"/>
              <a:ext cx="680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文本框 258"/>
            <p:cNvSpPr/>
            <p:nvPr/>
          </p:nvSpPr>
          <p:spPr>
            <a:xfrm>
              <a:off x="2967120" y="4999320"/>
              <a:ext cx="5047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直接连接符 509"/>
            <p:cNvSpPr/>
            <p:nvPr/>
          </p:nvSpPr>
          <p:spPr>
            <a:xfrm>
              <a:off x="2808360" y="4987800"/>
              <a:ext cx="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直接连接符 510"/>
            <p:cNvSpPr/>
            <p:nvPr/>
          </p:nvSpPr>
          <p:spPr>
            <a:xfrm flipH="1">
              <a:off x="2830320" y="4987800"/>
              <a:ext cx="1440" cy="6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文本框 261"/>
            <p:cNvSpPr/>
            <p:nvPr/>
          </p:nvSpPr>
          <p:spPr>
            <a:xfrm>
              <a:off x="2707560" y="4849920"/>
              <a:ext cx="5378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17" name="TextBox 263"/>
          <p:cNvSpPr/>
          <p:nvPr/>
        </p:nvSpPr>
        <p:spPr>
          <a:xfrm>
            <a:off x="3011400" y="538020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TextBox 263"/>
          <p:cNvSpPr/>
          <p:nvPr/>
        </p:nvSpPr>
        <p:spPr>
          <a:xfrm>
            <a:off x="4122720" y="541008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TextBox 263"/>
          <p:cNvSpPr/>
          <p:nvPr/>
        </p:nvSpPr>
        <p:spPr>
          <a:xfrm>
            <a:off x="5073480" y="611820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TextBox 263"/>
          <p:cNvSpPr/>
          <p:nvPr/>
        </p:nvSpPr>
        <p:spPr>
          <a:xfrm>
            <a:off x="4562640" y="8362800"/>
            <a:ext cx="347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弧形 516"/>
          <p:cNvSpPr/>
          <p:nvPr/>
        </p:nvSpPr>
        <p:spPr>
          <a:xfrm flipV="1">
            <a:off x="5303880" y="7416720"/>
            <a:ext cx="285840" cy="441360"/>
          </a:xfrm>
          <a:custGeom>
            <a:avLst/>
            <a:gdLst/>
            <a:ahLst/>
            <a:rect l="l" t="t" r="r" b="b"/>
            <a:pathLst>
              <a:path stroke="0" w="285750" h="441325">
                <a:moveTo>
                  <a:pt x="57" y="214428"/>
                </a:moveTo>
                <a:cubicBezTo>
                  <a:pt x="932" y="166626"/>
                  <a:pt x="11838" y="120556"/>
                  <a:pt x="31133" y="83155"/>
                </a:cubicBezTo>
                <a:cubicBezTo>
                  <a:pt x="66101" y="15374"/>
                  <a:pt x="123522" y="-14517"/>
                  <a:pt x="177922" y="6742"/>
                </a:cubicBezTo>
                <a:lnTo>
                  <a:pt x="142875" y="220663"/>
                </a:lnTo>
                <a:lnTo>
                  <a:pt x="57" y="214428"/>
                </a:lnTo>
                <a:close/>
              </a:path>
              <a:path fill="none" w="285750" h="441325">
                <a:moveTo>
                  <a:pt x="57" y="214428"/>
                </a:moveTo>
                <a:cubicBezTo>
                  <a:pt x="932" y="166626"/>
                  <a:pt x="11838" y="120556"/>
                  <a:pt x="31133" y="83155"/>
                </a:cubicBezTo>
                <a:cubicBezTo>
                  <a:pt x="66101" y="15374"/>
                  <a:pt x="123522" y="-14517"/>
                  <a:pt x="177922" y="6742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文本框 270"/>
          <p:cNvSpPr/>
          <p:nvPr/>
        </p:nvSpPr>
        <p:spPr>
          <a:xfrm>
            <a:off x="5421240" y="7780320"/>
            <a:ext cx="7286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DH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弧形 518"/>
          <p:cNvSpPr/>
          <p:nvPr/>
        </p:nvSpPr>
        <p:spPr>
          <a:xfrm flipV="1" rot="1500000">
            <a:off x="4707000" y="8342280"/>
            <a:ext cx="312840" cy="442800"/>
          </a:xfrm>
          <a:custGeom>
            <a:avLst/>
            <a:gdLst/>
            <a:ahLst/>
            <a:rect l="l" t="t" r="r" b="b"/>
            <a:pathLst>
              <a:path stroke="0" w="312737" h="442912">
                <a:moveTo>
                  <a:pt x="74" y="214633"/>
                </a:moveTo>
                <a:cubicBezTo>
                  <a:pt x="1184" y="163625"/>
                  <a:pt x="14699" y="114725"/>
                  <a:pt x="38334" y="76204"/>
                </a:cubicBezTo>
                <a:cubicBezTo>
                  <a:pt x="76306" y="14313"/>
                  <a:pt x="135317" y="-12801"/>
                  <a:pt x="191712" y="5731"/>
                </a:cubicBezTo>
                <a:lnTo>
                  <a:pt x="156369" y="221456"/>
                </a:lnTo>
                <a:lnTo>
                  <a:pt x="74" y="214633"/>
                </a:lnTo>
                <a:close/>
              </a:path>
              <a:path fill="none" w="312737" h="442912">
                <a:moveTo>
                  <a:pt x="74" y="214633"/>
                </a:moveTo>
                <a:cubicBezTo>
                  <a:pt x="1184" y="163625"/>
                  <a:pt x="14699" y="114725"/>
                  <a:pt x="38334" y="76204"/>
                </a:cubicBezTo>
                <a:cubicBezTo>
                  <a:pt x="76306" y="14313"/>
                  <a:pt x="135317" y="-12801"/>
                  <a:pt x="191712" y="5731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文本框 272"/>
          <p:cNvSpPr/>
          <p:nvPr/>
        </p:nvSpPr>
        <p:spPr>
          <a:xfrm>
            <a:off x="4738680" y="8721720"/>
            <a:ext cx="59832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</a:t>
            </a:r>
            <a:r>
              <a:rPr b="1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弧形 520"/>
          <p:cNvSpPr/>
          <p:nvPr/>
        </p:nvSpPr>
        <p:spPr>
          <a:xfrm flipV="1" rot="1500000">
            <a:off x="3801600" y="8568720"/>
            <a:ext cx="230400" cy="479160"/>
          </a:xfrm>
          <a:custGeom>
            <a:avLst/>
            <a:gdLst/>
            <a:ahLst/>
            <a:rect l="l" t="t" r="r" b="b"/>
            <a:pathLst>
              <a:path stroke="0" w="230187" h="479425">
                <a:moveTo>
                  <a:pt x="25" y="234689"/>
                </a:moveTo>
                <a:cubicBezTo>
                  <a:pt x="439" y="193505"/>
                  <a:pt x="5943" y="153238"/>
                  <a:pt x="16003" y="117773"/>
                </a:cubicBezTo>
                <a:cubicBezTo>
                  <a:pt x="43748" y="19971"/>
                  <a:pt x="100642" y="-23842"/>
                  <a:pt x="152262" y="12843"/>
                </a:cubicBezTo>
                <a:lnTo>
                  <a:pt x="115094" y="239713"/>
                </a:lnTo>
                <a:lnTo>
                  <a:pt x="25" y="234689"/>
                </a:lnTo>
                <a:close/>
              </a:path>
              <a:path fill="none" w="230187" h="479425">
                <a:moveTo>
                  <a:pt x="25" y="234689"/>
                </a:moveTo>
                <a:cubicBezTo>
                  <a:pt x="439" y="193505"/>
                  <a:pt x="5943" y="153238"/>
                  <a:pt x="16003" y="117773"/>
                </a:cubicBezTo>
                <a:cubicBezTo>
                  <a:pt x="43748" y="19971"/>
                  <a:pt x="100642" y="-23842"/>
                  <a:pt x="152262" y="1284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文本框 274"/>
          <p:cNvSpPr/>
          <p:nvPr/>
        </p:nvSpPr>
        <p:spPr>
          <a:xfrm>
            <a:off x="3805200" y="8966160"/>
            <a:ext cx="59868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</a:t>
            </a:r>
            <a:r>
              <a:rPr b="1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TextBox 263"/>
          <p:cNvSpPr/>
          <p:nvPr/>
        </p:nvSpPr>
        <p:spPr>
          <a:xfrm>
            <a:off x="3648240" y="8605800"/>
            <a:ext cx="347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5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TextBox 263"/>
          <p:cNvSpPr/>
          <p:nvPr/>
        </p:nvSpPr>
        <p:spPr>
          <a:xfrm>
            <a:off x="2320920" y="807228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7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弧形 524"/>
          <p:cNvSpPr/>
          <p:nvPr/>
        </p:nvSpPr>
        <p:spPr>
          <a:xfrm flipV="1" rot="1500000">
            <a:off x="2253960" y="7948080"/>
            <a:ext cx="230040" cy="478080"/>
          </a:xfrm>
          <a:custGeom>
            <a:avLst/>
            <a:gdLst/>
            <a:ahLst/>
            <a:rect l="l" t="t" r="r" b="b"/>
            <a:pathLst>
              <a:path stroke="0" w="230188" h="477837">
                <a:moveTo>
                  <a:pt x="25" y="233895"/>
                </a:moveTo>
                <a:cubicBezTo>
                  <a:pt x="442" y="192735"/>
                  <a:pt x="5975" y="152498"/>
                  <a:pt x="16089" y="117084"/>
                </a:cubicBezTo>
                <a:cubicBezTo>
                  <a:pt x="43848" y="19880"/>
                  <a:pt x="100616" y="-23661"/>
                  <a:pt x="152152" y="12723"/>
                </a:cubicBezTo>
                <a:lnTo>
                  <a:pt x="115094" y="238919"/>
                </a:lnTo>
                <a:lnTo>
                  <a:pt x="25" y="233895"/>
                </a:lnTo>
                <a:close/>
              </a:path>
              <a:path fill="none" w="230188" h="477837">
                <a:moveTo>
                  <a:pt x="25" y="233895"/>
                </a:moveTo>
                <a:cubicBezTo>
                  <a:pt x="442" y="192735"/>
                  <a:pt x="5975" y="152498"/>
                  <a:pt x="16089" y="117084"/>
                </a:cubicBezTo>
                <a:cubicBezTo>
                  <a:pt x="43848" y="19880"/>
                  <a:pt x="100616" y="-23661"/>
                  <a:pt x="152152" y="12723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文本框 278"/>
          <p:cNvSpPr/>
          <p:nvPr/>
        </p:nvSpPr>
        <p:spPr>
          <a:xfrm>
            <a:off x="2252520" y="8344080"/>
            <a:ext cx="59868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ADH</a:t>
            </a:r>
            <a:r>
              <a:rPr b="1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弧形 526"/>
          <p:cNvSpPr/>
          <p:nvPr/>
        </p:nvSpPr>
        <p:spPr>
          <a:xfrm flipH="1" flipV="1" rot="3180000">
            <a:off x="1847880" y="6875280"/>
            <a:ext cx="254160" cy="376200"/>
          </a:xfrm>
          <a:custGeom>
            <a:avLst/>
            <a:gdLst/>
            <a:ahLst/>
            <a:rect l="l" t="t" r="r" b="b"/>
            <a:pathLst>
              <a:path stroke="0" w="254000" h="376238">
                <a:moveTo>
                  <a:pt x="55" y="182577"/>
                </a:moveTo>
                <a:cubicBezTo>
                  <a:pt x="890" y="140587"/>
                  <a:pt x="11190" y="100219"/>
                  <a:pt x="29313" y="67907"/>
                </a:cubicBezTo>
                <a:cubicBezTo>
                  <a:pt x="60301" y="12656"/>
                  <a:pt x="109826" y="-11634"/>
                  <a:pt x="156951" y="5306"/>
                </a:cubicBezTo>
                <a:lnTo>
                  <a:pt x="127000" y="188119"/>
                </a:lnTo>
                <a:lnTo>
                  <a:pt x="55" y="182577"/>
                </a:lnTo>
                <a:close/>
              </a:path>
              <a:path fill="none" w="254000" h="376238">
                <a:moveTo>
                  <a:pt x="55" y="182577"/>
                </a:moveTo>
                <a:cubicBezTo>
                  <a:pt x="890" y="140587"/>
                  <a:pt x="11190" y="100219"/>
                  <a:pt x="29313" y="67907"/>
                </a:cubicBezTo>
                <a:cubicBezTo>
                  <a:pt x="60301" y="12656"/>
                  <a:pt x="109826" y="-11634"/>
                  <a:pt x="156951" y="5306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TextBox 263"/>
          <p:cNvSpPr/>
          <p:nvPr/>
        </p:nvSpPr>
        <p:spPr>
          <a:xfrm>
            <a:off x="1971720" y="685656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8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33" name="组合 283"/>
          <p:cNvGrpSpPr/>
          <p:nvPr/>
        </p:nvGrpSpPr>
        <p:grpSpPr>
          <a:xfrm>
            <a:off x="3143160" y="8632800"/>
            <a:ext cx="960480" cy="688680"/>
            <a:chOff x="3143160" y="8632800"/>
            <a:chExt cx="960480" cy="688680"/>
          </a:xfrm>
        </p:grpSpPr>
        <p:grpSp>
          <p:nvGrpSpPr>
            <p:cNvPr id="534" name="组合 268"/>
            <p:cNvGrpSpPr/>
            <p:nvPr/>
          </p:nvGrpSpPr>
          <p:grpSpPr>
            <a:xfrm>
              <a:off x="3143160" y="8658000"/>
              <a:ext cx="960480" cy="663480"/>
              <a:chOff x="3143160" y="8658000"/>
              <a:chExt cx="960480" cy="663480"/>
            </a:xfrm>
          </p:grpSpPr>
          <p:grpSp>
            <p:nvGrpSpPr>
              <p:cNvPr id="535" name="组合 182"/>
              <p:cNvGrpSpPr/>
              <p:nvPr/>
            </p:nvGrpSpPr>
            <p:grpSpPr>
              <a:xfrm>
                <a:off x="3143160" y="8658000"/>
                <a:ext cx="960480" cy="663480"/>
                <a:chOff x="3143160" y="8658000"/>
                <a:chExt cx="960480" cy="663480"/>
              </a:xfrm>
            </p:grpSpPr>
            <p:sp>
              <p:nvSpPr>
                <p:cNvPr id="536" name="TextBox 315"/>
                <p:cNvSpPr/>
                <p:nvPr/>
              </p:nvSpPr>
              <p:spPr>
                <a:xfrm>
                  <a:off x="3238200" y="8940600"/>
                  <a:ext cx="411120" cy="380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7" name="TextBox 316"/>
                <p:cNvSpPr/>
                <p:nvPr/>
              </p:nvSpPr>
              <p:spPr>
                <a:xfrm>
                  <a:off x="3143160" y="8808120"/>
                  <a:ext cx="960480" cy="1980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   </a:t>
                  </a:r>
                  <a:r>
                    <a:rPr b="1" lang="en-US" sz="6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CH</a:t>
                  </a:r>
                  <a:r>
                    <a:rPr b="1" lang="en-US" sz="600" spc="-1" strike="noStrike" baseline="-25000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TextBox 317"/>
                <p:cNvSpPr/>
                <p:nvPr/>
              </p:nvSpPr>
              <p:spPr>
                <a:xfrm>
                  <a:off x="3234960" y="8658000"/>
                  <a:ext cx="411120" cy="160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9" name="直接连接符 539"/>
                <p:cNvSpPr/>
                <p:nvPr/>
              </p:nvSpPr>
              <p:spPr>
                <a:xfrm>
                  <a:off x="3327120" y="8783280"/>
                  <a:ext cx="0" cy="666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800" bIns="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40" name="矩形 535"/>
              <p:cNvSpPr/>
              <p:nvPr/>
            </p:nvSpPr>
            <p:spPr>
              <a:xfrm>
                <a:off x="3238200" y="8665920"/>
                <a:ext cx="338040" cy="198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H</a:t>
                </a:r>
                <a:r>
                  <a:rPr b="1" lang="en-US" sz="600" spc="-1" strike="noStrike" baseline="-25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2</a:t>
                </a: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41" name="组合 291"/>
            <p:cNvGrpSpPr/>
            <p:nvPr/>
          </p:nvGrpSpPr>
          <p:grpSpPr>
            <a:xfrm>
              <a:off x="3243240" y="8632800"/>
              <a:ext cx="385200" cy="514080"/>
              <a:chOff x="3243240" y="8632800"/>
              <a:chExt cx="385200" cy="514080"/>
            </a:xfrm>
          </p:grpSpPr>
          <p:sp>
            <p:nvSpPr>
              <p:cNvPr id="542" name="矩形 292"/>
              <p:cNvSpPr/>
              <p:nvPr/>
            </p:nvSpPr>
            <p:spPr>
              <a:xfrm>
                <a:off x="3243240" y="8961480"/>
                <a:ext cx="385200" cy="1854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OO</a:t>
                </a:r>
                <a:r>
                  <a:rPr b="1" lang="en-US" sz="600" spc="-1" strike="noStrike" baseline="30000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-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3" name="直接连接符 532"/>
              <p:cNvSpPr/>
              <p:nvPr/>
            </p:nvSpPr>
            <p:spPr>
              <a:xfrm>
                <a:off x="3321000" y="8632800"/>
                <a:ext cx="0" cy="68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4" name="直接连接符 533"/>
              <p:cNvSpPr/>
              <p:nvPr/>
            </p:nvSpPr>
            <p:spPr>
              <a:xfrm>
                <a:off x="3320280" y="8926560"/>
                <a:ext cx="0" cy="66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800" bIns="19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45" name="组合 297"/>
          <p:cNvGrpSpPr/>
          <p:nvPr/>
        </p:nvGrpSpPr>
        <p:grpSpPr>
          <a:xfrm>
            <a:off x="3236760" y="8359920"/>
            <a:ext cx="768600" cy="334080"/>
            <a:chOff x="3236760" y="8359920"/>
            <a:chExt cx="768600" cy="334080"/>
          </a:xfrm>
        </p:grpSpPr>
        <p:sp>
          <p:nvSpPr>
            <p:cNvPr id="546" name="文本框 298"/>
            <p:cNvSpPr/>
            <p:nvPr/>
          </p:nvSpPr>
          <p:spPr>
            <a:xfrm>
              <a:off x="3236760" y="8508600"/>
              <a:ext cx="1990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直接连接符 542"/>
            <p:cNvSpPr/>
            <p:nvPr/>
          </p:nvSpPr>
          <p:spPr>
            <a:xfrm>
              <a:off x="3360240" y="8587080"/>
              <a:ext cx="66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文本框 302"/>
            <p:cNvSpPr/>
            <p:nvPr/>
          </p:nvSpPr>
          <p:spPr>
            <a:xfrm>
              <a:off x="3372840" y="8503920"/>
              <a:ext cx="314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直接连接符 544"/>
            <p:cNvSpPr/>
            <p:nvPr/>
          </p:nvSpPr>
          <p:spPr>
            <a:xfrm>
              <a:off x="3487680" y="8583840"/>
              <a:ext cx="6624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文本框 304"/>
            <p:cNvSpPr/>
            <p:nvPr/>
          </p:nvSpPr>
          <p:spPr>
            <a:xfrm>
              <a:off x="3501720" y="8507880"/>
              <a:ext cx="5036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A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直接连接符 546"/>
            <p:cNvSpPr/>
            <p:nvPr/>
          </p:nvSpPr>
          <p:spPr>
            <a:xfrm>
              <a:off x="3319560" y="8482320"/>
              <a:ext cx="0" cy="68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直接连接符 547"/>
            <p:cNvSpPr/>
            <p:nvPr/>
          </p:nvSpPr>
          <p:spPr>
            <a:xfrm>
              <a:off x="3341160" y="8482320"/>
              <a:ext cx="0" cy="68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文本框 307"/>
            <p:cNvSpPr/>
            <p:nvPr/>
          </p:nvSpPr>
          <p:spPr>
            <a:xfrm>
              <a:off x="3242880" y="8359920"/>
              <a:ext cx="5367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54" name="弧形 549"/>
          <p:cNvSpPr/>
          <p:nvPr/>
        </p:nvSpPr>
        <p:spPr>
          <a:xfrm rot="10165800">
            <a:off x="2781360" y="7829640"/>
            <a:ext cx="735120" cy="938160"/>
          </a:xfrm>
          <a:custGeom>
            <a:avLst/>
            <a:gdLst/>
            <a:ahLst/>
            <a:rect l="l" t="t" r="r" b="b"/>
            <a:pathLst>
              <a:path stroke="0" w="735013" h="938213">
                <a:moveTo>
                  <a:pt x="367506" y="0"/>
                </a:moveTo>
                <a:cubicBezTo>
                  <a:pt x="570475" y="0"/>
                  <a:pt x="735013" y="210026"/>
                  <a:pt x="735013" y="469107"/>
                </a:cubicBezTo>
                <a:lnTo>
                  <a:pt x="367507" y="469107"/>
                </a:lnTo>
                <a:cubicBezTo>
                  <a:pt x="367507" y="312738"/>
                  <a:pt x="367506" y="156369"/>
                  <a:pt x="367506" y="0"/>
                </a:cubicBezTo>
                <a:close/>
              </a:path>
              <a:path fill="none" w="735013" h="938213">
                <a:moveTo>
                  <a:pt x="367506" y="0"/>
                </a:moveTo>
                <a:cubicBezTo>
                  <a:pt x="570475" y="0"/>
                  <a:pt x="735013" y="210026"/>
                  <a:pt x="735013" y="469107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文本框 313"/>
          <p:cNvSpPr/>
          <p:nvPr/>
        </p:nvSpPr>
        <p:spPr>
          <a:xfrm>
            <a:off x="2927520" y="8827920"/>
            <a:ext cx="598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TP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弧形 551"/>
          <p:cNvSpPr/>
          <p:nvPr/>
        </p:nvSpPr>
        <p:spPr>
          <a:xfrm flipV="1" rot="1500000">
            <a:off x="2930040" y="8469360"/>
            <a:ext cx="230400" cy="426600"/>
          </a:xfrm>
          <a:custGeom>
            <a:avLst/>
            <a:gdLst/>
            <a:ahLst/>
            <a:rect l="l" t="t" r="r" b="b"/>
            <a:pathLst>
              <a:path stroke="0" w="230188" h="427037">
                <a:moveTo>
                  <a:pt x="32" y="208495"/>
                </a:moveTo>
                <a:cubicBezTo>
                  <a:pt x="543" y="168230"/>
                  <a:pt x="7182" y="129054"/>
                  <a:pt x="19183" y="95491"/>
                </a:cubicBezTo>
                <a:cubicBezTo>
                  <a:pt x="47298" y="16860"/>
                  <a:pt x="99900" y="-18212"/>
                  <a:pt x="148564" y="9227"/>
                </a:cubicBezTo>
                <a:lnTo>
                  <a:pt x="115094" y="213519"/>
                </a:lnTo>
                <a:lnTo>
                  <a:pt x="32" y="208495"/>
                </a:lnTo>
                <a:close/>
              </a:path>
              <a:path fill="none" w="230188" h="427037">
                <a:moveTo>
                  <a:pt x="32" y="208495"/>
                </a:moveTo>
                <a:cubicBezTo>
                  <a:pt x="543" y="168230"/>
                  <a:pt x="7182" y="129054"/>
                  <a:pt x="19183" y="95491"/>
                </a:cubicBezTo>
                <a:cubicBezTo>
                  <a:pt x="47298" y="16860"/>
                  <a:pt x="99900" y="-18212"/>
                  <a:pt x="148564" y="9227"/>
                </a:cubicBezTo>
              </a:path>
            </a:pathLst>
          </a:custGeom>
          <a:noFill/>
          <a:ln w="19080">
            <a:solidFill>
              <a:srgbClr val="000000"/>
            </a:solidFill>
            <a:round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TextBox 263"/>
          <p:cNvSpPr/>
          <p:nvPr/>
        </p:nvSpPr>
        <p:spPr>
          <a:xfrm>
            <a:off x="2892600" y="847872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6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TextBox 263"/>
          <p:cNvSpPr/>
          <p:nvPr/>
        </p:nvSpPr>
        <p:spPr>
          <a:xfrm>
            <a:off x="2205000" y="593424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9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文本框 322"/>
          <p:cNvSpPr/>
          <p:nvPr/>
        </p:nvSpPr>
        <p:spPr>
          <a:xfrm>
            <a:off x="1992240" y="7074000"/>
            <a:ext cx="46188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</a:t>
            </a:r>
            <a:r>
              <a:rPr b="0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O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文本框 323"/>
          <p:cNvSpPr/>
          <p:nvPr/>
        </p:nvSpPr>
        <p:spPr>
          <a:xfrm>
            <a:off x="3565440" y="5568840"/>
            <a:ext cx="770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citr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文本框 324"/>
          <p:cNvSpPr/>
          <p:nvPr/>
        </p:nvSpPr>
        <p:spPr>
          <a:xfrm>
            <a:off x="5335560" y="7178760"/>
            <a:ext cx="770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isocitr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文本框 325"/>
          <p:cNvSpPr/>
          <p:nvPr/>
        </p:nvSpPr>
        <p:spPr>
          <a:xfrm>
            <a:off x="4443480" y="5925960"/>
            <a:ext cx="770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cis- aconit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文本框 326"/>
          <p:cNvSpPr/>
          <p:nvPr/>
        </p:nvSpPr>
        <p:spPr>
          <a:xfrm>
            <a:off x="4892760" y="8423280"/>
            <a:ext cx="7696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oxalosuccin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文本框 327"/>
          <p:cNvSpPr/>
          <p:nvPr/>
        </p:nvSpPr>
        <p:spPr>
          <a:xfrm>
            <a:off x="4094280" y="8989920"/>
            <a:ext cx="7696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α-ketoglutar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文本框 329"/>
          <p:cNvSpPr/>
          <p:nvPr/>
        </p:nvSpPr>
        <p:spPr>
          <a:xfrm>
            <a:off x="2467080" y="8663040"/>
            <a:ext cx="7696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succin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文本框 330"/>
          <p:cNvSpPr/>
          <p:nvPr/>
        </p:nvSpPr>
        <p:spPr>
          <a:xfrm>
            <a:off x="2119320" y="7835760"/>
            <a:ext cx="770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fumar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文本框 331"/>
          <p:cNvSpPr/>
          <p:nvPr/>
        </p:nvSpPr>
        <p:spPr>
          <a:xfrm>
            <a:off x="1890720" y="6761160"/>
            <a:ext cx="770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mal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文本框 332"/>
          <p:cNvSpPr/>
          <p:nvPr/>
        </p:nvSpPr>
        <p:spPr>
          <a:xfrm>
            <a:off x="2343240" y="5853240"/>
            <a:ext cx="76968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oxaloacetate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文本框 333"/>
          <p:cNvSpPr/>
          <p:nvPr/>
        </p:nvSpPr>
        <p:spPr>
          <a:xfrm>
            <a:off x="2822400" y="5106960"/>
            <a:ext cx="770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aacetyl Co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0" name="图片 334" descr="TCA10530-M"/>
          <p:cNvPicPr/>
          <p:nvPr/>
        </p:nvPicPr>
        <p:blipFill>
          <a:blip r:embed="rId14"/>
          <a:stretch/>
        </p:blipFill>
        <p:spPr>
          <a:xfrm>
            <a:off x="898560" y="5214960"/>
            <a:ext cx="581040" cy="681120"/>
          </a:xfrm>
          <a:prstGeom prst="rect">
            <a:avLst/>
          </a:prstGeom>
          <a:ln w="0">
            <a:noFill/>
          </a:ln>
        </p:spPr>
      </p:pic>
      <p:pic>
        <p:nvPicPr>
          <p:cNvPr id="571" name="图片 335" descr="TCA20530"/>
          <p:cNvPicPr/>
          <p:nvPr/>
        </p:nvPicPr>
        <p:blipFill>
          <a:blip r:embed="rId15"/>
          <a:stretch/>
        </p:blipFill>
        <p:spPr>
          <a:xfrm>
            <a:off x="2935440" y="5551560"/>
            <a:ext cx="539640" cy="162000"/>
          </a:xfrm>
          <a:prstGeom prst="rect">
            <a:avLst/>
          </a:prstGeom>
          <a:ln w="0">
            <a:noFill/>
          </a:ln>
        </p:spPr>
      </p:pic>
      <p:pic>
        <p:nvPicPr>
          <p:cNvPr id="572" name="图片 336" descr="TCA30530"/>
          <p:cNvPicPr/>
          <p:nvPr/>
        </p:nvPicPr>
        <p:blipFill>
          <a:blip r:embed="rId16"/>
          <a:stretch/>
        </p:blipFill>
        <p:spPr>
          <a:xfrm>
            <a:off x="3916440" y="5589720"/>
            <a:ext cx="539640" cy="593640"/>
          </a:xfrm>
          <a:prstGeom prst="rect">
            <a:avLst/>
          </a:prstGeom>
          <a:ln w="0">
            <a:noFill/>
          </a:ln>
        </p:spPr>
      </p:pic>
      <p:pic>
        <p:nvPicPr>
          <p:cNvPr id="573" name="图片 337" descr="TCA30530"/>
          <p:cNvPicPr/>
          <p:nvPr/>
        </p:nvPicPr>
        <p:blipFill>
          <a:blip r:embed="rId17"/>
          <a:stretch/>
        </p:blipFill>
        <p:spPr>
          <a:xfrm>
            <a:off x="5286240" y="5580000"/>
            <a:ext cx="540000" cy="593640"/>
          </a:xfrm>
          <a:prstGeom prst="rect">
            <a:avLst/>
          </a:prstGeom>
          <a:ln w="0">
            <a:noFill/>
          </a:ln>
        </p:spPr>
      </p:pic>
      <p:pic>
        <p:nvPicPr>
          <p:cNvPr id="574" name="图片 338" descr="TCA40530"/>
          <p:cNvPicPr/>
          <p:nvPr/>
        </p:nvPicPr>
        <p:blipFill>
          <a:blip r:embed="rId18"/>
          <a:stretch/>
        </p:blipFill>
        <p:spPr>
          <a:xfrm>
            <a:off x="4243320" y="8202600"/>
            <a:ext cx="539640" cy="108000"/>
          </a:xfrm>
          <a:prstGeom prst="rect">
            <a:avLst/>
          </a:prstGeom>
          <a:ln w="0">
            <a:noFill/>
          </a:ln>
        </p:spPr>
      </p:pic>
      <p:sp>
        <p:nvSpPr>
          <p:cNvPr id="575" name="TextBox 263"/>
          <p:cNvSpPr/>
          <p:nvPr/>
        </p:nvSpPr>
        <p:spPr>
          <a:xfrm>
            <a:off x="3052800" y="567684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1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TextBox 263"/>
          <p:cNvSpPr/>
          <p:nvPr/>
        </p:nvSpPr>
        <p:spPr>
          <a:xfrm>
            <a:off x="4367160" y="453708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2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TextBox 263"/>
          <p:cNvSpPr/>
          <p:nvPr/>
        </p:nvSpPr>
        <p:spPr>
          <a:xfrm>
            <a:off x="5415120" y="5430960"/>
            <a:ext cx="3474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3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TextBox 263"/>
          <p:cNvSpPr/>
          <p:nvPr/>
        </p:nvSpPr>
        <p:spPr>
          <a:xfrm>
            <a:off x="4381560" y="806148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4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79" name="图片 343" descr="TCA50530"/>
          <p:cNvPicPr/>
          <p:nvPr/>
        </p:nvPicPr>
        <p:blipFill>
          <a:blip r:embed="rId19"/>
          <a:stretch/>
        </p:blipFill>
        <p:spPr>
          <a:xfrm>
            <a:off x="2482920" y="8024760"/>
            <a:ext cx="539640" cy="108000"/>
          </a:xfrm>
          <a:prstGeom prst="rect">
            <a:avLst/>
          </a:prstGeom>
          <a:ln w="0">
            <a:noFill/>
          </a:ln>
        </p:spPr>
      </p:pic>
      <p:sp>
        <p:nvSpPr>
          <p:cNvPr id="580" name="TextBox 263"/>
          <p:cNvSpPr/>
          <p:nvPr/>
        </p:nvSpPr>
        <p:spPr>
          <a:xfrm>
            <a:off x="2597040" y="787716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7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81" name="图片 345" descr="TCA60530"/>
          <p:cNvPicPr/>
          <p:nvPr/>
        </p:nvPicPr>
        <p:blipFill>
          <a:blip r:embed="rId20"/>
          <a:stretch/>
        </p:blipFill>
        <p:spPr>
          <a:xfrm>
            <a:off x="1639800" y="5680080"/>
            <a:ext cx="540000" cy="324000"/>
          </a:xfrm>
          <a:prstGeom prst="rect">
            <a:avLst/>
          </a:prstGeom>
          <a:ln w="0">
            <a:noFill/>
          </a:ln>
        </p:spPr>
      </p:pic>
      <p:sp>
        <p:nvSpPr>
          <p:cNvPr id="582" name="TextBox 263"/>
          <p:cNvSpPr/>
          <p:nvPr/>
        </p:nvSpPr>
        <p:spPr>
          <a:xfrm>
            <a:off x="1770120" y="5545080"/>
            <a:ext cx="3477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9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文本框 360"/>
          <p:cNvSpPr/>
          <p:nvPr/>
        </p:nvSpPr>
        <p:spPr>
          <a:xfrm>
            <a:off x="2014560" y="4994280"/>
            <a:ext cx="682560" cy="19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NADH+ CO</a:t>
            </a:r>
            <a:r>
              <a:rPr b="1" lang="en-US" sz="6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4" name="组合 361"/>
          <p:cNvGrpSpPr/>
          <p:nvPr/>
        </p:nvGrpSpPr>
        <p:grpSpPr>
          <a:xfrm>
            <a:off x="11160" y="4835520"/>
            <a:ext cx="861840" cy="334440"/>
            <a:chOff x="11160" y="4835520"/>
            <a:chExt cx="861840" cy="334440"/>
          </a:xfrm>
        </p:grpSpPr>
        <p:sp>
          <p:nvSpPr>
            <p:cNvPr id="585" name="文本框 362"/>
            <p:cNvSpPr/>
            <p:nvPr/>
          </p:nvSpPr>
          <p:spPr>
            <a:xfrm>
              <a:off x="221040" y="4984560"/>
              <a:ext cx="199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文本框 363"/>
            <p:cNvSpPr/>
            <p:nvPr/>
          </p:nvSpPr>
          <p:spPr>
            <a:xfrm>
              <a:off x="11160" y="4970880"/>
              <a:ext cx="861840" cy="19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H</a:t>
              </a:r>
              <a:r>
                <a:rPr b="1" lang="en-US" sz="600" spc="-1" strike="noStrike" baseline="-25000">
                  <a:solidFill>
                    <a:srgbClr val="000000"/>
                  </a:solidFill>
                  <a:latin typeface="Times New Roman"/>
                  <a:ea typeface="Times New Roman"/>
                </a:rPr>
                <a:t>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直接连接符 582"/>
            <p:cNvSpPr/>
            <p:nvPr/>
          </p:nvSpPr>
          <p:spPr>
            <a:xfrm>
              <a:off x="245880" y="5064120"/>
              <a:ext cx="66600" cy="10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720" bIns="-45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直接连接符 583"/>
            <p:cNvSpPr/>
            <p:nvPr/>
          </p:nvSpPr>
          <p:spPr>
            <a:xfrm>
              <a:off x="363600" y="5072040"/>
              <a:ext cx="68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文本框 366"/>
            <p:cNvSpPr/>
            <p:nvPr/>
          </p:nvSpPr>
          <p:spPr>
            <a:xfrm>
              <a:off x="357120" y="4979520"/>
              <a:ext cx="4719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OOH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直接连接符 585"/>
            <p:cNvSpPr/>
            <p:nvPr/>
          </p:nvSpPr>
          <p:spPr>
            <a:xfrm>
              <a:off x="324000" y="4967280"/>
              <a:ext cx="0" cy="68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直接连接符 586"/>
            <p:cNvSpPr/>
            <p:nvPr/>
          </p:nvSpPr>
          <p:spPr>
            <a:xfrm flipH="1">
              <a:off x="345960" y="4967280"/>
              <a:ext cx="1440" cy="680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文本框 371"/>
            <p:cNvSpPr/>
            <p:nvPr/>
          </p:nvSpPr>
          <p:spPr>
            <a:xfrm>
              <a:off x="217800" y="4835520"/>
              <a:ext cx="5374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O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93" name="文本框 372"/>
          <p:cNvSpPr/>
          <p:nvPr/>
        </p:nvSpPr>
        <p:spPr>
          <a:xfrm>
            <a:off x="2455920" y="4994280"/>
            <a:ext cx="2365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文本框 373"/>
          <p:cNvSpPr/>
          <p:nvPr/>
        </p:nvSpPr>
        <p:spPr>
          <a:xfrm>
            <a:off x="628560" y="4971960"/>
            <a:ext cx="23832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文本框 374"/>
          <p:cNvSpPr/>
          <p:nvPr/>
        </p:nvSpPr>
        <p:spPr>
          <a:xfrm>
            <a:off x="693720" y="4984920"/>
            <a:ext cx="79236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ASH + NAD</a:t>
            </a:r>
            <a:r>
              <a:rPr b="1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直接连接符 591"/>
          <p:cNvSpPr/>
          <p:nvPr/>
        </p:nvSpPr>
        <p:spPr>
          <a:xfrm>
            <a:off x="1409760" y="5067360"/>
            <a:ext cx="61920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TextBox 263"/>
          <p:cNvSpPr/>
          <p:nvPr/>
        </p:nvSpPr>
        <p:spPr>
          <a:xfrm>
            <a:off x="1546200" y="506412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re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TextBox 1"/>
          <p:cNvSpPr/>
          <p:nvPr/>
        </p:nvSpPr>
        <p:spPr>
          <a:xfrm>
            <a:off x="-3240" y="4492800"/>
            <a:ext cx="48600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B)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TextBox 612"/>
          <p:cNvSpPr/>
          <p:nvPr/>
        </p:nvSpPr>
        <p:spPr>
          <a:xfrm>
            <a:off x="2911320" y="2141640"/>
            <a:ext cx="1357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lycolysi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TextBox 613"/>
          <p:cNvSpPr/>
          <p:nvPr/>
        </p:nvSpPr>
        <p:spPr>
          <a:xfrm>
            <a:off x="3098880" y="6838920"/>
            <a:ext cx="1357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CA cycl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TextBox 263"/>
          <p:cNvSpPr/>
          <p:nvPr/>
        </p:nvSpPr>
        <p:spPr>
          <a:xfrm>
            <a:off x="1027080" y="5861160"/>
            <a:ext cx="34920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pre)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文本框 328"/>
          <p:cNvSpPr/>
          <p:nvPr/>
        </p:nvSpPr>
        <p:spPr>
          <a:xfrm>
            <a:off x="2778120" y="8959680"/>
            <a:ext cx="770040" cy="185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600" spc="-1" strike="noStrike">
                <a:solidFill>
                  <a:srgbClr val="1d41d5"/>
                </a:solidFill>
                <a:latin typeface="Times New Roman"/>
                <a:ea typeface="Times New Roman"/>
              </a:rPr>
              <a:t>succinyl CoA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矩形 557"/>
          <p:cNvSpPr/>
          <p:nvPr/>
        </p:nvSpPr>
        <p:spPr>
          <a:xfrm>
            <a:off x="1057320" y="7532640"/>
            <a:ext cx="150840" cy="96840"/>
          </a:xfrm>
          <a:prstGeom prst="rect">
            <a:avLst/>
          </a:prstGeom>
          <a:noFill/>
          <a:ln w="12600">
            <a:solidFill>
              <a:srgbClr val="948a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矩形 1"/>
          <p:cNvSpPr/>
          <p:nvPr/>
        </p:nvSpPr>
        <p:spPr>
          <a:xfrm>
            <a:off x="84240" y="8445600"/>
            <a:ext cx="236988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3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mparison of glycolysis and citrate cycles between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s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and WT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09-19T23:39:19Z</dcterms:created>
  <dc:creator>万丽云</dc:creator>
  <dc:description/>
  <dc:language>en-US</dc:language>
  <cp:lastModifiedBy>wly</cp:lastModifiedBy>
  <dcterms:modified xsi:type="dcterms:W3CDTF">2019-07-10T01:20:05Z</dcterms:modified>
  <cp:revision>12</cp:revision>
  <dc:subject/>
  <dc:title>幻灯片 1</dc:title>
</cp:coreProperties>
</file>